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86" r:id="rId4"/>
    <p:sldId id="288" r:id="rId5"/>
    <p:sldId id="289" r:id="rId6"/>
    <p:sldId id="290" r:id="rId7"/>
    <p:sldId id="291" r:id="rId8"/>
    <p:sldId id="293" r:id="rId9"/>
    <p:sldId id="292" r:id="rId10"/>
    <p:sldId id="294" r:id="rId11"/>
    <p:sldId id="295" r:id="rId12"/>
    <p:sldId id="296" r:id="rId13"/>
    <p:sldId id="297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2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657F52-DF43-4424-9D2B-C4F51BBC0F9D}" v="9" dt="2023-10-09T23:14:39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286" autoAdjust="0"/>
    <p:restoredTop sz="93792" autoAdjust="0"/>
  </p:normalViewPr>
  <p:slideViewPr>
    <p:cSldViewPr snapToGrid="0">
      <p:cViewPr varScale="1">
        <p:scale>
          <a:sx n="103" d="100"/>
          <a:sy n="103" d="100"/>
        </p:scale>
        <p:origin x="642" y="108"/>
      </p:cViewPr>
      <p:guideLst>
        <p:guide orient="horz" pos="202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oe Fehlberg" userId="5a123bd2-7317-4220-884d-082c90c58297" providerId="ADAL" clId="{49657F52-DF43-4424-9D2B-C4F51BBC0F9D}"/>
    <pc:docChg chg="undo custSel delSld modSld">
      <pc:chgData name="Zoe Fehlberg" userId="5a123bd2-7317-4220-884d-082c90c58297" providerId="ADAL" clId="{49657F52-DF43-4424-9D2B-C4F51BBC0F9D}" dt="2023-10-09T23:15:16.157" v="84" actId="47"/>
      <pc:docMkLst>
        <pc:docMk/>
      </pc:docMkLst>
      <pc:sldChg chg="delSp modSp mod">
        <pc:chgData name="Zoe Fehlberg" userId="5a123bd2-7317-4220-884d-082c90c58297" providerId="ADAL" clId="{49657F52-DF43-4424-9D2B-C4F51BBC0F9D}" dt="2023-10-09T23:11:28.403" v="4" actId="478"/>
        <pc:sldMkLst>
          <pc:docMk/>
          <pc:sldMk cId="2652371780" sldId="256"/>
        </pc:sldMkLst>
        <pc:spChg chg="del">
          <ac:chgData name="Zoe Fehlberg" userId="5a123bd2-7317-4220-884d-082c90c58297" providerId="ADAL" clId="{49657F52-DF43-4424-9D2B-C4F51BBC0F9D}" dt="2023-10-09T23:11:24.954" v="0" actId="478"/>
          <ac:spMkLst>
            <pc:docMk/>
            <pc:sldMk cId="2652371780" sldId="256"/>
            <ac:spMk id="109" creationId="{3CAFE384-659C-7359-43A2-24EEEFC838EF}"/>
          </ac:spMkLst>
        </pc:spChg>
        <pc:spChg chg="del">
          <ac:chgData name="Zoe Fehlberg" userId="5a123bd2-7317-4220-884d-082c90c58297" providerId="ADAL" clId="{49657F52-DF43-4424-9D2B-C4F51BBC0F9D}" dt="2023-10-09T23:11:25.592" v="1" actId="478"/>
          <ac:spMkLst>
            <pc:docMk/>
            <pc:sldMk cId="2652371780" sldId="256"/>
            <ac:spMk id="112" creationId="{7CC94CFD-05AD-54C1-98CF-FF4053FBF91F}"/>
          </ac:spMkLst>
        </pc:spChg>
        <pc:spChg chg="del">
          <ac:chgData name="Zoe Fehlberg" userId="5a123bd2-7317-4220-884d-082c90c58297" providerId="ADAL" clId="{49657F52-DF43-4424-9D2B-C4F51BBC0F9D}" dt="2023-10-09T23:11:28.403" v="4" actId="478"/>
          <ac:spMkLst>
            <pc:docMk/>
            <pc:sldMk cId="2652371780" sldId="256"/>
            <ac:spMk id="131" creationId="{DA006EFF-207A-5633-5136-9507902CF2B8}"/>
          </ac:spMkLst>
        </pc:spChg>
        <pc:cxnChg chg="del mod">
          <ac:chgData name="Zoe Fehlberg" userId="5a123bd2-7317-4220-884d-082c90c58297" providerId="ADAL" clId="{49657F52-DF43-4424-9D2B-C4F51BBC0F9D}" dt="2023-10-09T23:11:26.852" v="3" actId="478"/>
          <ac:cxnSpMkLst>
            <pc:docMk/>
            <pc:sldMk cId="2652371780" sldId="256"/>
            <ac:cxnSpMk id="110" creationId="{A9DB1A87-AD32-D48C-2737-3392558B5786}"/>
          </ac:cxnSpMkLst>
        </pc:cxnChg>
        <pc:cxnChg chg="del mod">
          <ac:chgData name="Zoe Fehlberg" userId="5a123bd2-7317-4220-884d-082c90c58297" providerId="ADAL" clId="{49657F52-DF43-4424-9D2B-C4F51BBC0F9D}" dt="2023-10-09T23:11:26.231" v="2" actId="478"/>
          <ac:cxnSpMkLst>
            <pc:docMk/>
            <pc:sldMk cId="2652371780" sldId="256"/>
            <ac:cxnSpMk id="113" creationId="{E70E7988-AE9B-CBB5-7545-D8A6E0A73880}"/>
          </ac:cxnSpMkLst>
        </pc:cxnChg>
      </pc:sldChg>
      <pc:sldChg chg="delSp mod">
        <pc:chgData name="Zoe Fehlberg" userId="5a123bd2-7317-4220-884d-082c90c58297" providerId="ADAL" clId="{49657F52-DF43-4424-9D2B-C4F51BBC0F9D}" dt="2023-10-09T23:11:30.439" v="5" actId="478"/>
        <pc:sldMkLst>
          <pc:docMk/>
          <pc:sldMk cId="4075855579" sldId="258"/>
        </pc:sldMkLst>
        <pc:spChg chg="del">
          <ac:chgData name="Zoe Fehlberg" userId="5a123bd2-7317-4220-884d-082c90c58297" providerId="ADAL" clId="{49657F52-DF43-4424-9D2B-C4F51BBC0F9D}" dt="2023-10-09T23:11:30.439" v="5" actId="478"/>
          <ac:spMkLst>
            <pc:docMk/>
            <pc:sldMk cId="4075855579" sldId="258"/>
            <ac:spMk id="52" creationId="{6BD672E5-2EA0-0E84-536C-AEAB6293AA5A}"/>
          </ac:spMkLst>
        </pc:spChg>
      </pc:sldChg>
      <pc:sldChg chg="addSp delSp modSp mod">
        <pc:chgData name="Zoe Fehlberg" userId="5a123bd2-7317-4220-884d-082c90c58297" providerId="ADAL" clId="{49657F52-DF43-4424-9D2B-C4F51BBC0F9D}" dt="2023-10-09T23:12:19.883" v="29"/>
        <pc:sldMkLst>
          <pc:docMk/>
          <pc:sldMk cId="727036463" sldId="288"/>
        </pc:sldMkLst>
        <pc:spChg chg="add mod">
          <ac:chgData name="Zoe Fehlberg" userId="5a123bd2-7317-4220-884d-082c90c58297" providerId="ADAL" clId="{49657F52-DF43-4424-9D2B-C4F51BBC0F9D}" dt="2023-10-09T23:12:19.883" v="29"/>
          <ac:spMkLst>
            <pc:docMk/>
            <pc:sldMk cId="727036463" sldId="288"/>
            <ac:spMk id="39" creationId="{32C6CAB8-7887-F07A-5669-27A5B81BDCB3}"/>
          </ac:spMkLst>
        </pc:spChg>
        <pc:spChg chg="del">
          <ac:chgData name="Zoe Fehlberg" userId="5a123bd2-7317-4220-884d-082c90c58297" providerId="ADAL" clId="{49657F52-DF43-4424-9D2B-C4F51BBC0F9D}" dt="2023-10-09T23:12:19.267" v="28" actId="478"/>
          <ac:spMkLst>
            <pc:docMk/>
            <pc:sldMk cId="727036463" sldId="288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1:33.460" v="6" actId="478"/>
          <ac:spMkLst>
            <pc:docMk/>
            <pc:sldMk cId="727036463" sldId="288"/>
            <ac:spMk id="70" creationId="{3B93E0A2-6D70-FCD5-7DB3-E415A92FF30D}"/>
          </ac:spMkLst>
        </pc:spChg>
      </pc:sldChg>
      <pc:sldChg chg="delSp modSp mod">
        <pc:chgData name="Zoe Fehlberg" userId="5a123bd2-7317-4220-884d-082c90c58297" providerId="ADAL" clId="{49657F52-DF43-4424-9D2B-C4F51BBC0F9D}" dt="2023-10-09T23:11:41.013" v="13" actId="478"/>
        <pc:sldMkLst>
          <pc:docMk/>
          <pc:sldMk cId="2680925678" sldId="289"/>
        </pc:sldMkLst>
        <pc:spChg chg="del">
          <ac:chgData name="Zoe Fehlberg" userId="5a123bd2-7317-4220-884d-082c90c58297" providerId="ADAL" clId="{49657F52-DF43-4424-9D2B-C4F51BBC0F9D}" dt="2023-10-09T23:11:41.013" v="13" actId="478"/>
          <ac:spMkLst>
            <pc:docMk/>
            <pc:sldMk cId="2680925678" sldId="289"/>
            <ac:spMk id="70" creationId="{3B93E0A2-6D70-FCD5-7DB3-E415A92FF30D}"/>
          </ac:spMkLst>
        </pc:spChg>
        <pc:spChg chg="del mod">
          <ac:chgData name="Zoe Fehlberg" userId="5a123bd2-7317-4220-884d-082c90c58297" providerId="ADAL" clId="{49657F52-DF43-4424-9D2B-C4F51BBC0F9D}" dt="2023-10-09T23:11:37.603" v="10" actId="478"/>
          <ac:spMkLst>
            <pc:docMk/>
            <pc:sldMk cId="2680925678" sldId="289"/>
            <ac:spMk id="92" creationId="{ACE8B216-CE66-AF9F-A8FE-428608C32B13}"/>
          </ac:spMkLst>
        </pc:spChg>
        <pc:spChg chg="del mod">
          <ac:chgData name="Zoe Fehlberg" userId="5a123bd2-7317-4220-884d-082c90c58297" providerId="ADAL" clId="{49657F52-DF43-4424-9D2B-C4F51BBC0F9D}" dt="2023-10-09T23:11:36.519" v="9" actId="478"/>
          <ac:spMkLst>
            <pc:docMk/>
            <pc:sldMk cId="2680925678" sldId="289"/>
            <ac:spMk id="96" creationId="{703A19FB-EE44-E769-568F-B7EFB98378CF}"/>
          </ac:spMkLst>
        </pc:spChg>
        <pc:cxnChg chg="del mod">
          <ac:chgData name="Zoe Fehlberg" userId="5a123bd2-7317-4220-884d-082c90c58297" providerId="ADAL" clId="{49657F52-DF43-4424-9D2B-C4F51BBC0F9D}" dt="2023-10-09T23:11:40.124" v="12" actId="478"/>
          <ac:cxnSpMkLst>
            <pc:docMk/>
            <pc:sldMk cId="2680925678" sldId="289"/>
            <ac:cxnSpMk id="93" creationId="{E2801BE7-3E4D-38A6-D31C-05A098345841}"/>
          </ac:cxnSpMkLst>
        </pc:cxnChg>
        <pc:cxnChg chg="del mod">
          <ac:chgData name="Zoe Fehlberg" userId="5a123bd2-7317-4220-884d-082c90c58297" providerId="ADAL" clId="{49657F52-DF43-4424-9D2B-C4F51BBC0F9D}" dt="2023-10-09T23:11:38.276" v="11" actId="478"/>
          <ac:cxnSpMkLst>
            <pc:docMk/>
            <pc:sldMk cId="2680925678" sldId="289"/>
            <ac:cxnSpMk id="97" creationId="{924E5644-D36A-119C-7909-0B562BDF7606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2:27.590" v="32" actId="1076"/>
        <pc:sldMkLst>
          <pc:docMk/>
          <pc:sldMk cId="1909666780" sldId="290"/>
        </pc:sldMkLst>
        <pc:spChg chg="add mod">
          <ac:chgData name="Zoe Fehlberg" userId="5a123bd2-7317-4220-884d-082c90c58297" providerId="ADAL" clId="{49657F52-DF43-4424-9D2B-C4F51BBC0F9D}" dt="2023-10-09T23:12:27.590" v="32" actId="1076"/>
          <ac:spMkLst>
            <pc:docMk/>
            <pc:sldMk cId="1909666780" sldId="290"/>
            <ac:spMk id="8" creationId="{4E9B7464-8732-F0A6-9990-4F7D150DDA5E}"/>
          </ac:spMkLst>
        </pc:spChg>
        <pc:spChg chg="del">
          <ac:chgData name="Zoe Fehlberg" userId="5a123bd2-7317-4220-884d-082c90c58297" providerId="ADAL" clId="{49657F52-DF43-4424-9D2B-C4F51BBC0F9D}" dt="2023-10-09T23:12:25.956" v="31" actId="478"/>
          <ac:spMkLst>
            <pc:docMk/>
            <pc:sldMk cId="1909666780" sldId="290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1:43.861" v="14" actId="478"/>
          <ac:spMkLst>
            <pc:docMk/>
            <pc:sldMk cId="1909666780" sldId="290"/>
            <ac:spMk id="70" creationId="{3B93E0A2-6D70-FCD5-7DB3-E415A92FF30D}"/>
          </ac:spMkLst>
        </pc:spChg>
        <pc:spChg chg="add del mod">
          <ac:chgData name="Zoe Fehlberg" userId="5a123bd2-7317-4220-884d-082c90c58297" providerId="ADAL" clId="{49657F52-DF43-4424-9D2B-C4F51BBC0F9D}" dt="2023-10-09T23:12:11.349" v="26" actId="478"/>
          <ac:spMkLst>
            <pc:docMk/>
            <pc:sldMk cId="1909666780" sldId="290"/>
            <ac:spMk id="96" creationId="{703A19FB-EE44-E769-568F-B7EFB98378CF}"/>
          </ac:spMkLst>
        </pc:spChg>
        <pc:cxnChg chg="add del mod">
          <ac:chgData name="Zoe Fehlberg" userId="5a123bd2-7317-4220-884d-082c90c58297" providerId="ADAL" clId="{49657F52-DF43-4424-9D2B-C4F51BBC0F9D}" dt="2023-10-09T23:12:11.765" v="27" actId="478"/>
          <ac:cxnSpMkLst>
            <pc:docMk/>
            <pc:sldMk cId="1909666780" sldId="290"/>
            <ac:cxnSpMk id="97" creationId="{924E5644-D36A-119C-7909-0B562BDF7606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2:32.905" v="34"/>
        <pc:sldMkLst>
          <pc:docMk/>
          <pc:sldMk cId="2503128698" sldId="291"/>
        </pc:sldMkLst>
        <pc:spChg chg="add mod">
          <ac:chgData name="Zoe Fehlberg" userId="5a123bd2-7317-4220-884d-082c90c58297" providerId="ADAL" clId="{49657F52-DF43-4424-9D2B-C4F51BBC0F9D}" dt="2023-10-09T23:12:32.905" v="34"/>
          <ac:spMkLst>
            <pc:docMk/>
            <pc:sldMk cId="2503128698" sldId="291"/>
            <ac:spMk id="6" creationId="{492F7F79-C9C6-73A8-5EDC-D5904BA77F9B}"/>
          </ac:spMkLst>
        </pc:spChg>
        <pc:spChg chg="del">
          <ac:chgData name="Zoe Fehlberg" userId="5a123bd2-7317-4220-884d-082c90c58297" providerId="ADAL" clId="{49657F52-DF43-4424-9D2B-C4F51BBC0F9D}" dt="2023-10-09T23:12:32.179" v="33" actId="478"/>
          <ac:spMkLst>
            <pc:docMk/>
            <pc:sldMk cId="2503128698" sldId="291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1:50.535" v="18" actId="478"/>
          <ac:spMkLst>
            <pc:docMk/>
            <pc:sldMk cId="2503128698" sldId="291"/>
            <ac:spMk id="70" creationId="{3B93E0A2-6D70-FCD5-7DB3-E415A92FF30D}"/>
          </ac:spMkLst>
        </pc:spChg>
        <pc:spChg chg="del mod">
          <ac:chgData name="Zoe Fehlberg" userId="5a123bd2-7317-4220-884d-082c90c58297" providerId="ADAL" clId="{49657F52-DF43-4424-9D2B-C4F51BBC0F9D}" dt="2023-10-09T23:11:48.312" v="16" actId="478"/>
          <ac:spMkLst>
            <pc:docMk/>
            <pc:sldMk cId="2503128698" sldId="291"/>
            <ac:spMk id="111" creationId="{183FB9F4-3337-D5E0-9DC0-DE927E8096E7}"/>
          </ac:spMkLst>
        </pc:spChg>
        <pc:cxnChg chg="del mod">
          <ac:chgData name="Zoe Fehlberg" userId="5a123bd2-7317-4220-884d-082c90c58297" providerId="ADAL" clId="{49657F52-DF43-4424-9D2B-C4F51BBC0F9D}" dt="2023-10-09T23:11:49.467" v="17" actId="478"/>
          <ac:cxnSpMkLst>
            <pc:docMk/>
            <pc:sldMk cId="2503128698" sldId="291"/>
            <ac:cxnSpMk id="112" creationId="{C0AB88F8-4A40-8606-CF99-C21E31E0C3C0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3:48.512" v="51"/>
        <pc:sldMkLst>
          <pc:docMk/>
          <pc:sldMk cId="3182455154" sldId="292"/>
        </pc:sldMkLst>
        <pc:spChg chg="add mod">
          <ac:chgData name="Zoe Fehlberg" userId="5a123bd2-7317-4220-884d-082c90c58297" providerId="ADAL" clId="{49657F52-DF43-4424-9D2B-C4F51BBC0F9D}" dt="2023-10-09T23:13:48.512" v="51"/>
          <ac:spMkLst>
            <pc:docMk/>
            <pc:sldMk cId="3182455154" sldId="292"/>
            <ac:spMk id="4" creationId="{736A0C2F-3B93-AC1C-27D2-3E470591A832}"/>
          </ac:spMkLst>
        </pc:spChg>
        <pc:spChg chg="del">
          <ac:chgData name="Zoe Fehlberg" userId="5a123bd2-7317-4220-884d-082c90c58297" providerId="ADAL" clId="{49657F52-DF43-4424-9D2B-C4F51BBC0F9D}" dt="2023-10-09T23:13:47.908" v="50" actId="478"/>
          <ac:spMkLst>
            <pc:docMk/>
            <pc:sldMk cId="3182455154" sldId="292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2:45.475" v="42" actId="478"/>
          <ac:spMkLst>
            <pc:docMk/>
            <pc:sldMk cId="3182455154" sldId="292"/>
            <ac:spMk id="70" creationId="{3B93E0A2-6D70-FCD5-7DB3-E415A92FF30D}"/>
          </ac:spMkLst>
        </pc:spChg>
        <pc:spChg chg="del">
          <ac:chgData name="Zoe Fehlberg" userId="5a123bd2-7317-4220-884d-082c90c58297" providerId="ADAL" clId="{49657F52-DF43-4424-9D2B-C4F51BBC0F9D}" dt="2023-10-09T23:13:46.033" v="48" actId="478"/>
          <ac:spMkLst>
            <pc:docMk/>
            <pc:sldMk cId="3182455154" sldId="292"/>
            <ac:spMk id="92" creationId="{C9877E40-BCF2-709A-58D2-70F5BFA616E5}"/>
          </ac:spMkLst>
        </pc:spChg>
        <pc:spChg chg="del">
          <ac:chgData name="Zoe Fehlberg" userId="5a123bd2-7317-4220-884d-082c90c58297" providerId="ADAL" clId="{49657F52-DF43-4424-9D2B-C4F51BBC0F9D}" dt="2023-10-09T23:12:46.275" v="43" actId="478"/>
          <ac:spMkLst>
            <pc:docMk/>
            <pc:sldMk cId="3182455154" sldId="292"/>
            <ac:spMk id="106" creationId="{DC1E807C-9BCB-EBB3-38CD-B39D8961E749}"/>
          </ac:spMkLst>
        </pc:spChg>
        <pc:spChg chg="del">
          <ac:chgData name="Zoe Fehlberg" userId="5a123bd2-7317-4220-884d-082c90c58297" providerId="ADAL" clId="{49657F52-DF43-4424-9D2B-C4F51BBC0F9D}" dt="2023-10-09T23:13:43.192" v="45" actId="478"/>
          <ac:spMkLst>
            <pc:docMk/>
            <pc:sldMk cId="3182455154" sldId="292"/>
            <ac:spMk id="112" creationId="{AC78AD22-72AA-C1D9-70C2-06FC5C54E3BC}"/>
          </ac:spMkLst>
        </pc:spChg>
        <pc:cxnChg chg="del mod">
          <ac:chgData name="Zoe Fehlberg" userId="5a123bd2-7317-4220-884d-082c90c58297" providerId="ADAL" clId="{49657F52-DF43-4424-9D2B-C4F51BBC0F9D}" dt="2023-10-09T23:13:46.610" v="49" actId="478"/>
          <ac:cxnSpMkLst>
            <pc:docMk/>
            <pc:sldMk cId="3182455154" sldId="292"/>
            <ac:cxnSpMk id="93" creationId="{A974857D-AEA0-3004-5664-C5F766AE3189}"/>
          </ac:cxnSpMkLst>
        </pc:cxnChg>
        <pc:cxnChg chg="del mod">
          <ac:chgData name="Zoe Fehlberg" userId="5a123bd2-7317-4220-884d-082c90c58297" providerId="ADAL" clId="{49657F52-DF43-4424-9D2B-C4F51BBC0F9D}" dt="2023-10-09T23:12:46.803" v="44" actId="478"/>
          <ac:cxnSpMkLst>
            <pc:docMk/>
            <pc:sldMk cId="3182455154" sldId="292"/>
            <ac:cxnSpMk id="109" creationId="{0E24EED2-2213-7996-38D9-2A41576A9515}"/>
          </ac:cxnSpMkLst>
        </pc:cxnChg>
        <pc:cxnChg chg="del mod">
          <ac:chgData name="Zoe Fehlberg" userId="5a123bd2-7317-4220-884d-082c90c58297" providerId="ADAL" clId="{49657F52-DF43-4424-9D2B-C4F51BBC0F9D}" dt="2023-10-09T23:13:44.583" v="47" actId="478"/>
          <ac:cxnSpMkLst>
            <pc:docMk/>
            <pc:sldMk cId="3182455154" sldId="292"/>
            <ac:cxnSpMk id="115" creationId="{398CD164-F9B9-E1CE-F1F0-64FADFAAC5E6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2:42.200" v="41"/>
        <pc:sldMkLst>
          <pc:docMk/>
          <pc:sldMk cId="1092442507" sldId="293"/>
        </pc:sldMkLst>
        <pc:spChg chg="add mod">
          <ac:chgData name="Zoe Fehlberg" userId="5a123bd2-7317-4220-884d-082c90c58297" providerId="ADAL" clId="{49657F52-DF43-4424-9D2B-C4F51BBC0F9D}" dt="2023-10-09T23:12:42.200" v="41"/>
          <ac:spMkLst>
            <pc:docMk/>
            <pc:sldMk cId="1092442507" sldId="293"/>
            <ac:spMk id="5" creationId="{BDBEF279-79F5-BD82-449E-D06F9D353413}"/>
          </ac:spMkLst>
        </pc:spChg>
        <pc:spChg chg="del">
          <ac:chgData name="Zoe Fehlberg" userId="5a123bd2-7317-4220-884d-082c90c58297" providerId="ADAL" clId="{49657F52-DF43-4424-9D2B-C4F51BBC0F9D}" dt="2023-10-09T23:12:39.476" v="38" actId="478"/>
          <ac:spMkLst>
            <pc:docMk/>
            <pc:sldMk cId="1092442507" sldId="293"/>
            <ac:spMk id="49" creationId="{9E8EA10B-DD56-0038-557C-21C01A01C667}"/>
          </ac:spMkLst>
        </pc:spChg>
        <pc:spChg chg="del">
          <ac:chgData name="Zoe Fehlberg" userId="5a123bd2-7317-4220-884d-082c90c58297" providerId="ADAL" clId="{49657F52-DF43-4424-9D2B-C4F51BBC0F9D}" dt="2023-10-09T23:12:41.555" v="40" actId="478"/>
          <ac:spMkLst>
            <pc:docMk/>
            <pc:sldMk cId="1092442507" sldId="293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2:36.531" v="35" actId="478"/>
          <ac:spMkLst>
            <pc:docMk/>
            <pc:sldMk cId="1092442507" sldId="293"/>
            <ac:spMk id="70" creationId="{3B93E0A2-6D70-FCD5-7DB3-E415A92FF30D}"/>
          </ac:spMkLst>
        </pc:spChg>
        <pc:spChg chg="del">
          <ac:chgData name="Zoe Fehlberg" userId="5a123bd2-7317-4220-884d-082c90c58297" providerId="ADAL" clId="{49657F52-DF43-4424-9D2B-C4F51BBC0F9D}" dt="2023-10-09T23:12:37.445" v="36" actId="478"/>
          <ac:spMkLst>
            <pc:docMk/>
            <pc:sldMk cId="1092442507" sldId="293"/>
            <ac:spMk id="92" creationId="{C9877E40-BCF2-709A-58D2-70F5BFA616E5}"/>
          </ac:spMkLst>
        </pc:spChg>
        <pc:cxnChg chg="del mod">
          <ac:chgData name="Zoe Fehlberg" userId="5a123bd2-7317-4220-884d-082c90c58297" providerId="ADAL" clId="{49657F52-DF43-4424-9D2B-C4F51BBC0F9D}" dt="2023-10-09T23:12:40.418" v="39" actId="478"/>
          <ac:cxnSpMkLst>
            <pc:docMk/>
            <pc:sldMk cId="1092442507" sldId="293"/>
            <ac:cxnSpMk id="50" creationId="{0703C2D3-794B-55CE-F490-46C75ED4D417}"/>
          </ac:cxnSpMkLst>
        </pc:cxnChg>
        <pc:cxnChg chg="del mod">
          <ac:chgData name="Zoe Fehlberg" userId="5a123bd2-7317-4220-884d-082c90c58297" providerId="ADAL" clId="{49657F52-DF43-4424-9D2B-C4F51BBC0F9D}" dt="2023-10-09T23:12:38.355" v="37" actId="478"/>
          <ac:cxnSpMkLst>
            <pc:docMk/>
            <pc:sldMk cId="1092442507" sldId="293"/>
            <ac:cxnSpMk id="93" creationId="{A974857D-AEA0-3004-5664-C5F766AE3189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3:57.522" v="56" actId="478"/>
        <pc:sldMkLst>
          <pc:docMk/>
          <pc:sldMk cId="883995382" sldId="294"/>
        </pc:sldMkLst>
        <pc:spChg chg="add mod">
          <ac:chgData name="Zoe Fehlberg" userId="5a123bd2-7317-4220-884d-082c90c58297" providerId="ADAL" clId="{49657F52-DF43-4424-9D2B-C4F51BBC0F9D}" dt="2023-10-09T23:13:54.665" v="54"/>
          <ac:spMkLst>
            <pc:docMk/>
            <pc:sldMk cId="883995382" sldId="294"/>
            <ac:spMk id="11" creationId="{0DDD7C61-A232-65BF-ECD5-C77A714655CB}"/>
          </ac:spMkLst>
        </pc:spChg>
        <pc:spChg chg="del">
          <ac:chgData name="Zoe Fehlberg" userId="5a123bd2-7317-4220-884d-082c90c58297" providerId="ADAL" clId="{49657F52-DF43-4424-9D2B-C4F51BBC0F9D}" dt="2023-10-09T23:13:56.392" v="55" actId="478"/>
          <ac:spMkLst>
            <pc:docMk/>
            <pc:sldMk cId="883995382" sldId="294"/>
            <ac:spMk id="49" creationId="{9E8EA10B-DD56-0038-557C-21C01A01C667}"/>
          </ac:spMkLst>
        </pc:spChg>
        <pc:spChg chg="del">
          <ac:chgData name="Zoe Fehlberg" userId="5a123bd2-7317-4220-884d-082c90c58297" providerId="ADAL" clId="{49657F52-DF43-4424-9D2B-C4F51BBC0F9D}" dt="2023-10-09T23:13:54.103" v="53" actId="478"/>
          <ac:spMkLst>
            <pc:docMk/>
            <pc:sldMk cId="883995382" sldId="294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3:53.528" v="52" actId="478"/>
          <ac:spMkLst>
            <pc:docMk/>
            <pc:sldMk cId="883995382" sldId="294"/>
            <ac:spMk id="70" creationId="{3B93E0A2-6D70-FCD5-7DB3-E415A92FF30D}"/>
          </ac:spMkLst>
        </pc:spChg>
        <pc:cxnChg chg="del mod">
          <ac:chgData name="Zoe Fehlberg" userId="5a123bd2-7317-4220-884d-082c90c58297" providerId="ADAL" clId="{49657F52-DF43-4424-9D2B-C4F51BBC0F9D}" dt="2023-10-09T23:13:57.522" v="56" actId="478"/>
          <ac:cxnSpMkLst>
            <pc:docMk/>
            <pc:sldMk cId="883995382" sldId="294"/>
            <ac:cxnSpMk id="50" creationId="{0703C2D3-794B-55CE-F490-46C75ED4D417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4:05.255" v="61" actId="478"/>
        <pc:sldMkLst>
          <pc:docMk/>
          <pc:sldMk cId="1136757873" sldId="295"/>
        </pc:sldMkLst>
        <pc:spChg chg="add mod">
          <ac:chgData name="Zoe Fehlberg" userId="5a123bd2-7317-4220-884d-082c90c58297" providerId="ADAL" clId="{49657F52-DF43-4424-9D2B-C4F51BBC0F9D}" dt="2023-10-09T23:14:01.335" v="59"/>
          <ac:spMkLst>
            <pc:docMk/>
            <pc:sldMk cId="1136757873" sldId="295"/>
            <ac:spMk id="4" creationId="{CAE19A0F-F2EB-FF4E-2C67-9DA477D74587}"/>
          </ac:spMkLst>
        </pc:spChg>
        <pc:spChg chg="del">
          <ac:chgData name="Zoe Fehlberg" userId="5a123bd2-7317-4220-884d-082c90c58297" providerId="ADAL" clId="{49657F52-DF43-4424-9D2B-C4F51BBC0F9D}" dt="2023-10-09T23:14:04.559" v="60" actId="478"/>
          <ac:spMkLst>
            <pc:docMk/>
            <pc:sldMk cId="1136757873" sldId="295"/>
            <ac:spMk id="49" creationId="{9E8EA10B-DD56-0038-557C-21C01A01C667}"/>
          </ac:spMkLst>
        </pc:spChg>
        <pc:spChg chg="del">
          <ac:chgData name="Zoe Fehlberg" userId="5a123bd2-7317-4220-884d-082c90c58297" providerId="ADAL" clId="{49657F52-DF43-4424-9D2B-C4F51BBC0F9D}" dt="2023-10-09T23:14:00.645" v="58" actId="478"/>
          <ac:spMkLst>
            <pc:docMk/>
            <pc:sldMk cId="1136757873" sldId="295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4:00.289" v="57" actId="478"/>
          <ac:spMkLst>
            <pc:docMk/>
            <pc:sldMk cId="1136757873" sldId="295"/>
            <ac:spMk id="70" creationId="{3B93E0A2-6D70-FCD5-7DB3-E415A92FF30D}"/>
          </ac:spMkLst>
        </pc:spChg>
        <pc:cxnChg chg="del mod">
          <ac:chgData name="Zoe Fehlberg" userId="5a123bd2-7317-4220-884d-082c90c58297" providerId="ADAL" clId="{49657F52-DF43-4424-9D2B-C4F51BBC0F9D}" dt="2023-10-09T23:14:05.255" v="61" actId="478"/>
          <ac:cxnSpMkLst>
            <pc:docMk/>
            <pc:sldMk cId="1136757873" sldId="295"/>
            <ac:cxnSpMk id="50" creationId="{0703C2D3-794B-55CE-F490-46C75ED4D417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4:31.257" v="75" actId="1076"/>
        <pc:sldMkLst>
          <pc:docMk/>
          <pc:sldMk cId="812589270" sldId="296"/>
        </pc:sldMkLst>
        <pc:spChg chg="del">
          <ac:chgData name="Zoe Fehlberg" userId="5a123bd2-7317-4220-884d-082c90c58297" providerId="ADAL" clId="{49657F52-DF43-4424-9D2B-C4F51BBC0F9D}" dt="2023-10-09T23:14:12.292" v="67" actId="478"/>
          <ac:spMkLst>
            <pc:docMk/>
            <pc:sldMk cId="812589270" sldId="296"/>
            <ac:spMk id="17" creationId="{1FBE5175-E443-F1FC-801D-614A29CC4BAD}"/>
          </ac:spMkLst>
        </pc:spChg>
        <pc:spChg chg="add mod">
          <ac:chgData name="Zoe Fehlberg" userId="5a123bd2-7317-4220-884d-082c90c58297" providerId="ADAL" clId="{49657F52-DF43-4424-9D2B-C4F51BBC0F9D}" dt="2023-10-09T23:14:09.120" v="64"/>
          <ac:spMkLst>
            <pc:docMk/>
            <pc:sldMk cId="812589270" sldId="296"/>
            <ac:spMk id="18" creationId="{50548678-89A6-D66B-61AB-625F2744EB69}"/>
          </ac:spMkLst>
        </pc:spChg>
        <pc:spChg chg="del">
          <ac:chgData name="Zoe Fehlberg" userId="5a123bd2-7317-4220-884d-082c90c58297" providerId="ADAL" clId="{49657F52-DF43-4424-9D2B-C4F51BBC0F9D}" dt="2023-10-09T23:14:10.554" v="65" actId="478"/>
          <ac:spMkLst>
            <pc:docMk/>
            <pc:sldMk cId="812589270" sldId="296"/>
            <ac:spMk id="39" creationId="{2C9959A8-E9AB-D5F9-653E-DF4D2F9B9B4F}"/>
          </ac:spMkLst>
        </pc:spChg>
        <pc:spChg chg="del">
          <ac:chgData name="Zoe Fehlberg" userId="5a123bd2-7317-4220-884d-082c90c58297" providerId="ADAL" clId="{49657F52-DF43-4424-9D2B-C4F51BBC0F9D}" dt="2023-10-09T23:14:14.868" v="70" actId="478"/>
          <ac:spMkLst>
            <pc:docMk/>
            <pc:sldMk cId="812589270" sldId="296"/>
            <ac:spMk id="44" creationId="{A7829A4E-BE45-8DAE-70AB-546AA21111EE}"/>
          </ac:spMkLst>
        </pc:spChg>
        <pc:spChg chg="mod">
          <ac:chgData name="Zoe Fehlberg" userId="5a123bd2-7317-4220-884d-082c90c58297" providerId="ADAL" clId="{49657F52-DF43-4424-9D2B-C4F51BBC0F9D}" dt="2023-10-09T23:14:26.785" v="74" actId="1076"/>
          <ac:spMkLst>
            <pc:docMk/>
            <pc:sldMk cId="812589270" sldId="296"/>
            <ac:spMk id="46" creationId="{D478C971-7B24-B8D0-5820-F2414027CC70}"/>
          </ac:spMkLst>
        </pc:spChg>
        <pc:spChg chg="del">
          <ac:chgData name="Zoe Fehlberg" userId="5a123bd2-7317-4220-884d-082c90c58297" providerId="ADAL" clId="{49657F52-DF43-4424-9D2B-C4F51BBC0F9D}" dt="2023-10-09T23:14:16.087" v="72" actId="478"/>
          <ac:spMkLst>
            <pc:docMk/>
            <pc:sldMk cId="812589270" sldId="296"/>
            <ac:spMk id="49" creationId="{9E8EA10B-DD56-0038-557C-21C01A01C667}"/>
          </ac:spMkLst>
        </pc:spChg>
        <pc:spChg chg="del">
          <ac:chgData name="Zoe Fehlberg" userId="5a123bd2-7317-4220-884d-082c90c58297" providerId="ADAL" clId="{49657F52-DF43-4424-9D2B-C4F51BBC0F9D}" dt="2023-10-09T23:14:08.488" v="63" actId="478"/>
          <ac:spMkLst>
            <pc:docMk/>
            <pc:sldMk cId="812589270" sldId="296"/>
            <ac:spMk id="51" creationId="{41268781-6795-5F72-87FA-A86C962F1A60}"/>
          </ac:spMkLst>
        </pc:spChg>
        <pc:spChg chg="mod">
          <ac:chgData name="Zoe Fehlberg" userId="5a123bd2-7317-4220-884d-082c90c58297" providerId="ADAL" clId="{49657F52-DF43-4424-9D2B-C4F51BBC0F9D}" dt="2023-10-09T23:14:31.257" v="75" actId="1076"/>
          <ac:spMkLst>
            <pc:docMk/>
            <pc:sldMk cId="812589270" sldId="296"/>
            <ac:spMk id="53" creationId="{E1258E7B-BCEF-5992-5166-B68B5D3C847D}"/>
          </ac:spMkLst>
        </pc:spChg>
        <pc:spChg chg="del">
          <ac:chgData name="Zoe Fehlberg" userId="5a123bd2-7317-4220-884d-082c90c58297" providerId="ADAL" clId="{49657F52-DF43-4424-9D2B-C4F51BBC0F9D}" dt="2023-10-09T23:14:07.624" v="62" actId="478"/>
          <ac:spMkLst>
            <pc:docMk/>
            <pc:sldMk cId="812589270" sldId="296"/>
            <ac:spMk id="70" creationId="{3B93E0A2-6D70-FCD5-7DB3-E415A92FF30D}"/>
          </ac:spMkLst>
        </pc:spChg>
        <pc:cxnChg chg="del mod">
          <ac:chgData name="Zoe Fehlberg" userId="5a123bd2-7317-4220-884d-082c90c58297" providerId="ADAL" clId="{49657F52-DF43-4424-9D2B-C4F51BBC0F9D}" dt="2023-10-09T23:14:13.251" v="69" actId="478"/>
          <ac:cxnSpMkLst>
            <pc:docMk/>
            <pc:sldMk cId="812589270" sldId="296"/>
            <ac:cxnSpMk id="32" creationId="{8D3DF31F-3FB3-4A31-0C76-CDEBD42B6E9F}"/>
          </ac:cxnSpMkLst>
        </pc:cxnChg>
        <pc:cxnChg chg="del mod">
          <ac:chgData name="Zoe Fehlberg" userId="5a123bd2-7317-4220-884d-082c90c58297" providerId="ADAL" clId="{49657F52-DF43-4424-9D2B-C4F51BBC0F9D}" dt="2023-10-09T23:14:11.267" v="66" actId="478"/>
          <ac:cxnSpMkLst>
            <pc:docMk/>
            <pc:sldMk cId="812589270" sldId="296"/>
            <ac:cxnSpMk id="41" creationId="{77CAE751-F38B-CEBE-4B6A-72B36EC06705}"/>
          </ac:cxnSpMkLst>
        </pc:cxnChg>
        <pc:cxnChg chg="del mod">
          <ac:chgData name="Zoe Fehlberg" userId="5a123bd2-7317-4220-884d-082c90c58297" providerId="ADAL" clId="{49657F52-DF43-4424-9D2B-C4F51BBC0F9D}" dt="2023-10-09T23:14:15.430" v="71" actId="478"/>
          <ac:cxnSpMkLst>
            <pc:docMk/>
            <pc:sldMk cId="812589270" sldId="296"/>
            <ac:cxnSpMk id="45" creationId="{1F2BD3BA-5D89-827C-4ECA-C0FE32E1D186}"/>
          </ac:cxnSpMkLst>
        </pc:cxnChg>
        <pc:cxnChg chg="del mod">
          <ac:chgData name="Zoe Fehlberg" userId="5a123bd2-7317-4220-884d-082c90c58297" providerId="ADAL" clId="{49657F52-DF43-4424-9D2B-C4F51BBC0F9D}" dt="2023-10-09T23:14:16.906" v="73" actId="478"/>
          <ac:cxnSpMkLst>
            <pc:docMk/>
            <pc:sldMk cId="812589270" sldId="296"/>
            <ac:cxnSpMk id="50" creationId="{0703C2D3-794B-55CE-F490-46C75ED4D417}"/>
          </ac:cxnSpMkLst>
        </pc:cxnChg>
        <pc:cxnChg chg="mod">
          <ac:chgData name="Zoe Fehlberg" userId="5a123bd2-7317-4220-884d-082c90c58297" providerId="ADAL" clId="{49657F52-DF43-4424-9D2B-C4F51BBC0F9D}" dt="2023-10-09T23:14:26.785" v="74" actId="1076"/>
          <ac:cxnSpMkLst>
            <pc:docMk/>
            <pc:sldMk cId="812589270" sldId="296"/>
            <ac:cxnSpMk id="52" creationId="{C0D6E7E9-B12F-22FB-0B0B-3293A01A5962}"/>
          </ac:cxnSpMkLst>
        </pc:cxnChg>
        <pc:cxnChg chg="mod">
          <ac:chgData name="Zoe Fehlberg" userId="5a123bd2-7317-4220-884d-082c90c58297" providerId="ADAL" clId="{49657F52-DF43-4424-9D2B-C4F51BBC0F9D}" dt="2023-10-09T23:14:31.257" v="75" actId="1076"/>
          <ac:cxnSpMkLst>
            <pc:docMk/>
            <pc:sldMk cId="812589270" sldId="296"/>
            <ac:cxnSpMk id="54" creationId="{9EE7C146-E73C-8CF3-3218-F761007744DC}"/>
          </ac:cxnSpMkLst>
        </pc:cxnChg>
      </pc:sldChg>
      <pc:sldChg chg="addSp delSp modSp mod">
        <pc:chgData name="Zoe Fehlberg" userId="5a123bd2-7317-4220-884d-082c90c58297" providerId="ADAL" clId="{49657F52-DF43-4424-9D2B-C4F51BBC0F9D}" dt="2023-10-09T23:14:44.979" v="82" actId="478"/>
        <pc:sldMkLst>
          <pc:docMk/>
          <pc:sldMk cId="3046406398" sldId="297"/>
        </pc:sldMkLst>
        <pc:spChg chg="add mod">
          <ac:chgData name="Zoe Fehlberg" userId="5a123bd2-7317-4220-884d-082c90c58297" providerId="ADAL" clId="{49657F52-DF43-4424-9D2B-C4F51BBC0F9D}" dt="2023-10-09T23:14:39.560" v="77"/>
          <ac:spMkLst>
            <pc:docMk/>
            <pc:sldMk cId="3046406398" sldId="297"/>
            <ac:spMk id="4" creationId="{88E46D1F-712F-F1C9-9BF5-216D07B21542}"/>
          </ac:spMkLst>
        </pc:spChg>
        <pc:spChg chg="del">
          <ac:chgData name="Zoe Fehlberg" userId="5a123bd2-7317-4220-884d-082c90c58297" providerId="ADAL" clId="{49657F52-DF43-4424-9D2B-C4F51BBC0F9D}" dt="2023-10-09T23:14:42.438" v="79" actId="478"/>
          <ac:spMkLst>
            <pc:docMk/>
            <pc:sldMk cId="3046406398" sldId="297"/>
            <ac:spMk id="14" creationId="{5D4EE213-3F66-F4CA-E1FF-8B5B51E66275}"/>
          </ac:spMkLst>
        </pc:spChg>
        <pc:spChg chg="del">
          <ac:chgData name="Zoe Fehlberg" userId="5a123bd2-7317-4220-884d-082c90c58297" providerId="ADAL" clId="{49657F52-DF43-4424-9D2B-C4F51BBC0F9D}" dt="2023-10-09T23:14:44.308" v="81" actId="478"/>
          <ac:spMkLst>
            <pc:docMk/>
            <pc:sldMk cId="3046406398" sldId="297"/>
            <ac:spMk id="49" creationId="{9E8EA10B-DD56-0038-557C-21C01A01C667}"/>
          </ac:spMkLst>
        </pc:spChg>
        <pc:spChg chg="del">
          <ac:chgData name="Zoe Fehlberg" userId="5a123bd2-7317-4220-884d-082c90c58297" providerId="ADAL" clId="{49657F52-DF43-4424-9D2B-C4F51BBC0F9D}" dt="2023-10-09T23:14:38.773" v="76" actId="478"/>
          <ac:spMkLst>
            <pc:docMk/>
            <pc:sldMk cId="3046406398" sldId="297"/>
            <ac:spMk id="51" creationId="{41268781-6795-5F72-87FA-A86C962F1A60}"/>
          </ac:spMkLst>
        </pc:spChg>
        <pc:spChg chg="del">
          <ac:chgData name="Zoe Fehlberg" userId="5a123bd2-7317-4220-884d-082c90c58297" providerId="ADAL" clId="{49657F52-DF43-4424-9D2B-C4F51BBC0F9D}" dt="2023-10-09T23:14:40.508" v="78" actId="478"/>
          <ac:spMkLst>
            <pc:docMk/>
            <pc:sldMk cId="3046406398" sldId="297"/>
            <ac:spMk id="70" creationId="{3B93E0A2-6D70-FCD5-7DB3-E415A92FF30D}"/>
          </ac:spMkLst>
        </pc:spChg>
        <pc:cxnChg chg="del mod">
          <ac:chgData name="Zoe Fehlberg" userId="5a123bd2-7317-4220-884d-082c90c58297" providerId="ADAL" clId="{49657F52-DF43-4424-9D2B-C4F51BBC0F9D}" dt="2023-10-09T23:14:43.026" v="80" actId="478"/>
          <ac:cxnSpMkLst>
            <pc:docMk/>
            <pc:sldMk cId="3046406398" sldId="297"/>
            <ac:cxnSpMk id="15" creationId="{DFBD98AF-4588-0932-29DB-FEACEDF3A6ED}"/>
          </ac:cxnSpMkLst>
        </pc:cxnChg>
        <pc:cxnChg chg="del mod">
          <ac:chgData name="Zoe Fehlberg" userId="5a123bd2-7317-4220-884d-082c90c58297" providerId="ADAL" clId="{49657F52-DF43-4424-9D2B-C4F51BBC0F9D}" dt="2023-10-09T23:14:44.979" v="82" actId="478"/>
          <ac:cxnSpMkLst>
            <pc:docMk/>
            <pc:sldMk cId="3046406398" sldId="297"/>
            <ac:cxnSpMk id="50" creationId="{0703C2D3-794B-55CE-F490-46C75ED4D417}"/>
          </ac:cxnSpMkLst>
        </pc:cxnChg>
      </pc:sldChg>
      <pc:sldChg chg="del">
        <pc:chgData name="Zoe Fehlberg" userId="5a123bd2-7317-4220-884d-082c90c58297" providerId="ADAL" clId="{49657F52-DF43-4424-9D2B-C4F51BBC0F9D}" dt="2023-10-09T23:15:16.157" v="84" actId="47"/>
        <pc:sldMkLst>
          <pc:docMk/>
          <pc:sldMk cId="2527435145" sldId="298"/>
        </pc:sldMkLst>
      </pc:sldChg>
      <pc:sldChg chg="del">
        <pc:chgData name="Zoe Fehlberg" userId="5a123bd2-7317-4220-884d-082c90c58297" providerId="ADAL" clId="{49657F52-DF43-4424-9D2B-C4F51BBC0F9D}" dt="2023-10-09T23:15:15.245" v="83" actId="47"/>
        <pc:sldMkLst>
          <pc:docMk/>
          <pc:sldMk cId="2979466486" sldId="30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BB17C3-5DD3-7231-A9A6-F4FE5D8F20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03B1D3-FEB2-80AA-2020-4ACFCCD0C6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8C96D8-F557-54FF-85B9-9F85F57EF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B85EE3-78D4-B51D-EB8D-6721F1E09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406C18-C157-0AF6-2D06-7FC9D4B3B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71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7BF35-FF27-CD54-30E4-47208578F3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2E70A8-FEA6-11D3-DC1B-318F1F1E2E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8E4543-69E7-E9EF-2D09-604434E32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1375F-D1F9-2D4C-1AB1-F3FC67E85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98E64C-B350-F73C-238D-9B8A14E50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6338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CE1D76-4311-5C3A-44EC-888E50E678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B409B4-8856-15FA-1C5B-D635F74B10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A65E68-7480-360E-ACE7-D1AEE555F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B3F755-2C7B-ACE3-A64C-C8A5E6875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669D68-2B24-C816-8217-537AF290E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9842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DCF1B-838F-0CA6-76E6-638BAC84A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154A5B-563B-F8F1-72C0-7F01829587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1F4B5F-B9D0-40CD-3C33-DC6D6ACAD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850830-F2C3-81DB-27E9-6731C6EC0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94AFF5-169B-55F9-EEF0-D1EC9186E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3549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F9700-A6DF-F4A2-914F-A7655B5BE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550900-98BC-6C46-4A97-B4403DCAE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49C50E-89F7-CBEC-37F3-A748183B8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416B2D-9879-1E0A-4C23-000158C80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0C5DE6-3143-62EF-1564-1883AF737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0911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0A6EE-66D9-E031-B4A9-54F821A56F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B08D61-0598-036C-8E5E-294A4223C7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4934F4-ED48-ACC0-C894-A6DE6D267B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B3065F-7B7D-DB99-14DD-F87A9F591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74635A-C0DF-184C-7613-E56B5EE89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52E9BA-94A5-7DAE-6919-8ED57A2EF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3307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BE89F-75C8-D096-340F-4C9487E7C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27438E-DD2E-C84F-2593-2E7229B0CA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787117-E0BB-4958-12AF-C245914D5E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4C75D9-A898-7FF9-92C2-F945021B0B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2143BA9-328D-3F09-1E0C-5368A94FA7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684590F-8BB0-8EDC-5E5E-C4698108F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EFD14F-E246-F312-31F1-DA30679F4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115207-2CF4-D8B1-4365-2EF02C835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0034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F78CB4-8E3F-4AE7-4970-98C11C2833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3FBE71-A874-116D-0724-46BAB76C1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3E7FB2-06C3-F5DE-4507-135C687D7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F1AB94-F940-D418-BBD1-2B2A656D6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6433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E9061C-F36F-942F-AF98-F6535E6CC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7DA4CA-9F08-73DF-F5E5-127EE5582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474929-CD95-3F76-8693-CD7C211D8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80456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4057A-9CC5-078B-1070-1CA33D408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FD9BD2-45A1-FC83-6C66-5771AB5E3C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4C7416-8DC3-2F9E-9069-437072C211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70ED6C-8D58-0876-937B-B473A5C96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776559-69DD-B5D8-57E3-5DD9EFF6E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D9CCF4-FBDF-F512-5DF9-C6051C36D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40100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43FAB-CF1E-F5DE-A247-E31E5334B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2ADEBF-8F53-80B5-4223-1E99F94701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F7061B-6F38-1628-905F-AF88EBF3D0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AA025D-21F0-C64B-BE72-924CE916F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E0B0C1-E15E-8168-5FB2-D2ADA31C9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202B54-C0A6-5C7C-26D7-7BA104913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11135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6E13F0-A484-92FD-6180-8EA04ECFE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145030-3540-0635-6D0E-46F5500AF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C27885-DB2C-9485-0B11-1A4EA30377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5D999-0173-448A-BDE0-1CE939844B21}" type="datetimeFigureOut">
              <a:rPr lang="en-AU" smtClean="0"/>
              <a:t>10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DAFA0F-5D74-0397-D521-09042A1F92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19E76-8999-04D7-7E52-CC424781B4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ADDC7-AB23-4038-9CC6-51AA9263FB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615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ECC12A87-39C6-930A-BEF8-12EE4FB136A4}"/>
              </a:ext>
            </a:extLst>
          </p:cNvPr>
          <p:cNvCxnSpPr>
            <a:cxnSpLocks/>
          </p:cNvCxnSpPr>
          <p:nvPr/>
        </p:nvCxnSpPr>
        <p:spPr>
          <a:xfrm>
            <a:off x="7616377" y="2012992"/>
            <a:ext cx="367099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FAE73F07-CDC6-9C5C-BDBA-C2580AF7D873}"/>
              </a:ext>
            </a:extLst>
          </p:cNvPr>
          <p:cNvCxnSpPr>
            <a:cxnSpLocks/>
          </p:cNvCxnSpPr>
          <p:nvPr/>
        </p:nvCxnSpPr>
        <p:spPr>
          <a:xfrm flipV="1">
            <a:off x="2169217" y="1645756"/>
            <a:ext cx="2377453" cy="23409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51AFDEA7-65FB-4AF8-948A-F65B9D9C0AE1}"/>
              </a:ext>
            </a:extLst>
          </p:cNvPr>
          <p:cNvCxnSpPr>
            <a:cxnSpLocks/>
            <a:stCxn id="2" idx="3"/>
          </p:cNvCxnSpPr>
          <p:nvPr/>
        </p:nvCxnSpPr>
        <p:spPr>
          <a:xfrm>
            <a:off x="1123908" y="1930969"/>
            <a:ext cx="3443274" cy="41366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103E6C18-003E-4455-B4AC-2CDA0F446D40}"/>
              </a:ext>
            </a:extLst>
          </p:cNvPr>
          <p:cNvCxnSpPr>
            <a:cxnSpLocks/>
          </p:cNvCxnSpPr>
          <p:nvPr/>
        </p:nvCxnSpPr>
        <p:spPr>
          <a:xfrm>
            <a:off x="5431853" y="1510168"/>
            <a:ext cx="590010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FBDA9FC-BF5A-8F23-E7B6-03472A435645}"/>
              </a:ext>
            </a:extLst>
          </p:cNvPr>
          <p:cNvCxnSpPr>
            <a:cxnSpLocks/>
          </p:cNvCxnSpPr>
          <p:nvPr/>
        </p:nvCxnSpPr>
        <p:spPr>
          <a:xfrm>
            <a:off x="5530871" y="2344273"/>
            <a:ext cx="575649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588EE4AF-F7F5-E9E1-7B01-F000DCC52C0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E6CDAE-BF5D-2048-4393-964B74E85277}"/>
              </a:ext>
            </a:extLst>
          </p:cNvPr>
          <p:cNvSpPr txBox="1"/>
          <p:nvPr/>
        </p:nvSpPr>
        <p:spPr>
          <a:xfrm>
            <a:off x="11236034" y="0"/>
            <a:ext cx="841860" cy="37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G01</a:t>
            </a:r>
            <a:endParaRPr lang="en-AU" dirty="0"/>
          </a:p>
        </p:txBody>
      </p: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915A58E2-2F80-B366-09E9-77568FFCCECD}"/>
              </a:ext>
            </a:extLst>
          </p:cNvPr>
          <p:cNvSpPr/>
          <p:nvPr/>
        </p:nvSpPr>
        <p:spPr>
          <a:xfrm>
            <a:off x="67272" y="1598282"/>
            <a:ext cx="1056636" cy="665374"/>
          </a:xfrm>
          <a:prstGeom prst="round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Reanalysis discussed in pre-test appointment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06A2003-D750-C9B8-78DE-F84ED09F5C38}"/>
              </a:ext>
            </a:extLst>
          </p:cNvPr>
          <p:cNvSpPr/>
          <p:nvPr/>
        </p:nvSpPr>
        <p:spPr>
          <a:xfrm>
            <a:off x="1186622" y="1590463"/>
            <a:ext cx="982595" cy="666154"/>
          </a:xfrm>
          <a:prstGeom prst="rect">
            <a:avLst/>
          </a:prstGeom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Unsolved patient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B35A2D4-2909-A394-9184-AB2921150E81}"/>
              </a:ext>
            </a:extLst>
          </p:cNvPr>
          <p:cNvSpPr/>
          <p:nvPr/>
        </p:nvSpPr>
        <p:spPr>
          <a:xfrm>
            <a:off x="2265090" y="1500532"/>
            <a:ext cx="1140398" cy="92373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Clinician books patient in for a review appointment in 2-3 years time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746B09AF-712D-6CB3-C024-D2FCCEFD5175}"/>
              </a:ext>
            </a:extLst>
          </p:cNvPr>
          <p:cNvSpPr/>
          <p:nvPr/>
        </p:nvSpPr>
        <p:spPr>
          <a:xfrm>
            <a:off x="3475664" y="1515353"/>
            <a:ext cx="963689" cy="93362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Patient seen at review appointment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67C9C96-C454-3F97-C709-0119298C4C1B}"/>
              </a:ext>
            </a:extLst>
          </p:cNvPr>
          <p:cNvSpPr/>
          <p:nvPr/>
        </p:nvSpPr>
        <p:spPr>
          <a:xfrm>
            <a:off x="4546670" y="1325544"/>
            <a:ext cx="963689" cy="640424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 4. Enrol patient in research a project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8C3F172-7CAE-D204-08A7-06E936C9B653}"/>
              </a:ext>
            </a:extLst>
          </p:cNvPr>
          <p:cNvSpPr/>
          <p:nvPr/>
        </p:nvSpPr>
        <p:spPr>
          <a:xfrm>
            <a:off x="4567182" y="2024421"/>
            <a:ext cx="963689" cy="640424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 5. Take case to consulting clinicians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C3B36BF-C3EC-D890-3AA7-8A4E6CB6F4F1}"/>
              </a:ext>
            </a:extLst>
          </p:cNvPr>
          <p:cNvSpPr/>
          <p:nvPr/>
        </p:nvSpPr>
        <p:spPr>
          <a:xfrm>
            <a:off x="7693891" y="1398788"/>
            <a:ext cx="687662" cy="23108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+ result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BE7EA96-7DAC-F31C-C02A-2901B5E80427}"/>
              </a:ext>
            </a:extLst>
          </p:cNvPr>
          <p:cNvSpPr/>
          <p:nvPr/>
        </p:nvSpPr>
        <p:spPr>
          <a:xfrm>
            <a:off x="7705677" y="1872415"/>
            <a:ext cx="678952" cy="247104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- result</a:t>
            </a:r>
          </a:p>
        </p:txBody>
      </p:sp>
      <p:sp>
        <p:nvSpPr>
          <p:cNvPr id="41" name="Flowchart: Terminator 40">
            <a:extLst>
              <a:ext uri="{FF2B5EF4-FFF2-40B4-BE49-F238E27FC236}">
                <a16:creationId xmlns:a16="http://schemas.microsoft.com/office/drawing/2014/main" id="{29033DB8-2D2F-643B-A07F-44AC591C8090}"/>
              </a:ext>
            </a:extLst>
          </p:cNvPr>
          <p:cNvSpPr/>
          <p:nvPr/>
        </p:nvSpPr>
        <p:spPr>
          <a:xfrm>
            <a:off x="11327754" y="1344169"/>
            <a:ext cx="750140" cy="1104810"/>
          </a:xfrm>
          <a:prstGeom prst="flowChartTerminator">
            <a:avLst/>
          </a:prstGeom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0. Patient informed about results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B2225A58-DF98-BADC-80A2-D45D5AF83E99}"/>
              </a:ext>
            </a:extLst>
          </p:cNvPr>
          <p:cNvSpPr/>
          <p:nvPr/>
        </p:nvSpPr>
        <p:spPr>
          <a:xfrm>
            <a:off x="9330858" y="1297906"/>
            <a:ext cx="1222603" cy="407305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9. Secure funding to get report issued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215BE726-7D49-A00F-913F-9D819173A599}"/>
              </a:ext>
            </a:extLst>
          </p:cNvPr>
          <p:cNvSpPr/>
          <p:nvPr/>
        </p:nvSpPr>
        <p:spPr>
          <a:xfrm>
            <a:off x="9340173" y="2215934"/>
            <a:ext cx="944079" cy="2566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Return apt.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F20F4EF-5576-D0F3-6E61-B6418DBB2A6F}"/>
              </a:ext>
            </a:extLst>
          </p:cNvPr>
          <p:cNvSpPr/>
          <p:nvPr/>
        </p:nvSpPr>
        <p:spPr>
          <a:xfrm>
            <a:off x="7705677" y="2251993"/>
            <a:ext cx="687662" cy="23108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+ result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DCB51C5-CE84-E805-00E8-9C6C40AEE9F5}"/>
              </a:ext>
            </a:extLst>
          </p:cNvPr>
          <p:cNvSpPr/>
          <p:nvPr/>
        </p:nvSpPr>
        <p:spPr>
          <a:xfrm>
            <a:off x="8484851" y="1338486"/>
            <a:ext cx="750140" cy="138016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8. Clinician informed about result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0A3F4C3-A8D3-8AF5-6F2D-D60C9433E084}"/>
              </a:ext>
            </a:extLst>
          </p:cNvPr>
          <p:cNvSpPr/>
          <p:nvPr/>
        </p:nvSpPr>
        <p:spPr>
          <a:xfrm>
            <a:off x="6726384" y="1367223"/>
            <a:ext cx="889993" cy="1291538"/>
          </a:xfrm>
          <a:prstGeom prst="rect">
            <a:avLst/>
          </a:prstGeom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Data reanalysed</a:t>
            </a:r>
            <a:endParaRPr lang="en-GB" sz="1000" b="1" dirty="0">
              <a:highlight>
                <a:srgbClr val="FFFF00"/>
              </a:highlight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21AAA01-EDAE-A837-C5D0-1BC76D080280}"/>
              </a:ext>
            </a:extLst>
          </p:cNvPr>
          <p:cNvSpPr/>
          <p:nvPr/>
        </p:nvSpPr>
        <p:spPr>
          <a:xfrm>
            <a:off x="9338289" y="1866450"/>
            <a:ext cx="961112" cy="23971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hone call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2DFE1811-A9EA-26ED-9E96-3662F1AA055F}"/>
              </a:ext>
            </a:extLst>
          </p:cNvPr>
          <p:cNvSpPr/>
          <p:nvPr/>
        </p:nvSpPr>
        <p:spPr>
          <a:xfrm>
            <a:off x="5605172" y="2024133"/>
            <a:ext cx="963689" cy="64028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Send Lab test request + additional consent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1B00205D-4558-EB95-A359-DC32ECC5BB1E}"/>
              </a:ext>
            </a:extLst>
          </p:cNvPr>
          <p:cNvSpPr/>
          <p:nvPr/>
        </p:nvSpPr>
        <p:spPr>
          <a:xfrm>
            <a:off x="10649328" y="1312034"/>
            <a:ext cx="575128" cy="376995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Return apt.</a:t>
            </a:r>
          </a:p>
        </p:txBody>
      </p:sp>
      <p:sp>
        <p:nvSpPr>
          <p:cNvPr id="88" name="Rectangle: Rounded Corners 87">
            <a:extLst>
              <a:ext uri="{FF2B5EF4-FFF2-40B4-BE49-F238E27FC236}">
                <a16:creationId xmlns:a16="http://schemas.microsoft.com/office/drawing/2014/main" id="{09366D7F-AD8B-016E-FBD2-90C09B17FCC8}"/>
              </a:ext>
            </a:extLst>
          </p:cNvPr>
          <p:cNvSpPr/>
          <p:nvPr/>
        </p:nvSpPr>
        <p:spPr>
          <a:xfrm>
            <a:off x="114105" y="3105801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89" name="Rectangle: Rounded Corners 88">
            <a:extLst>
              <a:ext uri="{FF2B5EF4-FFF2-40B4-BE49-F238E27FC236}">
                <a16:creationId xmlns:a16="http://schemas.microsoft.com/office/drawing/2014/main" id="{1CE396E6-F873-8046-64DB-346CD4BC25D4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450B26E9-EA9F-AF26-A75D-CB17F28E91F9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1" name="Rectangle 90">
            <a:extLst>
              <a:ext uri="{FF2B5EF4-FFF2-40B4-BE49-F238E27FC236}">
                <a16:creationId xmlns:a16="http://schemas.microsoft.com/office/drawing/2014/main" id="{412B8C04-DB2B-AD48-50B5-8D6463129526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41EF6111-F523-A64A-EACA-99661AD3C489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3" name="Rectangle 92">
            <a:extLst>
              <a:ext uri="{FF2B5EF4-FFF2-40B4-BE49-F238E27FC236}">
                <a16:creationId xmlns:a16="http://schemas.microsoft.com/office/drawing/2014/main" id="{E6471EE8-D5AA-998D-67EA-A785942B96BE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FBFD5F28-F89D-A732-326C-8A0A7BBA2A84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04E39936-81C6-662B-0EE2-B6D0B88AFADC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033479A3-27A1-8724-A828-F2AD55BC5774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4C745B9C-8F76-5A7D-01FF-7A36E07C0127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17450819-F5C6-B501-DA4C-85DE6AFB2EE7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E7E60435-0A49-C11A-EFF6-B57551F5C6BD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: Rounded Corners 99">
            <a:extLst>
              <a:ext uri="{FF2B5EF4-FFF2-40B4-BE49-F238E27FC236}">
                <a16:creationId xmlns:a16="http://schemas.microsoft.com/office/drawing/2014/main" id="{CB21A7D5-8BE1-1F10-C33C-8DE416EB343D}"/>
              </a:ext>
            </a:extLst>
          </p:cNvPr>
          <p:cNvSpPr/>
          <p:nvPr/>
        </p:nvSpPr>
        <p:spPr>
          <a:xfrm>
            <a:off x="265392" y="4732121"/>
            <a:ext cx="1007758" cy="528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Funded reanalysis program 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8A6952A3-BE49-21FF-70FB-FB989F000CBB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4829BE8B-7AE8-18C9-C072-F9BE15D9A6C8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375EF74D-97BD-CC42-1A4B-3377F75EC657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F5739463-F8BE-0461-23A7-2F64AD3A6A7A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B6D6AF89-E4EF-5772-ED6C-2D107A740378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6" name="Rectangle: Rounded Corners 105">
            <a:extLst>
              <a:ext uri="{FF2B5EF4-FFF2-40B4-BE49-F238E27FC236}">
                <a16:creationId xmlns:a16="http://schemas.microsoft.com/office/drawing/2014/main" id="{F0A7C9CD-2CF7-9F4D-F18E-0A4A49921C97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cxnSp>
        <p:nvCxnSpPr>
          <p:cNvPr id="107" name="Connector: Elbow 106">
            <a:extLst>
              <a:ext uri="{FF2B5EF4-FFF2-40B4-BE49-F238E27FC236}">
                <a16:creationId xmlns:a16="http://schemas.microsoft.com/office/drawing/2014/main" id="{61D6B097-B384-29A9-12DB-648BC4FAC426}"/>
              </a:ext>
            </a:extLst>
          </p:cNvPr>
          <p:cNvCxnSpPr>
            <a:stCxn id="100" idx="1"/>
          </p:cNvCxnSpPr>
          <p:nvPr/>
        </p:nvCxnSpPr>
        <p:spPr>
          <a:xfrm rot="10800000" flipV="1">
            <a:off x="223024" y="4996539"/>
            <a:ext cx="42369" cy="825781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Rectangle 107">
            <a:extLst>
              <a:ext uri="{FF2B5EF4-FFF2-40B4-BE49-F238E27FC236}">
                <a16:creationId xmlns:a16="http://schemas.microsoft.com/office/drawing/2014/main" id="{D295140B-B2E0-E13A-4090-A21576FAA76D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118" name="Rectangle: Rounded Corners 117">
            <a:extLst>
              <a:ext uri="{FF2B5EF4-FFF2-40B4-BE49-F238E27FC236}">
                <a16:creationId xmlns:a16="http://schemas.microsoft.com/office/drawing/2014/main" id="{C2E7970E-1BD5-68C2-D96C-EE090E92BDA4}"/>
              </a:ext>
            </a:extLst>
          </p:cNvPr>
          <p:cNvSpPr/>
          <p:nvPr/>
        </p:nvSpPr>
        <p:spPr>
          <a:xfrm>
            <a:off x="3201101" y="4704475"/>
            <a:ext cx="1007758" cy="56805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Develop a pipeline</a:t>
            </a:r>
          </a:p>
        </p:txBody>
      </p:sp>
      <p:cxnSp>
        <p:nvCxnSpPr>
          <p:cNvPr id="119" name="Connector: Elbow 118">
            <a:extLst>
              <a:ext uri="{FF2B5EF4-FFF2-40B4-BE49-F238E27FC236}">
                <a16:creationId xmlns:a16="http://schemas.microsoft.com/office/drawing/2014/main" id="{5A150790-9A22-D544-AA45-C6C3987E7AD3}"/>
              </a:ext>
            </a:extLst>
          </p:cNvPr>
          <p:cNvCxnSpPr>
            <a:cxnSpLocks/>
            <a:stCxn id="118" idx="1"/>
          </p:cNvCxnSpPr>
          <p:nvPr/>
        </p:nvCxnSpPr>
        <p:spPr>
          <a:xfrm rot="10800000" flipV="1">
            <a:off x="3148245" y="4988500"/>
            <a:ext cx="52857" cy="50013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Rectangle: Rounded Corners 121">
            <a:extLst>
              <a:ext uri="{FF2B5EF4-FFF2-40B4-BE49-F238E27FC236}">
                <a16:creationId xmlns:a16="http://schemas.microsoft.com/office/drawing/2014/main" id="{CA0628E7-342F-66E3-FED9-0A30A94E8E03}"/>
              </a:ext>
            </a:extLst>
          </p:cNvPr>
          <p:cNvSpPr/>
          <p:nvPr/>
        </p:nvSpPr>
        <p:spPr>
          <a:xfrm>
            <a:off x="5809967" y="4620985"/>
            <a:ext cx="1086799" cy="648919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 and changes to workflows </a:t>
            </a:r>
          </a:p>
        </p:txBody>
      </p:sp>
      <p:cxnSp>
        <p:nvCxnSpPr>
          <p:cNvPr id="123" name="Connector: Elbow 122">
            <a:extLst>
              <a:ext uri="{FF2B5EF4-FFF2-40B4-BE49-F238E27FC236}">
                <a16:creationId xmlns:a16="http://schemas.microsoft.com/office/drawing/2014/main" id="{E0584605-4E9C-1DDE-0F34-B3F07602F533}"/>
              </a:ext>
            </a:extLst>
          </p:cNvPr>
          <p:cNvCxnSpPr>
            <a:cxnSpLocks/>
            <a:stCxn id="122" idx="1"/>
          </p:cNvCxnSpPr>
          <p:nvPr/>
        </p:nvCxnSpPr>
        <p:spPr>
          <a:xfrm rot="10800000" flipV="1">
            <a:off x="5757113" y="4945445"/>
            <a:ext cx="52854" cy="540572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Rectangle: Rounded Corners 123">
            <a:extLst>
              <a:ext uri="{FF2B5EF4-FFF2-40B4-BE49-F238E27FC236}">
                <a16:creationId xmlns:a16="http://schemas.microsoft.com/office/drawing/2014/main" id="{8E100010-E2EA-953D-B5FB-AB94CD19384A}"/>
              </a:ext>
            </a:extLst>
          </p:cNvPr>
          <p:cNvSpPr/>
          <p:nvPr/>
        </p:nvSpPr>
        <p:spPr>
          <a:xfrm>
            <a:off x="8330531" y="4576598"/>
            <a:ext cx="1007758" cy="648919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al workloads and changes to workflows </a:t>
            </a:r>
          </a:p>
        </p:txBody>
      </p:sp>
      <p:cxnSp>
        <p:nvCxnSpPr>
          <p:cNvPr id="125" name="Connector: Elbow 124">
            <a:extLst>
              <a:ext uri="{FF2B5EF4-FFF2-40B4-BE49-F238E27FC236}">
                <a16:creationId xmlns:a16="http://schemas.microsoft.com/office/drawing/2014/main" id="{C0D50B56-A869-68B0-2865-806CB035AC85}"/>
              </a:ext>
            </a:extLst>
          </p:cNvPr>
          <p:cNvCxnSpPr>
            <a:cxnSpLocks/>
            <a:stCxn id="124" idx="1"/>
          </p:cNvCxnSpPr>
          <p:nvPr/>
        </p:nvCxnSpPr>
        <p:spPr>
          <a:xfrm rot="10800000" flipV="1">
            <a:off x="8277679" y="4901058"/>
            <a:ext cx="52853" cy="540572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Rectangle: Rounded Corners 129">
            <a:extLst>
              <a:ext uri="{FF2B5EF4-FFF2-40B4-BE49-F238E27FC236}">
                <a16:creationId xmlns:a16="http://schemas.microsoft.com/office/drawing/2014/main" id="{9D33B8DB-2206-5AF9-5EFC-F4A9F892C607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26523717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32445" y="4002772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2AA2CC-F06D-B8CE-9172-D5AB9292BC1D}"/>
              </a:ext>
            </a:extLst>
          </p:cNvPr>
          <p:cNvSpPr txBox="1"/>
          <p:nvPr/>
        </p:nvSpPr>
        <p:spPr>
          <a:xfrm>
            <a:off x="10906926" y="245207"/>
            <a:ext cx="1648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C11</a:t>
            </a:r>
            <a:endParaRPr lang="en-AU" dirty="0"/>
          </a:p>
        </p:txBody>
      </p: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B944D1D9-79B1-D1A7-7CA1-440A22ADCB1D}"/>
              </a:ext>
            </a:extLst>
          </p:cNvPr>
          <p:cNvSpPr/>
          <p:nvPr/>
        </p:nvSpPr>
        <p:spPr>
          <a:xfrm>
            <a:off x="7941111" y="4641651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al team capacity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11608911-5F6A-A725-8AE6-4CF102B31F1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7888257" y="4940687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oup 3">
            <a:extLst>
              <a:ext uri="{FF2B5EF4-FFF2-40B4-BE49-F238E27FC236}">
                <a16:creationId xmlns:a16="http://schemas.microsoft.com/office/drawing/2014/main" id="{8BF7F0D2-83DB-164A-F018-0B378AE0FBFC}"/>
              </a:ext>
            </a:extLst>
          </p:cNvPr>
          <p:cNvGrpSpPr/>
          <p:nvPr/>
        </p:nvGrpSpPr>
        <p:grpSpPr>
          <a:xfrm>
            <a:off x="345121" y="1678173"/>
            <a:ext cx="10970695" cy="1013606"/>
            <a:chOff x="617678" y="1257343"/>
            <a:chExt cx="10970695" cy="1041884"/>
          </a:xfrm>
          <a:solidFill>
            <a:schemeClr val="bg1"/>
          </a:solidFill>
        </p:grpSpPr>
        <p:sp>
          <p:nvSpPr>
            <p:cNvPr id="5" name="Flowchart: Terminator 4">
              <a:extLst>
                <a:ext uri="{FF2B5EF4-FFF2-40B4-BE49-F238E27FC236}">
                  <a16:creationId xmlns:a16="http://schemas.microsoft.com/office/drawing/2014/main" id="{4A5781C6-5B4A-7F2E-85BD-D5A4033A212C}"/>
                </a:ext>
              </a:extLst>
            </p:cNvPr>
            <p:cNvSpPr/>
            <p:nvPr/>
          </p:nvSpPr>
          <p:spPr>
            <a:xfrm>
              <a:off x="617678" y="1265377"/>
              <a:ext cx="779877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8" name="Flowchart: Terminator 7">
              <a:extLst>
                <a:ext uri="{FF2B5EF4-FFF2-40B4-BE49-F238E27FC236}">
                  <a16:creationId xmlns:a16="http://schemas.microsoft.com/office/drawing/2014/main" id="{17A58B04-E615-9F10-5494-0824A8CC2CE4}"/>
                </a:ext>
              </a:extLst>
            </p:cNvPr>
            <p:cNvSpPr/>
            <p:nvPr/>
          </p:nvSpPr>
          <p:spPr>
            <a:xfrm>
              <a:off x="9598268" y="1257343"/>
              <a:ext cx="1990105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8. Patient informed about results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3EF7FAB5-73B7-07DB-6C6F-A8B7FBD74CD5}"/>
                </a:ext>
              </a:extLst>
            </p:cNvPr>
            <p:cNvCxnSpPr>
              <a:cxnSpLocks/>
              <a:endCxn id="8" idx="1"/>
            </p:cNvCxnSpPr>
            <p:nvPr/>
          </p:nvCxnSpPr>
          <p:spPr>
            <a:xfrm>
              <a:off x="1442581" y="1717572"/>
              <a:ext cx="8155687" cy="23787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86648C99-6B95-8CA7-3C53-2304C54B27A1}"/>
                </a:ext>
              </a:extLst>
            </p:cNvPr>
            <p:cNvSpPr/>
            <p:nvPr/>
          </p:nvSpPr>
          <p:spPr>
            <a:xfrm>
              <a:off x="5816451" y="1331195"/>
              <a:ext cx="1252634" cy="968032"/>
            </a:xfrm>
            <a:prstGeom prst="roundRect">
              <a:avLst/>
            </a:prstGeom>
            <a:solidFill>
              <a:schemeClr val="bg1"/>
            </a:solidFill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5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8FC689C9-D9CA-56F1-6F6A-20C9969A4354}"/>
              </a:ext>
            </a:extLst>
          </p:cNvPr>
          <p:cNvSpPr/>
          <p:nvPr/>
        </p:nvSpPr>
        <p:spPr>
          <a:xfrm>
            <a:off x="1211179" y="1800705"/>
            <a:ext cx="967379" cy="65041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Patient seen at review appointment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586FC65-0321-9244-74C4-CC4A0065545F}"/>
              </a:ext>
            </a:extLst>
          </p:cNvPr>
          <p:cNvSpPr/>
          <p:nvPr/>
        </p:nvSpPr>
        <p:spPr>
          <a:xfrm>
            <a:off x="6964926" y="1874843"/>
            <a:ext cx="1131865" cy="56976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Genetics team receive result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42CCD67-5B77-2ACF-7148-61D263553B31}"/>
              </a:ext>
            </a:extLst>
          </p:cNvPr>
          <p:cNvSpPr/>
          <p:nvPr/>
        </p:nvSpPr>
        <p:spPr>
          <a:xfrm>
            <a:off x="8167848" y="1920919"/>
            <a:ext cx="1012958" cy="42603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7. Book return app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8E7AB99-16E9-63A3-4A00-AE8E66907F4C}"/>
              </a:ext>
            </a:extLst>
          </p:cNvPr>
          <p:cNvSpPr/>
          <p:nvPr/>
        </p:nvSpPr>
        <p:spPr>
          <a:xfrm>
            <a:off x="2310437" y="1891923"/>
            <a:ext cx="967379" cy="42603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reconsented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C40634B-499F-7A5B-5A9A-CA8EFF970634}"/>
              </a:ext>
            </a:extLst>
          </p:cNvPr>
          <p:cNvSpPr/>
          <p:nvPr/>
        </p:nvSpPr>
        <p:spPr>
          <a:xfrm>
            <a:off x="4498086" y="1894572"/>
            <a:ext cx="967379" cy="42603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 Lab sent request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2E115C3-66C9-A3D7-E0AB-EF1340F12BE6}"/>
              </a:ext>
            </a:extLst>
          </p:cNvPr>
          <p:cNvSpPr/>
          <p:nvPr/>
        </p:nvSpPr>
        <p:spPr>
          <a:xfrm>
            <a:off x="3399725" y="1874843"/>
            <a:ext cx="1027944" cy="51819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Clinic department funded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C1235AD1-278E-09EB-B9E7-94B5E33916F6}"/>
              </a:ext>
            </a:extLst>
          </p:cNvPr>
          <p:cNvSpPr/>
          <p:nvPr/>
        </p:nvSpPr>
        <p:spPr>
          <a:xfrm>
            <a:off x="5273005" y="4652298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</a:t>
            </a:r>
          </a:p>
        </p:txBody>
      </p:sp>
      <p:cxnSp>
        <p:nvCxnSpPr>
          <p:cNvPr id="19" name="Connector: Elbow 18">
            <a:extLst>
              <a:ext uri="{FF2B5EF4-FFF2-40B4-BE49-F238E27FC236}">
                <a16:creationId xmlns:a16="http://schemas.microsoft.com/office/drawing/2014/main" id="{B6AA99B6-A24B-E725-5925-950DB4FD5697}"/>
              </a:ext>
            </a:extLst>
          </p:cNvPr>
          <p:cNvCxnSpPr>
            <a:cxnSpLocks/>
            <a:stCxn id="18" idx="1"/>
          </p:cNvCxnSpPr>
          <p:nvPr/>
        </p:nvCxnSpPr>
        <p:spPr>
          <a:xfrm rot="10800000" flipV="1">
            <a:off x="5220151" y="4951334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0DDD7C61-A232-65BF-ECD5-C77A714655CB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8839953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32445" y="4002772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B944D1D9-79B1-D1A7-7CA1-440A22ADCB1D}"/>
              </a:ext>
            </a:extLst>
          </p:cNvPr>
          <p:cNvSpPr/>
          <p:nvPr/>
        </p:nvSpPr>
        <p:spPr>
          <a:xfrm>
            <a:off x="7941111" y="4641651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capacity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11608911-5F6A-A725-8AE6-4CF102B31F1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7888257" y="4940687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C1235AD1-278E-09EB-B9E7-94B5E33916F6}"/>
              </a:ext>
            </a:extLst>
          </p:cNvPr>
          <p:cNvSpPr/>
          <p:nvPr/>
        </p:nvSpPr>
        <p:spPr>
          <a:xfrm>
            <a:off x="5273005" y="4652298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</a:t>
            </a:r>
          </a:p>
        </p:txBody>
      </p:sp>
      <p:cxnSp>
        <p:nvCxnSpPr>
          <p:cNvPr id="19" name="Connector: Elbow 18">
            <a:extLst>
              <a:ext uri="{FF2B5EF4-FFF2-40B4-BE49-F238E27FC236}">
                <a16:creationId xmlns:a16="http://schemas.microsoft.com/office/drawing/2014/main" id="{B6AA99B6-A24B-E725-5925-950DB4FD5697}"/>
              </a:ext>
            </a:extLst>
          </p:cNvPr>
          <p:cNvCxnSpPr>
            <a:cxnSpLocks/>
            <a:stCxn id="18" idx="1"/>
          </p:cNvCxnSpPr>
          <p:nvPr/>
        </p:nvCxnSpPr>
        <p:spPr>
          <a:xfrm rot="10800000" flipV="1">
            <a:off x="5220151" y="4951334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C4C886BB-A27D-4AD0-99AB-F275D61490DA}"/>
              </a:ext>
            </a:extLst>
          </p:cNvPr>
          <p:cNvSpPr txBox="1"/>
          <p:nvPr/>
        </p:nvSpPr>
        <p:spPr>
          <a:xfrm>
            <a:off x="11120676" y="114107"/>
            <a:ext cx="9572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GC14</a:t>
            </a:r>
            <a:endParaRPr lang="en-AU" dirty="0"/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43456D6E-274F-F388-06DD-092BDFF087CB}"/>
              </a:ext>
            </a:extLst>
          </p:cNvPr>
          <p:cNvCxnSpPr>
            <a:cxnSpLocks/>
          </p:cNvCxnSpPr>
          <p:nvPr/>
        </p:nvCxnSpPr>
        <p:spPr>
          <a:xfrm flipV="1">
            <a:off x="1380324" y="2165207"/>
            <a:ext cx="4436886" cy="2077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71" name="Group 70">
            <a:extLst>
              <a:ext uri="{FF2B5EF4-FFF2-40B4-BE49-F238E27FC236}">
                <a16:creationId xmlns:a16="http://schemas.microsoft.com/office/drawing/2014/main" id="{7F5EBEEA-CF44-2740-93DB-394E0C456C29}"/>
              </a:ext>
            </a:extLst>
          </p:cNvPr>
          <p:cNvGrpSpPr/>
          <p:nvPr/>
        </p:nvGrpSpPr>
        <p:grpSpPr>
          <a:xfrm>
            <a:off x="105672" y="1403846"/>
            <a:ext cx="12086328" cy="1001094"/>
            <a:chOff x="122904" y="1265377"/>
            <a:chExt cx="12086328" cy="1001094"/>
          </a:xfrm>
          <a:solidFill>
            <a:schemeClr val="bg1"/>
          </a:solidFill>
        </p:grpSpPr>
        <p:sp>
          <p:nvSpPr>
            <p:cNvPr id="72" name="Flowchart: Terminator 71">
              <a:extLst>
                <a:ext uri="{FF2B5EF4-FFF2-40B4-BE49-F238E27FC236}">
                  <a16:creationId xmlns:a16="http://schemas.microsoft.com/office/drawing/2014/main" id="{29312D9B-7E6C-0041-E11F-3B82D802AFF7}"/>
                </a:ext>
              </a:extLst>
            </p:cNvPr>
            <p:cNvSpPr/>
            <p:nvPr/>
          </p:nvSpPr>
          <p:spPr>
            <a:xfrm>
              <a:off x="122904" y="1265377"/>
              <a:ext cx="1274652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09D97D39-B3C4-11E6-9926-26D9CB9A14E3}"/>
                </a:ext>
              </a:extLst>
            </p:cNvPr>
            <p:cNvSpPr/>
            <p:nvPr/>
          </p:nvSpPr>
          <p:spPr>
            <a:xfrm>
              <a:off x="5986660" y="1298439"/>
              <a:ext cx="1034051" cy="968032"/>
            </a:xfrm>
            <a:prstGeom prst="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4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  <p:sp>
          <p:nvSpPr>
            <p:cNvPr id="74" name="Flowchart: Terminator 73">
              <a:extLst>
                <a:ext uri="{FF2B5EF4-FFF2-40B4-BE49-F238E27FC236}">
                  <a16:creationId xmlns:a16="http://schemas.microsoft.com/office/drawing/2014/main" id="{515DB2F3-F006-EC39-1E0E-42CFA9EFDEB8}"/>
                </a:ext>
              </a:extLst>
            </p:cNvPr>
            <p:cNvSpPr/>
            <p:nvPr/>
          </p:nvSpPr>
          <p:spPr>
            <a:xfrm>
              <a:off x="10934710" y="1268593"/>
              <a:ext cx="1274522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7. Patient informed about results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073F53D3-8F60-A431-2819-8B14751BE13D}"/>
                </a:ext>
              </a:extLst>
            </p:cNvPr>
            <p:cNvCxnSpPr>
              <a:cxnSpLocks/>
            </p:cNvCxnSpPr>
            <p:nvPr/>
          </p:nvCxnSpPr>
          <p:spPr>
            <a:xfrm>
              <a:off x="1427188" y="1555127"/>
              <a:ext cx="4361062" cy="51312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651928C9-5A13-A252-0E00-1DA0862CA5D2}"/>
                </a:ext>
              </a:extLst>
            </p:cNvPr>
            <p:cNvCxnSpPr>
              <a:cxnSpLocks/>
            </p:cNvCxnSpPr>
            <p:nvPr/>
          </p:nvCxnSpPr>
          <p:spPr>
            <a:xfrm>
              <a:off x="7020711" y="1580783"/>
              <a:ext cx="3847257" cy="12270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7" name="Rectangle 76">
            <a:extLst>
              <a:ext uri="{FF2B5EF4-FFF2-40B4-BE49-F238E27FC236}">
                <a16:creationId xmlns:a16="http://schemas.microsoft.com/office/drawing/2014/main" id="{186AD8A9-F073-A0BD-B0C9-A4E58FD97A08}"/>
              </a:ext>
            </a:extLst>
          </p:cNvPr>
          <p:cNvSpPr/>
          <p:nvPr/>
        </p:nvSpPr>
        <p:spPr>
          <a:xfrm>
            <a:off x="1464371" y="1451357"/>
            <a:ext cx="1399017" cy="6066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Patient books clinical review appt (12-24  months)</a:t>
            </a:r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CEBCBF4B-A077-5126-F55E-90BE38406745}"/>
              </a:ext>
            </a:extLst>
          </p:cNvPr>
          <p:cNvCxnSpPr>
            <a:cxnSpLocks/>
          </p:cNvCxnSpPr>
          <p:nvPr/>
        </p:nvCxnSpPr>
        <p:spPr>
          <a:xfrm>
            <a:off x="7003479" y="2165075"/>
            <a:ext cx="3922856" cy="2090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Rectangle 78">
            <a:extLst>
              <a:ext uri="{FF2B5EF4-FFF2-40B4-BE49-F238E27FC236}">
                <a16:creationId xmlns:a16="http://schemas.microsoft.com/office/drawing/2014/main" id="{84921F5F-06E8-F4DE-F7C5-4C970A5DBBE3}"/>
              </a:ext>
            </a:extLst>
          </p:cNvPr>
          <p:cNvSpPr/>
          <p:nvPr/>
        </p:nvSpPr>
        <p:spPr>
          <a:xfrm>
            <a:off x="9921527" y="1510457"/>
            <a:ext cx="709004" cy="437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Return appt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08CC7D46-FAA8-19B9-3C97-C3895D221F11}"/>
              </a:ext>
            </a:extLst>
          </p:cNvPr>
          <p:cNvSpPr/>
          <p:nvPr/>
        </p:nvSpPr>
        <p:spPr>
          <a:xfrm>
            <a:off x="7755162" y="1465989"/>
            <a:ext cx="904886" cy="9749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5. Clinician + GC sent report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DE0D94CC-FDF6-0E84-7C10-6207437C97AD}"/>
              </a:ext>
            </a:extLst>
          </p:cNvPr>
          <p:cNvSpPr/>
          <p:nvPr/>
        </p:nvSpPr>
        <p:spPr>
          <a:xfrm>
            <a:off x="1477957" y="2096451"/>
            <a:ext cx="1385431" cy="61697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Patient books appointment </a:t>
            </a:r>
          </a:p>
          <a:p>
            <a:pPr algn="ctr"/>
            <a:r>
              <a:rPr lang="en-GB" sz="1000" dirty="0"/>
              <a:t>(reproductive planning)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C7FC1FE4-5F85-8317-72E7-E10D0C7D9B78}"/>
              </a:ext>
            </a:extLst>
          </p:cNvPr>
          <p:cNvSpPr/>
          <p:nvPr/>
        </p:nvSpPr>
        <p:spPr>
          <a:xfrm>
            <a:off x="7114511" y="1550951"/>
            <a:ext cx="578155" cy="31056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+ result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39936F7E-80D2-8FD6-742B-E2F583E50F0C}"/>
              </a:ext>
            </a:extLst>
          </p:cNvPr>
          <p:cNvSpPr/>
          <p:nvPr/>
        </p:nvSpPr>
        <p:spPr>
          <a:xfrm>
            <a:off x="7120284" y="2039501"/>
            <a:ext cx="588686" cy="29295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- result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8CDFE110-B0ED-3E7D-C22D-294ACDA8C210}"/>
              </a:ext>
            </a:extLst>
          </p:cNvPr>
          <p:cNvSpPr/>
          <p:nvPr/>
        </p:nvSpPr>
        <p:spPr>
          <a:xfrm>
            <a:off x="9919494" y="2062384"/>
            <a:ext cx="709005" cy="5366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hone or return appt</a:t>
            </a:r>
          </a:p>
        </p:txBody>
      </p:sp>
      <p:sp>
        <p:nvSpPr>
          <p:cNvPr id="95" name="Diamond 94">
            <a:extLst>
              <a:ext uri="{FF2B5EF4-FFF2-40B4-BE49-F238E27FC236}">
                <a16:creationId xmlns:a16="http://schemas.microsoft.com/office/drawing/2014/main" id="{E534EBF8-CFED-F7E5-FA23-30A7DC91E256}"/>
              </a:ext>
            </a:extLst>
          </p:cNvPr>
          <p:cNvSpPr/>
          <p:nvPr/>
        </p:nvSpPr>
        <p:spPr>
          <a:xfrm>
            <a:off x="2860767" y="1391654"/>
            <a:ext cx="1986830" cy="1260339"/>
          </a:xfrm>
          <a:prstGeom prst="diamond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Clinician decides if reanalysis is appropriate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96B33607-092F-5F01-5F64-2EB0434A768D}"/>
              </a:ext>
            </a:extLst>
          </p:cNvPr>
          <p:cNvSpPr/>
          <p:nvPr/>
        </p:nvSpPr>
        <p:spPr>
          <a:xfrm>
            <a:off x="8753146" y="1419675"/>
            <a:ext cx="904886" cy="102130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Manually entered in EMR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05029A8E-FF6A-935B-209F-A3E4F06705BA}"/>
              </a:ext>
            </a:extLst>
          </p:cNvPr>
          <p:cNvSpPr/>
          <p:nvPr/>
        </p:nvSpPr>
        <p:spPr>
          <a:xfrm>
            <a:off x="4859939" y="1560417"/>
            <a:ext cx="1035049" cy="81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Patient reconsented in some circumstances</a:t>
            </a:r>
          </a:p>
        </p:txBody>
      </p:sp>
      <p:sp>
        <p:nvSpPr>
          <p:cNvPr id="105" name="Rectangle: Rounded Corners 104">
            <a:extLst>
              <a:ext uri="{FF2B5EF4-FFF2-40B4-BE49-F238E27FC236}">
                <a16:creationId xmlns:a16="http://schemas.microsoft.com/office/drawing/2014/main" id="{62F269A6-1664-4207-4EA1-F57EF20B144E}"/>
              </a:ext>
            </a:extLst>
          </p:cNvPr>
          <p:cNvSpPr/>
          <p:nvPr/>
        </p:nvSpPr>
        <p:spPr>
          <a:xfrm>
            <a:off x="4161881" y="4638116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trust</a:t>
            </a:r>
          </a:p>
        </p:txBody>
      </p:sp>
      <p:cxnSp>
        <p:nvCxnSpPr>
          <p:cNvPr id="106" name="Connector: Elbow 105">
            <a:extLst>
              <a:ext uri="{FF2B5EF4-FFF2-40B4-BE49-F238E27FC236}">
                <a16:creationId xmlns:a16="http://schemas.microsoft.com/office/drawing/2014/main" id="{C588E42C-B676-53D4-775A-55F2D8DD5F59}"/>
              </a:ext>
            </a:extLst>
          </p:cNvPr>
          <p:cNvCxnSpPr>
            <a:cxnSpLocks/>
            <a:stCxn id="105" idx="1"/>
          </p:cNvCxnSpPr>
          <p:nvPr/>
        </p:nvCxnSpPr>
        <p:spPr>
          <a:xfrm rot="10800000" flipV="1">
            <a:off x="4109027" y="4937152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: Rounded Corners 106">
            <a:extLst>
              <a:ext uri="{FF2B5EF4-FFF2-40B4-BE49-F238E27FC236}">
                <a16:creationId xmlns:a16="http://schemas.microsoft.com/office/drawing/2014/main" id="{34A35EB0-BCD5-F076-E97F-782AEE6DF35C}"/>
              </a:ext>
            </a:extLst>
          </p:cNvPr>
          <p:cNvSpPr/>
          <p:nvPr/>
        </p:nvSpPr>
        <p:spPr>
          <a:xfrm>
            <a:off x="315464" y="4821909"/>
            <a:ext cx="1138220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known consent processes (age of transition)</a:t>
            </a:r>
          </a:p>
        </p:txBody>
      </p:sp>
      <p:cxnSp>
        <p:nvCxnSpPr>
          <p:cNvPr id="108" name="Connector: Elbow 107">
            <a:extLst>
              <a:ext uri="{FF2B5EF4-FFF2-40B4-BE49-F238E27FC236}">
                <a16:creationId xmlns:a16="http://schemas.microsoft.com/office/drawing/2014/main" id="{EA82410B-CF1F-3A65-C51C-7649D297C0AD}"/>
              </a:ext>
            </a:extLst>
          </p:cNvPr>
          <p:cNvCxnSpPr>
            <a:cxnSpLocks/>
            <a:stCxn id="107" idx="1"/>
          </p:cNvCxnSpPr>
          <p:nvPr/>
        </p:nvCxnSpPr>
        <p:spPr>
          <a:xfrm rot="10800000" flipV="1">
            <a:off x="262610" y="5120945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AE19A0F-F2EB-FF4E-2C67-9DA477D74587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11367578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35409" y="3417602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B619EC-092C-2906-FF5C-12C3B4E6884C}"/>
              </a:ext>
            </a:extLst>
          </p:cNvPr>
          <p:cNvSpPr txBox="1"/>
          <p:nvPr/>
        </p:nvSpPr>
        <p:spPr>
          <a:xfrm>
            <a:off x="11236035" y="161272"/>
            <a:ext cx="841860" cy="37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C17</a:t>
            </a:r>
            <a:endParaRPr lang="en-AU" dirty="0"/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7C272F2E-08C5-0A8E-A04A-52458996888B}"/>
              </a:ext>
            </a:extLst>
          </p:cNvPr>
          <p:cNvCxnSpPr>
            <a:cxnSpLocks/>
          </p:cNvCxnSpPr>
          <p:nvPr/>
        </p:nvCxnSpPr>
        <p:spPr>
          <a:xfrm flipV="1">
            <a:off x="1619748" y="1861351"/>
            <a:ext cx="4762158" cy="2713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6" name="Group 5">
            <a:extLst>
              <a:ext uri="{FF2B5EF4-FFF2-40B4-BE49-F238E27FC236}">
                <a16:creationId xmlns:a16="http://schemas.microsoft.com/office/drawing/2014/main" id="{2CDF5E47-7F44-1B88-0AAB-F299A4CFAF1F}"/>
              </a:ext>
            </a:extLst>
          </p:cNvPr>
          <p:cNvGrpSpPr/>
          <p:nvPr/>
        </p:nvGrpSpPr>
        <p:grpSpPr>
          <a:xfrm>
            <a:off x="315464" y="1106348"/>
            <a:ext cx="11079475" cy="1779612"/>
            <a:chOff x="122904" y="1265376"/>
            <a:chExt cx="11079475" cy="1779612"/>
          </a:xfrm>
          <a:solidFill>
            <a:schemeClr val="bg1"/>
          </a:solidFill>
        </p:grpSpPr>
        <p:sp>
          <p:nvSpPr>
            <p:cNvPr id="7" name="Flowchart: Terminator 6">
              <a:extLst>
                <a:ext uri="{FF2B5EF4-FFF2-40B4-BE49-F238E27FC236}">
                  <a16:creationId xmlns:a16="http://schemas.microsoft.com/office/drawing/2014/main" id="{F99845A1-AA8A-67B1-AB80-FEE944AA116E}"/>
                </a:ext>
              </a:extLst>
            </p:cNvPr>
            <p:cNvSpPr/>
            <p:nvPr/>
          </p:nvSpPr>
          <p:spPr>
            <a:xfrm>
              <a:off x="122904" y="1265376"/>
              <a:ext cx="1274652" cy="1763543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5A8315F-15BC-5E1A-46A7-91DA12866FA3}"/>
                </a:ext>
              </a:extLst>
            </p:cNvPr>
            <p:cNvSpPr/>
            <p:nvPr/>
          </p:nvSpPr>
          <p:spPr>
            <a:xfrm>
              <a:off x="6209933" y="1284662"/>
              <a:ext cx="1056892" cy="1760326"/>
            </a:xfrm>
            <a:prstGeom prst="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4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  <p:sp>
          <p:nvSpPr>
            <p:cNvPr id="9" name="Flowchart: Terminator 8">
              <a:extLst>
                <a:ext uri="{FF2B5EF4-FFF2-40B4-BE49-F238E27FC236}">
                  <a16:creationId xmlns:a16="http://schemas.microsoft.com/office/drawing/2014/main" id="{18169D38-CAE0-7E14-6D23-09A2B9EEFE32}"/>
                </a:ext>
              </a:extLst>
            </p:cNvPr>
            <p:cNvSpPr/>
            <p:nvPr/>
          </p:nvSpPr>
          <p:spPr>
            <a:xfrm>
              <a:off x="9212274" y="1662188"/>
              <a:ext cx="1990105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6. Patient informed about results</a:t>
              </a: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13696B89-A338-A1BB-295E-B8CF8D209018}"/>
                </a:ext>
              </a:extLst>
            </p:cNvPr>
            <p:cNvCxnSpPr>
              <a:cxnSpLocks/>
            </p:cNvCxnSpPr>
            <p:nvPr/>
          </p:nvCxnSpPr>
          <p:spPr>
            <a:xfrm>
              <a:off x="1427188" y="1555127"/>
              <a:ext cx="4762158" cy="26288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71E99E7B-3330-CF6D-F8B5-041F45A338BA}"/>
              </a:ext>
            </a:extLst>
          </p:cNvPr>
          <p:cNvSpPr/>
          <p:nvPr/>
        </p:nvSpPr>
        <p:spPr>
          <a:xfrm>
            <a:off x="1724679" y="1226807"/>
            <a:ext cx="1648327" cy="39116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Patient or family member referred back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61FD687-CACC-8936-0732-C428AD4A8729}"/>
              </a:ext>
            </a:extLst>
          </p:cNvPr>
          <p:cNvSpPr/>
          <p:nvPr/>
        </p:nvSpPr>
        <p:spPr>
          <a:xfrm>
            <a:off x="1724678" y="1707341"/>
            <a:ext cx="1648327" cy="4632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Referral from another specialist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AD7CA98E-EB9C-511C-9C56-461979BB3046}"/>
              </a:ext>
            </a:extLst>
          </p:cNvPr>
          <p:cNvCxnSpPr>
            <a:cxnSpLocks/>
            <a:endCxn id="9" idx="1"/>
          </p:cNvCxnSpPr>
          <p:nvPr/>
        </p:nvCxnSpPr>
        <p:spPr>
          <a:xfrm flipV="1">
            <a:off x="7479972" y="1987176"/>
            <a:ext cx="1924862" cy="1862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3233863-0904-D431-6DDC-A63B7CC67C8B}"/>
              </a:ext>
            </a:extLst>
          </p:cNvPr>
          <p:cNvCxnSpPr>
            <a:cxnSpLocks/>
          </p:cNvCxnSpPr>
          <p:nvPr/>
        </p:nvCxnSpPr>
        <p:spPr>
          <a:xfrm>
            <a:off x="1609427" y="2562099"/>
            <a:ext cx="4762158" cy="556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Rectangle 14">
            <a:extLst>
              <a:ext uri="{FF2B5EF4-FFF2-40B4-BE49-F238E27FC236}">
                <a16:creationId xmlns:a16="http://schemas.microsoft.com/office/drawing/2014/main" id="{4856D25D-04CC-D049-3DC4-536D0B87864A}"/>
              </a:ext>
            </a:extLst>
          </p:cNvPr>
          <p:cNvSpPr/>
          <p:nvPr/>
        </p:nvSpPr>
        <p:spPr>
          <a:xfrm>
            <a:off x="1724678" y="2268314"/>
            <a:ext cx="1648327" cy="4632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Data used in a research project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B3F2E45-2D91-C77A-CEA9-54BF4C62D106}"/>
              </a:ext>
            </a:extLst>
          </p:cNvPr>
          <p:cNvSpPr/>
          <p:nvPr/>
        </p:nvSpPr>
        <p:spPr>
          <a:xfrm>
            <a:off x="7683656" y="1617967"/>
            <a:ext cx="1430317" cy="82397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5. Clinical team informed about result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3757EEA-1E3F-D4DE-6EBE-D9E36B7D6AE8}"/>
              </a:ext>
            </a:extLst>
          </p:cNvPr>
          <p:cNvSpPr/>
          <p:nvPr/>
        </p:nvSpPr>
        <p:spPr>
          <a:xfrm>
            <a:off x="3483648" y="2324981"/>
            <a:ext cx="1648327" cy="4632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Consented at primary test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6A9675B-7BB7-AC4A-0EF5-28522170FE6C}"/>
              </a:ext>
            </a:extLst>
          </p:cNvPr>
          <p:cNvSpPr/>
          <p:nvPr/>
        </p:nvSpPr>
        <p:spPr>
          <a:xfrm>
            <a:off x="3536113" y="1164459"/>
            <a:ext cx="1213901" cy="9460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Re-consented</a:t>
            </a:r>
          </a:p>
        </p:txBody>
      </p:sp>
      <p:sp>
        <p:nvSpPr>
          <p:cNvPr id="46" name="Rectangle: Rounded Corners 45">
            <a:extLst>
              <a:ext uri="{FF2B5EF4-FFF2-40B4-BE49-F238E27FC236}">
                <a16:creationId xmlns:a16="http://schemas.microsoft.com/office/drawing/2014/main" id="{D478C971-7B24-B8D0-5820-F2414027CC70}"/>
              </a:ext>
            </a:extLst>
          </p:cNvPr>
          <p:cNvSpPr/>
          <p:nvPr/>
        </p:nvSpPr>
        <p:spPr>
          <a:xfrm>
            <a:off x="10632437" y="4641651"/>
            <a:ext cx="840769" cy="60279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able to contact patient</a:t>
            </a:r>
          </a:p>
        </p:txBody>
      </p:sp>
      <p:cxnSp>
        <p:nvCxnSpPr>
          <p:cNvPr id="52" name="Connector: Elbow 51">
            <a:extLst>
              <a:ext uri="{FF2B5EF4-FFF2-40B4-BE49-F238E27FC236}">
                <a16:creationId xmlns:a16="http://schemas.microsoft.com/office/drawing/2014/main" id="{C0D6E7E9-B12F-22FB-0B0B-3293A01A5962}"/>
              </a:ext>
            </a:extLst>
          </p:cNvPr>
          <p:cNvCxnSpPr>
            <a:cxnSpLocks/>
            <a:stCxn id="46" idx="1"/>
          </p:cNvCxnSpPr>
          <p:nvPr/>
        </p:nvCxnSpPr>
        <p:spPr>
          <a:xfrm rot="10800000" flipV="1">
            <a:off x="10579583" y="4943047"/>
            <a:ext cx="52854" cy="51750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: Rounded Corners 52">
            <a:extLst>
              <a:ext uri="{FF2B5EF4-FFF2-40B4-BE49-F238E27FC236}">
                <a16:creationId xmlns:a16="http://schemas.microsoft.com/office/drawing/2014/main" id="{E1258E7B-BCEF-5992-5166-B68B5D3C847D}"/>
              </a:ext>
            </a:extLst>
          </p:cNvPr>
          <p:cNvSpPr/>
          <p:nvPr/>
        </p:nvSpPr>
        <p:spPr>
          <a:xfrm>
            <a:off x="315464" y="4736160"/>
            <a:ext cx="1007758" cy="528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Funded reanalysis program </a:t>
            </a:r>
          </a:p>
        </p:txBody>
      </p:sp>
      <p:cxnSp>
        <p:nvCxnSpPr>
          <p:cNvPr id="54" name="Connector: Elbow 53">
            <a:extLst>
              <a:ext uri="{FF2B5EF4-FFF2-40B4-BE49-F238E27FC236}">
                <a16:creationId xmlns:a16="http://schemas.microsoft.com/office/drawing/2014/main" id="{9EE7C146-E73C-8CF3-3218-F761007744DC}"/>
              </a:ext>
            </a:extLst>
          </p:cNvPr>
          <p:cNvCxnSpPr>
            <a:cxnSpLocks/>
            <a:stCxn id="53" idx="1"/>
          </p:cNvCxnSpPr>
          <p:nvPr/>
        </p:nvCxnSpPr>
        <p:spPr>
          <a:xfrm rot="10800000" flipV="1">
            <a:off x="270294" y="5000578"/>
            <a:ext cx="45171" cy="52359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: Rounded Corners 54">
            <a:extLst>
              <a:ext uri="{FF2B5EF4-FFF2-40B4-BE49-F238E27FC236}">
                <a16:creationId xmlns:a16="http://schemas.microsoft.com/office/drawing/2014/main" id="{F9EEE222-83D3-0A3C-7B8D-0FAD2E9464BC}"/>
              </a:ext>
            </a:extLst>
          </p:cNvPr>
          <p:cNvSpPr/>
          <p:nvPr/>
        </p:nvSpPr>
        <p:spPr>
          <a:xfrm>
            <a:off x="7941111" y="4641651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al team capacity</a:t>
            </a:r>
          </a:p>
        </p:txBody>
      </p:sp>
      <p:cxnSp>
        <p:nvCxnSpPr>
          <p:cNvPr id="56" name="Connector: Elbow 55">
            <a:extLst>
              <a:ext uri="{FF2B5EF4-FFF2-40B4-BE49-F238E27FC236}">
                <a16:creationId xmlns:a16="http://schemas.microsoft.com/office/drawing/2014/main" id="{7596F0F8-2336-3B81-F0C0-21957D3B7541}"/>
              </a:ext>
            </a:extLst>
          </p:cNvPr>
          <p:cNvCxnSpPr>
            <a:cxnSpLocks/>
            <a:stCxn id="55" idx="1"/>
          </p:cNvCxnSpPr>
          <p:nvPr/>
        </p:nvCxnSpPr>
        <p:spPr>
          <a:xfrm rot="10800000" flipV="1">
            <a:off x="7888257" y="4940687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angle 58">
            <a:extLst>
              <a:ext uri="{FF2B5EF4-FFF2-40B4-BE49-F238E27FC236}">
                <a16:creationId xmlns:a16="http://schemas.microsoft.com/office/drawing/2014/main" id="{F84153E9-BAB2-FFC1-7B03-7B5CBB09B0E4}"/>
              </a:ext>
            </a:extLst>
          </p:cNvPr>
          <p:cNvSpPr/>
          <p:nvPr/>
        </p:nvSpPr>
        <p:spPr>
          <a:xfrm>
            <a:off x="4995829" y="1238304"/>
            <a:ext cx="1182393" cy="92882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Hospital funded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50548678-89A6-D66B-61AB-625F2744EB69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81258927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DFE77387-6700-6DE9-1BD4-6C4C8A01AB29}"/>
              </a:ext>
            </a:extLst>
          </p:cNvPr>
          <p:cNvCxnSpPr>
            <a:cxnSpLocks/>
            <a:stCxn id="42" idx="3"/>
            <a:endCxn id="43" idx="1"/>
          </p:cNvCxnSpPr>
          <p:nvPr/>
        </p:nvCxnSpPr>
        <p:spPr>
          <a:xfrm>
            <a:off x="7531024" y="2436920"/>
            <a:ext cx="2212239" cy="1796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212810" y="3397137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107" name="Rectangle: Rounded Corners 106">
            <a:extLst>
              <a:ext uri="{FF2B5EF4-FFF2-40B4-BE49-F238E27FC236}">
                <a16:creationId xmlns:a16="http://schemas.microsoft.com/office/drawing/2014/main" id="{34A35EB0-BCD5-F076-E97F-782AEE6DF35C}"/>
              </a:ext>
            </a:extLst>
          </p:cNvPr>
          <p:cNvSpPr/>
          <p:nvPr/>
        </p:nvSpPr>
        <p:spPr>
          <a:xfrm>
            <a:off x="315464" y="4821909"/>
            <a:ext cx="1138220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Non genetics specialists consenting patients</a:t>
            </a:r>
          </a:p>
        </p:txBody>
      </p:sp>
      <p:cxnSp>
        <p:nvCxnSpPr>
          <p:cNvPr id="108" name="Connector: Elbow 107">
            <a:extLst>
              <a:ext uri="{FF2B5EF4-FFF2-40B4-BE49-F238E27FC236}">
                <a16:creationId xmlns:a16="http://schemas.microsoft.com/office/drawing/2014/main" id="{EA82410B-CF1F-3A65-C51C-7649D297C0AD}"/>
              </a:ext>
            </a:extLst>
          </p:cNvPr>
          <p:cNvCxnSpPr>
            <a:cxnSpLocks/>
            <a:stCxn id="107" idx="1"/>
          </p:cNvCxnSpPr>
          <p:nvPr/>
        </p:nvCxnSpPr>
        <p:spPr>
          <a:xfrm rot="10800000" flipV="1">
            <a:off x="262610" y="5120945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3790CE3-A118-3F81-8546-28EDA8ACFE49}"/>
              </a:ext>
            </a:extLst>
          </p:cNvPr>
          <p:cNvSpPr txBox="1"/>
          <p:nvPr/>
        </p:nvSpPr>
        <p:spPr>
          <a:xfrm>
            <a:off x="11223141" y="169866"/>
            <a:ext cx="841860" cy="37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C18</a:t>
            </a:r>
            <a:endParaRPr lang="en-AU" dirty="0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45BA1972-21BA-AC77-A899-D60D2A15AE22}"/>
              </a:ext>
            </a:extLst>
          </p:cNvPr>
          <p:cNvCxnSpPr>
            <a:cxnSpLocks/>
          </p:cNvCxnSpPr>
          <p:nvPr/>
        </p:nvCxnSpPr>
        <p:spPr>
          <a:xfrm>
            <a:off x="1453684" y="2288291"/>
            <a:ext cx="504560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9" name="Group 38">
            <a:extLst>
              <a:ext uri="{FF2B5EF4-FFF2-40B4-BE49-F238E27FC236}">
                <a16:creationId xmlns:a16="http://schemas.microsoft.com/office/drawing/2014/main" id="{17819AC2-7C01-8569-703A-9A08CE6FFAE2}"/>
              </a:ext>
            </a:extLst>
          </p:cNvPr>
          <p:cNvGrpSpPr/>
          <p:nvPr/>
        </p:nvGrpSpPr>
        <p:grpSpPr>
          <a:xfrm>
            <a:off x="149400" y="1506158"/>
            <a:ext cx="11583968" cy="1812533"/>
            <a:chOff x="122904" y="1265376"/>
            <a:chExt cx="11583968" cy="1812533"/>
          </a:xfrm>
          <a:solidFill>
            <a:schemeClr val="bg1"/>
          </a:solidFill>
        </p:grpSpPr>
        <p:sp>
          <p:nvSpPr>
            <p:cNvPr id="41" name="Flowchart: Terminator 40">
              <a:extLst>
                <a:ext uri="{FF2B5EF4-FFF2-40B4-BE49-F238E27FC236}">
                  <a16:creationId xmlns:a16="http://schemas.microsoft.com/office/drawing/2014/main" id="{E2421EBC-D7F5-BF4F-1997-2A561EAC6873}"/>
                </a:ext>
              </a:extLst>
            </p:cNvPr>
            <p:cNvSpPr/>
            <p:nvPr/>
          </p:nvSpPr>
          <p:spPr>
            <a:xfrm>
              <a:off x="122904" y="1265376"/>
              <a:ext cx="1274652" cy="1763543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43" name="Flowchart: Terminator 42">
              <a:extLst>
                <a:ext uri="{FF2B5EF4-FFF2-40B4-BE49-F238E27FC236}">
                  <a16:creationId xmlns:a16="http://schemas.microsoft.com/office/drawing/2014/main" id="{BAD220D0-C704-08CC-4C85-85D5FB480769}"/>
                </a:ext>
              </a:extLst>
            </p:cNvPr>
            <p:cNvSpPr/>
            <p:nvPr/>
          </p:nvSpPr>
          <p:spPr>
            <a:xfrm>
              <a:off x="9716767" y="1740694"/>
              <a:ext cx="1990105" cy="946813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6. Patient informed about results</a:t>
              </a:r>
            </a:p>
          </p:txBody>
        </p:sp>
        <p:sp>
          <p:nvSpPr>
            <p:cNvPr id="42" name="Rectangle: Rounded Corners 41">
              <a:extLst>
                <a:ext uri="{FF2B5EF4-FFF2-40B4-BE49-F238E27FC236}">
                  <a16:creationId xmlns:a16="http://schemas.microsoft.com/office/drawing/2014/main" id="{E503CA8F-4A49-5417-2CFA-18F5FD9FF29A}"/>
                </a:ext>
              </a:extLst>
            </p:cNvPr>
            <p:cNvSpPr/>
            <p:nvPr/>
          </p:nvSpPr>
          <p:spPr>
            <a:xfrm>
              <a:off x="6500490" y="1314366"/>
              <a:ext cx="1004038" cy="1763543"/>
            </a:xfrm>
            <a:prstGeom prst="roundRect">
              <a:avLst/>
            </a:prstGeom>
            <a:solidFill>
              <a:schemeClr val="bg1"/>
            </a:solidFill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4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</p:grpSp>
      <p:sp>
        <p:nvSpPr>
          <p:cNvPr id="44" name="Rectangle 43">
            <a:extLst>
              <a:ext uri="{FF2B5EF4-FFF2-40B4-BE49-F238E27FC236}">
                <a16:creationId xmlns:a16="http://schemas.microsoft.com/office/drawing/2014/main" id="{DFD6A827-7FC3-CF2B-9E88-D2CC61C78A4C}"/>
              </a:ext>
            </a:extLst>
          </p:cNvPr>
          <p:cNvSpPr/>
          <p:nvPr/>
        </p:nvSpPr>
        <p:spPr>
          <a:xfrm>
            <a:off x="1558614" y="2107151"/>
            <a:ext cx="1648327" cy="4632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Referral from another specialist 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15B9E496-07BF-4004-EBBE-C26BCA889F68}"/>
              </a:ext>
            </a:extLst>
          </p:cNvPr>
          <p:cNvCxnSpPr>
            <a:cxnSpLocks/>
          </p:cNvCxnSpPr>
          <p:nvPr/>
        </p:nvCxnSpPr>
        <p:spPr>
          <a:xfrm>
            <a:off x="1415663" y="2962440"/>
            <a:ext cx="508362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Rectangle 51">
            <a:extLst>
              <a:ext uri="{FF2B5EF4-FFF2-40B4-BE49-F238E27FC236}">
                <a16:creationId xmlns:a16="http://schemas.microsoft.com/office/drawing/2014/main" id="{9C474036-8D31-601C-B82D-37E98ED2B76A}"/>
              </a:ext>
            </a:extLst>
          </p:cNvPr>
          <p:cNvSpPr/>
          <p:nvPr/>
        </p:nvSpPr>
        <p:spPr>
          <a:xfrm>
            <a:off x="1558614" y="2668124"/>
            <a:ext cx="1648327" cy="4632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Research project trigger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785AA8A-191B-26DE-F774-A014D1135DF0}"/>
              </a:ext>
            </a:extLst>
          </p:cNvPr>
          <p:cNvSpPr/>
          <p:nvPr/>
        </p:nvSpPr>
        <p:spPr>
          <a:xfrm>
            <a:off x="8015075" y="2024935"/>
            <a:ext cx="1430317" cy="82397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5. Clinical team informed about result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3D01836D-3910-F323-070F-570BDCD30301}"/>
              </a:ext>
            </a:extLst>
          </p:cNvPr>
          <p:cNvSpPr/>
          <p:nvPr/>
        </p:nvSpPr>
        <p:spPr>
          <a:xfrm>
            <a:off x="3317584" y="2724791"/>
            <a:ext cx="1648327" cy="4632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Consented at primary test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236C8B92-D50C-5216-4323-96AC799B5851}"/>
              </a:ext>
            </a:extLst>
          </p:cNvPr>
          <p:cNvSpPr/>
          <p:nvPr/>
        </p:nvSpPr>
        <p:spPr>
          <a:xfrm>
            <a:off x="3370049" y="2130437"/>
            <a:ext cx="1648327" cy="3798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Re-consented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F04BEA7-9EBC-E8DC-F2EF-AC42F1CDC9FC}"/>
              </a:ext>
            </a:extLst>
          </p:cNvPr>
          <p:cNvSpPr/>
          <p:nvPr/>
        </p:nvSpPr>
        <p:spPr>
          <a:xfrm>
            <a:off x="5181484" y="2098375"/>
            <a:ext cx="1182393" cy="35650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Hospital funded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07902F67-A88C-1BEA-009E-5EEB59CF0E81}"/>
              </a:ext>
            </a:extLst>
          </p:cNvPr>
          <p:cNvSpPr/>
          <p:nvPr/>
        </p:nvSpPr>
        <p:spPr>
          <a:xfrm>
            <a:off x="2839040" y="4587686"/>
            <a:ext cx="1052485" cy="78692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pdated phenotype or  family history information (cancer)</a:t>
            </a:r>
          </a:p>
        </p:txBody>
      </p:sp>
      <p:cxnSp>
        <p:nvCxnSpPr>
          <p:cNvPr id="12" name="Connector: Elbow 11">
            <a:extLst>
              <a:ext uri="{FF2B5EF4-FFF2-40B4-BE49-F238E27FC236}">
                <a16:creationId xmlns:a16="http://schemas.microsoft.com/office/drawing/2014/main" id="{2F82EC8E-B8F0-392F-C1C5-4C00286201D6}"/>
              </a:ext>
            </a:extLst>
          </p:cNvPr>
          <p:cNvCxnSpPr>
            <a:cxnSpLocks/>
            <a:stCxn id="11" idx="1"/>
          </p:cNvCxnSpPr>
          <p:nvPr/>
        </p:nvCxnSpPr>
        <p:spPr>
          <a:xfrm rot="10800000" flipV="1">
            <a:off x="2786194" y="4981148"/>
            <a:ext cx="52847" cy="420715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D1FA5E56-571F-41AC-0D48-9BC5527919FC}"/>
              </a:ext>
            </a:extLst>
          </p:cNvPr>
          <p:cNvSpPr/>
          <p:nvPr/>
        </p:nvSpPr>
        <p:spPr>
          <a:xfrm>
            <a:off x="326557" y="4182129"/>
            <a:ext cx="1138220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known consent processes (age of transition)</a:t>
            </a:r>
          </a:p>
        </p:txBody>
      </p:sp>
      <p:cxnSp>
        <p:nvCxnSpPr>
          <p:cNvPr id="56" name="Connector: Elbow 55">
            <a:extLst>
              <a:ext uri="{FF2B5EF4-FFF2-40B4-BE49-F238E27FC236}">
                <a16:creationId xmlns:a16="http://schemas.microsoft.com/office/drawing/2014/main" id="{F4E7E2D4-6B23-C552-6073-1BFF4EC6CC42}"/>
              </a:ext>
            </a:extLst>
          </p:cNvPr>
          <p:cNvCxnSpPr>
            <a:cxnSpLocks/>
            <a:stCxn id="21" idx="1"/>
          </p:cNvCxnSpPr>
          <p:nvPr/>
        </p:nvCxnSpPr>
        <p:spPr>
          <a:xfrm rot="10800000" flipV="1">
            <a:off x="273703" y="4481165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88E46D1F-712F-F1C9-9BF5-216D07B21542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30464063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E934AE88-2B87-6A11-87FC-DF9195710127}"/>
              </a:ext>
            </a:extLst>
          </p:cNvPr>
          <p:cNvCxnSpPr>
            <a:cxnSpLocks/>
          </p:cNvCxnSpPr>
          <p:nvPr/>
        </p:nvCxnSpPr>
        <p:spPr>
          <a:xfrm flipV="1">
            <a:off x="1392995" y="1854291"/>
            <a:ext cx="8935404" cy="2963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54DA8C87-108B-B32C-E3F1-8E2EE78FB3AB}"/>
              </a:ext>
            </a:extLst>
          </p:cNvPr>
          <p:cNvCxnSpPr>
            <a:cxnSpLocks/>
          </p:cNvCxnSpPr>
          <p:nvPr/>
        </p:nvCxnSpPr>
        <p:spPr>
          <a:xfrm flipV="1">
            <a:off x="1392995" y="1470165"/>
            <a:ext cx="8935404" cy="2963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6" name="Group 5">
            <a:extLst>
              <a:ext uri="{FF2B5EF4-FFF2-40B4-BE49-F238E27FC236}">
                <a16:creationId xmlns:a16="http://schemas.microsoft.com/office/drawing/2014/main" id="{7EFAF08F-1D8B-B885-1B44-206B86BC82C0}"/>
              </a:ext>
            </a:extLst>
          </p:cNvPr>
          <p:cNvGrpSpPr/>
          <p:nvPr/>
        </p:nvGrpSpPr>
        <p:grpSpPr>
          <a:xfrm>
            <a:off x="114105" y="1162836"/>
            <a:ext cx="11668367" cy="1074179"/>
            <a:chOff x="-389561" y="1445368"/>
            <a:chExt cx="11668367" cy="1074179"/>
          </a:xfrm>
        </p:grpSpPr>
        <p:sp>
          <p:nvSpPr>
            <p:cNvPr id="7" name="Flowchart: Terminator 6">
              <a:extLst>
                <a:ext uri="{FF2B5EF4-FFF2-40B4-BE49-F238E27FC236}">
                  <a16:creationId xmlns:a16="http://schemas.microsoft.com/office/drawing/2014/main" id="{F9C531B3-EDE7-EE52-00A7-F0B5D45F5DF4}"/>
                </a:ext>
              </a:extLst>
            </p:cNvPr>
            <p:cNvSpPr/>
            <p:nvPr/>
          </p:nvSpPr>
          <p:spPr>
            <a:xfrm>
              <a:off x="-389561" y="1540382"/>
              <a:ext cx="1260227" cy="979165"/>
            </a:xfrm>
            <a:prstGeom prst="flowChartTerminator">
              <a:avLst/>
            </a:prstGeom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AABBD42-1E2F-2791-9DEB-956560F64857}"/>
                </a:ext>
              </a:extLst>
            </p:cNvPr>
            <p:cNvSpPr/>
            <p:nvPr/>
          </p:nvSpPr>
          <p:spPr>
            <a:xfrm>
              <a:off x="7004247" y="1445368"/>
              <a:ext cx="1127294" cy="968032"/>
            </a:xfrm>
            <a:prstGeom prst="rect">
              <a:avLst/>
            </a:prstGeom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4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  <p:sp>
          <p:nvSpPr>
            <p:cNvPr id="9" name="Flowchart: Terminator 8">
              <a:extLst>
                <a:ext uri="{FF2B5EF4-FFF2-40B4-BE49-F238E27FC236}">
                  <a16:creationId xmlns:a16="http://schemas.microsoft.com/office/drawing/2014/main" id="{6E139A01-D18A-0099-EFA8-312CBF82BBEC}"/>
                </a:ext>
              </a:extLst>
            </p:cNvPr>
            <p:cNvSpPr/>
            <p:nvPr/>
          </p:nvSpPr>
          <p:spPr>
            <a:xfrm>
              <a:off x="9783561" y="1486088"/>
              <a:ext cx="1495245" cy="851605"/>
            </a:xfrm>
            <a:prstGeom prst="flowChartTerminator">
              <a:avLst/>
            </a:prstGeom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6. Patient informed about results</a:t>
              </a:r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6C5F0F82-A3A9-72F3-13B9-117EFCEB2996}"/>
              </a:ext>
            </a:extLst>
          </p:cNvPr>
          <p:cNvSpPr/>
          <p:nvPr/>
        </p:nvSpPr>
        <p:spPr>
          <a:xfrm>
            <a:off x="5729555" y="1155208"/>
            <a:ext cx="1590577" cy="1064725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3. Patient consent. Original consent or reconsented if new phenotypes included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5753BC3-E8A5-B445-7FD6-C0111AFDD764}"/>
              </a:ext>
            </a:extLst>
          </p:cNvPr>
          <p:cNvSpPr/>
          <p:nvPr/>
        </p:nvSpPr>
        <p:spPr>
          <a:xfrm>
            <a:off x="8836739" y="1343780"/>
            <a:ext cx="1141531" cy="64891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5. Send clinic amended +/- report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0EFC69B-AE88-3935-ECFC-EDF4F90F5910}"/>
              </a:ext>
            </a:extLst>
          </p:cNvPr>
          <p:cNvSpPr/>
          <p:nvPr/>
        </p:nvSpPr>
        <p:spPr>
          <a:xfrm>
            <a:off x="1636286" y="1222623"/>
            <a:ext cx="2213361" cy="4761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28600" indent="-228600" algn="ctr">
              <a:buAutoNum type="arabicPeriod"/>
            </a:pPr>
            <a:r>
              <a:rPr lang="en-GB" sz="1000" dirty="0"/>
              <a:t>Clinician initiated (new gene-disease association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56210C6-221D-27FE-367F-DAC66C5689D0}"/>
              </a:ext>
            </a:extLst>
          </p:cNvPr>
          <p:cNvSpPr txBox="1"/>
          <p:nvPr/>
        </p:nvSpPr>
        <p:spPr>
          <a:xfrm>
            <a:off x="11081055" y="141730"/>
            <a:ext cx="939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B02</a:t>
            </a:r>
            <a:endParaRPr lang="en-AU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1671C5E-1EA6-A84A-A055-45FA6A086A0D}"/>
              </a:ext>
            </a:extLst>
          </p:cNvPr>
          <p:cNvSpPr/>
          <p:nvPr/>
        </p:nvSpPr>
        <p:spPr>
          <a:xfrm>
            <a:off x="1648425" y="1747433"/>
            <a:ext cx="2201221" cy="70383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1. Lab initiated</a:t>
            </a:r>
            <a:br>
              <a:rPr lang="en-GB" sz="1000" dirty="0"/>
            </a:br>
            <a:r>
              <a:rPr lang="en-GB" sz="1000" dirty="0"/>
              <a:t>(new gene-disease association in discussion with clinical team)</a:t>
            </a:r>
          </a:p>
        </p:txBody>
      </p: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: Rounded Corners 31">
            <a:extLst>
              <a:ext uri="{FF2B5EF4-FFF2-40B4-BE49-F238E27FC236}">
                <a16:creationId xmlns:a16="http://schemas.microsoft.com/office/drawing/2014/main" id="{59D5215A-47FD-8563-074A-A19B954A0E35}"/>
              </a:ext>
            </a:extLst>
          </p:cNvPr>
          <p:cNvSpPr/>
          <p:nvPr/>
        </p:nvSpPr>
        <p:spPr>
          <a:xfrm>
            <a:off x="870453" y="4770745"/>
            <a:ext cx="1007758" cy="528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known consent process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cxnSp>
        <p:nvCxnSpPr>
          <p:cNvPr id="39" name="Connector: Elbow 38">
            <a:extLst>
              <a:ext uri="{FF2B5EF4-FFF2-40B4-BE49-F238E27FC236}">
                <a16:creationId xmlns:a16="http://schemas.microsoft.com/office/drawing/2014/main" id="{3B885C96-311B-417A-9037-465AA398B351}"/>
              </a:ext>
            </a:extLst>
          </p:cNvPr>
          <p:cNvCxnSpPr>
            <a:cxnSpLocks/>
            <a:stCxn id="32" idx="1"/>
          </p:cNvCxnSpPr>
          <p:nvPr/>
        </p:nvCxnSpPr>
        <p:spPr>
          <a:xfrm rot="10800000" flipV="1">
            <a:off x="758545" y="5035163"/>
            <a:ext cx="111909" cy="41159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45" name="Rectangle: Rounded Corners 44">
            <a:extLst>
              <a:ext uri="{FF2B5EF4-FFF2-40B4-BE49-F238E27FC236}">
                <a16:creationId xmlns:a16="http://schemas.microsoft.com/office/drawing/2014/main" id="{4032AC6B-ECA4-EA4D-932C-A969ADEE1147}"/>
              </a:ext>
            </a:extLst>
          </p:cNvPr>
          <p:cNvSpPr/>
          <p:nvPr/>
        </p:nvSpPr>
        <p:spPr>
          <a:xfrm>
            <a:off x="4174534" y="4671833"/>
            <a:ext cx="1007758" cy="56805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Develop a pipeline</a:t>
            </a:r>
          </a:p>
        </p:txBody>
      </p:sp>
      <p:cxnSp>
        <p:nvCxnSpPr>
          <p:cNvPr id="46" name="Connector: Elbow 45">
            <a:extLst>
              <a:ext uri="{FF2B5EF4-FFF2-40B4-BE49-F238E27FC236}">
                <a16:creationId xmlns:a16="http://schemas.microsoft.com/office/drawing/2014/main" id="{96B4CB53-F469-3903-7791-A5E55D85833D}"/>
              </a:ext>
            </a:extLst>
          </p:cNvPr>
          <p:cNvCxnSpPr>
            <a:cxnSpLocks/>
            <a:stCxn id="45" idx="1"/>
          </p:cNvCxnSpPr>
          <p:nvPr/>
        </p:nvCxnSpPr>
        <p:spPr>
          <a:xfrm rot="10800000" flipV="1">
            <a:off x="4121678" y="4955858"/>
            <a:ext cx="52857" cy="50013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50585CFC-FE58-235A-852E-A794450A68A1}"/>
              </a:ext>
            </a:extLst>
          </p:cNvPr>
          <p:cNvSpPr/>
          <p:nvPr/>
        </p:nvSpPr>
        <p:spPr>
          <a:xfrm>
            <a:off x="5809967" y="4620985"/>
            <a:ext cx="1086799" cy="648919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2046E07E-E348-669C-5EEA-44A9550ACAA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5757113" y="4945445"/>
            <a:ext cx="52854" cy="540572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14105" y="3105801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062C3EB9-06D7-9B57-6F9D-E32F3CCED60E}"/>
              </a:ext>
            </a:extLst>
          </p:cNvPr>
          <p:cNvSpPr/>
          <p:nvPr/>
        </p:nvSpPr>
        <p:spPr>
          <a:xfrm>
            <a:off x="3994312" y="1222623"/>
            <a:ext cx="1590577" cy="1064725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2. Funded by the lab, unless more genes are being analysed then clinic covers the difference 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70069418-A9AC-43D3-DE6D-C1A88B42BE3F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40758555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FB1737B9-CE6F-917A-EB3F-0322962077C8}"/>
              </a:ext>
            </a:extLst>
          </p:cNvPr>
          <p:cNvCxnSpPr>
            <a:cxnSpLocks/>
          </p:cNvCxnSpPr>
          <p:nvPr/>
        </p:nvCxnSpPr>
        <p:spPr>
          <a:xfrm flipV="1">
            <a:off x="1311409" y="2232046"/>
            <a:ext cx="9303388" cy="3085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27E0249D-C8B8-F72C-1AF4-4C1728FA2CFF}"/>
              </a:ext>
            </a:extLst>
          </p:cNvPr>
          <p:cNvCxnSpPr>
            <a:cxnSpLocks/>
          </p:cNvCxnSpPr>
          <p:nvPr/>
        </p:nvCxnSpPr>
        <p:spPr>
          <a:xfrm flipV="1">
            <a:off x="1311409" y="1464215"/>
            <a:ext cx="9372916" cy="3108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50585CFC-FE58-235A-852E-A794450A68A1}"/>
              </a:ext>
            </a:extLst>
          </p:cNvPr>
          <p:cNvSpPr/>
          <p:nvPr/>
        </p:nvSpPr>
        <p:spPr>
          <a:xfrm>
            <a:off x="5809967" y="4671833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 and skill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2046E07E-E348-669C-5EEA-44A9550ACAA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5757113" y="4970869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14105" y="3587383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9B7F40F-EA10-B4EA-CC62-258EA60E8414}"/>
              </a:ext>
            </a:extLst>
          </p:cNvPr>
          <p:cNvSpPr txBox="1"/>
          <p:nvPr/>
        </p:nvSpPr>
        <p:spPr>
          <a:xfrm>
            <a:off x="11202615" y="95163"/>
            <a:ext cx="8418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G03</a:t>
            </a:r>
            <a:endParaRPr lang="en-AU" dirty="0"/>
          </a:p>
        </p:txBody>
      </p:sp>
      <p:sp>
        <p:nvSpPr>
          <p:cNvPr id="71" name="Flowchart: Terminator 70">
            <a:extLst>
              <a:ext uri="{FF2B5EF4-FFF2-40B4-BE49-F238E27FC236}">
                <a16:creationId xmlns:a16="http://schemas.microsoft.com/office/drawing/2014/main" id="{DB5820FC-86A7-4520-EF8D-EFBA8101275F}"/>
              </a:ext>
            </a:extLst>
          </p:cNvPr>
          <p:cNvSpPr/>
          <p:nvPr/>
        </p:nvSpPr>
        <p:spPr>
          <a:xfrm>
            <a:off x="316046" y="1342565"/>
            <a:ext cx="982967" cy="1661013"/>
          </a:xfrm>
          <a:prstGeom prst="flowChartTerminator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Unsolved patient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AAA81C5D-A2C7-AC34-7054-9364635673DD}"/>
              </a:ext>
            </a:extLst>
          </p:cNvPr>
          <p:cNvSpPr/>
          <p:nvPr/>
        </p:nvSpPr>
        <p:spPr>
          <a:xfrm>
            <a:off x="1803509" y="2074469"/>
            <a:ext cx="1379650" cy="5725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 1. Patient enrolled in research project</a:t>
            </a: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648FC63B-5E81-5900-F38A-7326E186FB04}"/>
              </a:ext>
            </a:extLst>
          </p:cNvPr>
          <p:cNvGrpSpPr/>
          <p:nvPr/>
        </p:nvGrpSpPr>
        <p:grpSpPr>
          <a:xfrm>
            <a:off x="1593869" y="973916"/>
            <a:ext cx="1645606" cy="1029554"/>
            <a:chOff x="3459825" y="3063541"/>
            <a:chExt cx="1645606" cy="1029554"/>
          </a:xfrm>
        </p:grpSpPr>
        <p:sp>
          <p:nvSpPr>
            <p:cNvPr id="84" name="Diamond 83">
              <a:extLst>
                <a:ext uri="{FF2B5EF4-FFF2-40B4-BE49-F238E27FC236}">
                  <a16:creationId xmlns:a16="http://schemas.microsoft.com/office/drawing/2014/main" id="{01DAA996-8698-1DB0-231B-E80EDADCBA0E}"/>
                </a:ext>
              </a:extLst>
            </p:cNvPr>
            <p:cNvSpPr/>
            <p:nvPr/>
          </p:nvSpPr>
          <p:spPr>
            <a:xfrm>
              <a:off x="3459825" y="3063541"/>
              <a:ext cx="1645606" cy="1029554"/>
            </a:xfrm>
            <a:prstGeom prst="diamond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000" dirty="0"/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9A963B5-F5AF-733D-2E30-12031307775B}"/>
                </a:ext>
              </a:extLst>
            </p:cNvPr>
            <p:cNvSpPr txBox="1"/>
            <p:nvPr/>
          </p:nvSpPr>
          <p:spPr>
            <a:xfrm>
              <a:off x="3592803" y="3325811"/>
              <a:ext cx="1379650" cy="7078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GB" sz="1000" dirty="0"/>
                <a:t>1. Clinician decides if patient is appropriate to see in 2-3 years time</a:t>
              </a:r>
            </a:p>
          </p:txBody>
        </p:sp>
      </p:grpSp>
      <p:sp>
        <p:nvSpPr>
          <p:cNvPr id="67" name="Flowchart: Terminator 66">
            <a:extLst>
              <a:ext uri="{FF2B5EF4-FFF2-40B4-BE49-F238E27FC236}">
                <a16:creationId xmlns:a16="http://schemas.microsoft.com/office/drawing/2014/main" id="{1BFB34D9-1A7A-BACF-0DFA-B3F634D06A98}"/>
              </a:ext>
            </a:extLst>
          </p:cNvPr>
          <p:cNvSpPr/>
          <p:nvPr/>
        </p:nvSpPr>
        <p:spPr>
          <a:xfrm>
            <a:off x="10735157" y="1683219"/>
            <a:ext cx="1312329" cy="902808"/>
          </a:xfrm>
          <a:prstGeom prst="flowChartTerminator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Patient informed about results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BE57D3FB-1315-8F7B-DEEA-5E78EA4852A3}"/>
              </a:ext>
            </a:extLst>
          </p:cNvPr>
          <p:cNvSpPr/>
          <p:nvPr/>
        </p:nvSpPr>
        <p:spPr>
          <a:xfrm>
            <a:off x="7423773" y="1417070"/>
            <a:ext cx="900965" cy="7559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5.Clinician informed about result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4B857AEE-A9A6-E88C-5BA2-44A4D1712BBE}"/>
              </a:ext>
            </a:extLst>
          </p:cNvPr>
          <p:cNvSpPr/>
          <p:nvPr/>
        </p:nvSpPr>
        <p:spPr>
          <a:xfrm>
            <a:off x="3372453" y="1089465"/>
            <a:ext cx="926403" cy="70558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Patient seen at return appointment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C9E67F52-A5CA-6324-E03F-DE8BF0DA13C3}"/>
              </a:ext>
            </a:extLst>
          </p:cNvPr>
          <p:cNvSpPr/>
          <p:nvPr/>
        </p:nvSpPr>
        <p:spPr>
          <a:xfrm>
            <a:off x="4366563" y="1080373"/>
            <a:ext cx="909331" cy="70558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Reconsented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513BFA24-F9DB-B1C0-2013-8EDAC2C70879}"/>
              </a:ext>
            </a:extLst>
          </p:cNvPr>
          <p:cNvSpPr/>
          <p:nvPr/>
        </p:nvSpPr>
        <p:spPr>
          <a:xfrm>
            <a:off x="8389248" y="1417710"/>
            <a:ext cx="775698" cy="2713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+ result 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0AEA534D-B0FC-2934-7901-80630AF8F969}"/>
              </a:ext>
            </a:extLst>
          </p:cNvPr>
          <p:cNvSpPr/>
          <p:nvPr/>
        </p:nvSpPr>
        <p:spPr>
          <a:xfrm>
            <a:off x="8389248" y="1891513"/>
            <a:ext cx="775698" cy="2713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- result 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3B8AB73B-716D-4BCE-134B-0D42C89A8CE4}"/>
              </a:ext>
            </a:extLst>
          </p:cNvPr>
          <p:cNvSpPr/>
          <p:nvPr/>
        </p:nvSpPr>
        <p:spPr>
          <a:xfrm>
            <a:off x="9231968" y="2057793"/>
            <a:ext cx="1181139" cy="74686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Phone call with option to book another appointment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406B574B-C019-3D54-6F5C-11BBDA991B93}"/>
              </a:ext>
            </a:extLst>
          </p:cNvPr>
          <p:cNvSpPr/>
          <p:nvPr/>
        </p:nvSpPr>
        <p:spPr>
          <a:xfrm>
            <a:off x="9229456" y="1216694"/>
            <a:ext cx="1181139" cy="74686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Member of the clinical team organises return appointment 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6231F603-7655-8E9F-53C8-F5B6A8282CA0}"/>
              </a:ext>
            </a:extLst>
          </p:cNvPr>
          <p:cNvSpPr/>
          <p:nvPr/>
        </p:nvSpPr>
        <p:spPr>
          <a:xfrm>
            <a:off x="6402982" y="1080373"/>
            <a:ext cx="900965" cy="1512455"/>
          </a:xfrm>
          <a:prstGeom prst="rect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Reanalysis</a:t>
            </a:r>
            <a:endParaRPr lang="en-GB" sz="1000" b="1" dirty="0">
              <a:highlight>
                <a:srgbClr val="FFFF00"/>
              </a:highlight>
            </a:endParaRP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689377F2-5519-B0F3-7476-2A9F55B51D67}"/>
              </a:ext>
            </a:extLst>
          </p:cNvPr>
          <p:cNvSpPr/>
          <p:nvPr/>
        </p:nvSpPr>
        <p:spPr>
          <a:xfrm>
            <a:off x="5348959" y="1105167"/>
            <a:ext cx="994110" cy="7055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 Funding through hospital network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74369F53-EE0A-E5A3-6548-09B1248F4E25}"/>
              </a:ext>
            </a:extLst>
          </p:cNvPr>
          <p:cNvCxnSpPr>
            <a:cxnSpLocks/>
          </p:cNvCxnSpPr>
          <p:nvPr/>
        </p:nvCxnSpPr>
        <p:spPr>
          <a:xfrm flipV="1">
            <a:off x="1241881" y="2890143"/>
            <a:ext cx="9372916" cy="3108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Rectangle 88">
            <a:extLst>
              <a:ext uri="{FF2B5EF4-FFF2-40B4-BE49-F238E27FC236}">
                <a16:creationId xmlns:a16="http://schemas.microsoft.com/office/drawing/2014/main" id="{AA28F287-994A-AC4D-8B28-C37E2672CF8B}"/>
              </a:ext>
            </a:extLst>
          </p:cNvPr>
          <p:cNvSpPr/>
          <p:nvPr/>
        </p:nvSpPr>
        <p:spPr>
          <a:xfrm>
            <a:off x="1803509" y="2706861"/>
            <a:ext cx="1379650" cy="5725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dirty="0"/>
              <a:t> </a:t>
            </a:r>
            <a:r>
              <a:rPr lang="en-GB" sz="1000" dirty="0"/>
              <a:t>1. Postnatal clinician trigger for prenatal clinic patients  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5A1EE2B-971A-1D9F-F510-05B095B641EA}"/>
              </a:ext>
            </a:extLst>
          </p:cNvPr>
          <p:cNvSpPr/>
          <p:nvPr/>
        </p:nvSpPr>
        <p:spPr>
          <a:xfrm>
            <a:off x="8324177" y="4641813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capacity</a:t>
            </a:r>
          </a:p>
        </p:txBody>
      </p:sp>
      <p:cxnSp>
        <p:nvCxnSpPr>
          <p:cNvPr id="5" name="Connector: Elbow 4">
            <a:extLst>
              <a:ext uri="{FF2B5EF4-FFF2-40B4-BE49-F238E27FC236}">
                <a16:creationId xmlns:a16="http://schemas.microsoft.com/office/drawing/2014/main" id="{5CAA4410-A4A2-8F86-C653-3E673FD46E60}"/>
              </a:ext>
            </a:extLst>
          </p:cNvPr>
          <p:cNvCxnSpPr>
            <a:cxnSpLocks/>
            <a:stCxn id="4" idx="1"/>
          </p:cNvCxnSpPr>
          <p:nvPr/>
        </p:nvCxnSpPr>
        <p:spPr>
          <a:xfrm rot="10800000" flipV="1">
            <a:off x="8271323" y="4940849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ACB3CE2B-4535-928E-65B3-A39EB99A94F8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4251680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50585CFC-FE58-235A-852E-A794450A68A1}"/>
              </a:ext>
            </a:extLst>
          </p:cNvPr>
          <p:cNvSpPr/>
          <p:nvPr/>
        </p:nvSpPr>
        <p:spPr>
          <a:xfrm>
            <a:off x="5236771" y="4685693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 and skill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2046E07E-E348-669C-5EEA-44A9550ACAA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5183917" y="4984729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14105" y="3587383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5A1EE2B-971A-1D9F-F510-05B095B641EA}"/>
              </a:ext>
            </a:extLst>
          </p:cNvPr>
          <p:cNvSpPr/>
          <p:nvPr/>
        </p:nvSpPr>
        <p:spPr>
          <a:xfrm>
            <a:off x="7919254" y="4175763"/>
            <a:ext cx="952986" cy="1094142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Getting the report to the referring clinician or someone who can action it</a:t>
            </a:r>
          </a:p>
        </p:txBody>
      </p:sp>
      <p:cxnSp>
        <p:nvCxnSpPr>
          <p:cNvPr id="5" name="Connector: Elbow 4">
            <a:extLst>
              <a:ext uri="{FF2B5EF4-FFF2-40B4-BE49-F238E27FC236}">
                <a16:creationId xmlns:a16="http://schemas.microsoft.com/office/drawing/2014/main" id="{5CAA4410-A4A2-8F86-C653-3E673FD46E60}"/>
              </a:ext>
            </a:extLst>
          </p:cNvPr>
          <p:cNvCxnSpPr>
            <a:cxnSpLocks/>
            <a:stCxn id="4" idx="1"/>
          </p:cNvCxnSpPr>
          <p:nvPr/>
        </p:nvCxnSpPr>
        <p:spPr>
          <a:xfrm rot="10800000" flipV="1">
            <a:off x="7866400" y="4722833"/>
            <a:ext cx="52854" cy="763181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A6035B0D-97F1-C859-1A47-F80046D4FAB8}"/>
              </a:ext>
            </a:extLst>
          </p:cNvPr>
          <p:cNvSpPr txBox="1"/>
          <p:nvPr/>
        </p:nvSpPr>
        <p:spPr>
          <a:xfrm>
            <a:off x="10848177" y="126335"/>
            <a:ext cx="1039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B04</a:t>
            </a:r>
            <a:endParaRPr lang="en-AU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8169817C-0EEF-2CE6-DFB5-C1E4C368A9FF}"/>
              </a:ext>
            </a:extLst>
          </p:cNvPr>
          <p:cNvGrpSpPr/>
          <p:nvPr/>
        </p:nvGrpSpPr>
        <p:grpSpPr>
          <a:xfrm>
            <a:off x="273254" y="1335074"/>
            <a:ext cx="11450494" cy="2072162"/>
            <a:chOff x="297543" y="1267267"/>
            <a:chExt cx="11450494" cy="2072162"/>
          </a:xfrm>
          <a:solidFill>
            <a:schemeClr val="bg1"/>
          </a:solidFill>
        </p:grpSpPr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9B3A0437-8D6A-624C-15DD-7A0B2EC6CB25}"/>
                </a:ext>
              </a:extLst>
            </p:cNvPr>
            <p:cNvSpPr/>
            <p:nvPr/>
          </p:nvSpPr>
          <p:spPr>
            <a:xfrm>
              <a:off x="6182292" y="1267267"/>
              <a:ext cx="840770" cy="2072162"/>
            </a:xfrm>
            <a:prstGeom prst="round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5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  <p:sp>
          <p:nvSpPr>
            <p:cNvPr id="9" name="Flowchart: Terminator 8">
              <a:extLst>
                <a:ext uri="{FF2B5EF4-FFF2-40B4-BE49-F238E27FC236}">
                  <a16:creationId xmlns:a16="http://schemas.microsoft.com/office/drawing/2014/main" id="{C8D7364B-B4C2-A132-331E-E6CF647D0C0E}"/>
                </a:ext>
              </a:extLst>
            </p:cNvPr>
            <p:cNvSpPr/>
            <p:nvPr/>
          </p:nvSpPr>
          <p:spPr>
            <a:xfrm>
              <a:off x="10843151" y="1466730"/>
              <a:ext cx="904886" cy="1404589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9. Patient informed about results</a:t>
              </a: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E458F853-7544-793C-F0F9-DC2A96184EE6}"/>
                </a:ext>
              </a:extLst>
            </p:cNvPr>
            <p:cNvCxnSpPr>
              <a:cxnSpLocks/>
            </p:cNvCxnSpPr>
            <p:nvPr/>
          </p:nvCxnSpPr>
          <p:spPr>
            <a:xfrm>
              <a:off x="1104922" y="1572267"/>
              <a:ext cx="5072931" cy="0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37A1F9B5-BAD0-0278-5E39-27DBA4E3749F}"/>
                </a:ext>
              </a:extLst>
            </p:cNvPr>
            <p:cNvCxnSpPr>
              <a:cxnSpLocks/>
              <a:stCxn id="8" idx="3"/>
            </p:cNvCxnSpPr>
            <p:nvPr/>
          </p:nvCxnSpPr>
          <p:spPr>
            <a:xfrm flipV="1">
              <a:off x="7023062" y="2286922"/>
              <a:ext cx="3820089" cy="16426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Flowchart: Terminator 11">
              <a:extLst>
                <a:ext uri="{FF2B5EF4-FFF2-40B4-BE49-F238E27FC236}">
                  <a16:creationId xmlns:a16="http://schemas.microsoft.com/office/drawing/2014/main" id="{F6D7CD5B-A543-4754-37CA-DA6EA7BC9D98}"/>
                </a:ext>
              </a:extLst>
            </p:cNvPr>
            <p:cNvSpPr/>
            <p:nvPr/>
          </p:nvSpPr>
          <p:spPr>
            <a:xfrm>
              <a:off x="297543" y="1291982"/>
              <a:ext cx="797370" cy="1638941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DD934788-2325-6D38-7EE3-6E30746E9BD3}"/>
              </a:ext>
            </a:extLst>
          </p:cNvPr>
          <p:cNvSpPr/>
          <p:nvPr/>
        </p:nvSpPr>
        <p:spPr>
          <a:xfrm>
            <a:off x="8268802" y="2026447"/>
            <a:ext cx="1274522" cy="54230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7. Requesting clinician informed about results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83D641C-F44C-B4F4-E074-B11219334634}"/>
              </a:ext>
            </a:extLst>
          </p:cNvPr>
          <p:cNvSpPr/>
          <p:nvPr/>
        </p:nvSpPr>
        <p:spPr>
          <a:xfrm>
            <a:off x="7176793" y="2053854"/>
            <a:ext cx="923493" cy="46362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Report issued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655930F-04EE-80A6-5E9A-C85A0AEE8071}"/>
              </a:ext>
            </a:extLst>
          </p:cNvPr>
          <p:cNvSpPr/>
          <p:nvPr/>
        </p:nvSpPr>
        <p:spPr>
          <a:xfrm>
            <a:off x="9692076" y="2026447"/>
            <a:ext cx="904886" cy="54230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8. Enters medical record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4667034-030E-4F5C-BD53-1BD54869AED6}"/>
              </a:ext>
            </a:extLst>
          </p:cNvPr>
          <p:cNvSpPr/>
          <p:nvPr/>
        </p:nvSpPr>
        <p:spPr>
          <a:xfrm>
            <a:off x="1140997" y="1371983"/>
            <a:ext cx="1073236" cy="54486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Clinician requests reanalysis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A4ECCF5-249D-B9CF-80F6-58A281B9384F}"/>
              </a:ext>
            </a:extLst>
          </p:cNvPr>
          <p:cNvCxnSpPr>
            <a:cxnSpLocks/>
          </p:cNvCxnSpPr>
          <p:nvPr/>
        </p:nvCxnSpPr>
        <p:spPr>
          <a:xfrm>
            <a:off x="1080633" y="2803703"/>
            <a:ext cx="507293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08A65C96-5C76-AF60-FAE0-C9EC43D2D72E}"/>
              </a:ext>
            </a:extLst>
          </p:cNvPr>
          <p:cNvSpPr/>
          <p:nvPr/>
        </p:nvSpPr>
        <p:spPr>
          <a:xfrm>
            <a:off x="1137759" y="2429816"/>
            <a:ext cx="1273184" cy="5894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Lab triggered (new information, or discrepancy is found) 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93A4635-54A1-1252-B53D-DB3FF8F13760}"/>
              </a:ext>
            </a:extLst>
          </p:cNvPr>
          <p:cNvSpPr/>
          <p:nvPr/>
        </p:nvSpPr>
        <p:spPr>
          <a:xfrm>
            <a:off x="5050345" y="1227648"/>
            <a:ext cx="894671" cy="7987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 Funded by the requesting department 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EC777EEE-2ECD-CD5A-F37F-5D5DED4C4D8D}"/>
              </a:ext>
            </a:extLst>
          </p:cNvPr>
          <p:cNvGrpSpPr/>
          <p:nvPr/>
        </p:nvGrpSpPr>
        <p:grpSpPr>
          <a:xfrm>
            <a:off x="3309884" y="1151991"/>
            <a:ext cx="1306639" cy="995304"/>
            <a:chOff x="3067039" y="948944"/>
            <a:chExt cx="1306639" cy="995304"/>
          </a:xfrm>
          <a:solidFill>
            <a:schemeClr val="bg1"/>
          </a:solidFill>
        </p:grpSpPr>
        <p:sp>
          <p:nvSpPr>
            <p:cNvPr id="21" name="Diamond 20">
              <a:extLst>
                <a:ext uri="{FF2B5EF4-FFF2-40B4-BE49-F238E27FC236}">
                  <a16:creationId xmlns:a16="http://schemas.microsoft.com/office/drawing/2014/main" id="{EA4A3E03-6E36-73EB-8326-70E9DB85F702}"/>
                </a:ext>
              </a:extLst>
            </p:cNvPr>
            <p:cNvSpPr/>
            <p:nvPr/>
          </p:nvSpPr>
          <p:spPr>
            <a:xfrm>
              <a:off x="3090485" y="948944"/>
              <a:ext cx="1273184" cy="995304"/>
            </a:xfrm>
            <a:prstGeom prst="diamond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0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110C9F3-2BD9-DE84-3F95-32510A0404FC}"/>
                </a:ext>
              </a:extLst>
            </p:cNvPr>
            <p:cNvSpPr txBox="1"/>
            <p:nvPr/>
          </p:nvSpPr>
          <p:spPr>
            <a:xfrm>
              <a:off x="3067039" y="1244903"/>
              <a:ext cx="1306639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000" dirty="0">
                  <a:solidFill>
                    <a:schemeClr val="dk1"/>
                  </a:solidFill>
                </a:rPr>
                <a:t>3. Case is discussed at liaison meeting</a:t>
              </a:r>
            </a:p>
          </p:txBody>
        </p:sp>
      </p:grpSp>
      <p:sp>
        <p:nvSpPr>
          <p:cNvPr id="46" name="Rectangle 45">
            <a:extLst>
              <a:ext uri="{FF2B5EF4-FFF2-40B4-BE49-F238E27FC236}">
                <a16:creationId xmlns:a16="http://schemas.microsoft.com/office/drawing/2014/main" id="{AFD47334-6A5E-57AC-F1F0-AED655435765}"/>
              </a:ext>
            </a:extLst>
          </p:cNvPr>
          <p:cNvSpPr/>
          <p:nvPr/>
        </p:nvSpPr>
        <p:spPr>
          <a:xfrm>
            <a:off x="2306248" y="1371983"/>
            <a:ext cx="949989" cy="54486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Patient consented by clinician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217356E-059D-E1EF-0CC7-19F2E23AFCCC}"/>
              </a:ext>
            </a:extLst>
          </p:cNvPr>
          <p:cNvSpPr/>
          <p:nvPr/>
        </p:nvSpPr>
        <p:spPr>
          <a:xfrm>
            <a:off x="5081347" y="2517478"/>
            <a:ext cx="879313" cy="6114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 Funded by the lab</a:t>
            </a:r>
          </a:p>
        </p:txBody>
      </p:sp>
      <p:sp>
        <p:nvSpPr>
          <p:cNvPr id="50" name="Diamond 49">
            <a:extLst>
              <a:ext uri="{FF2B5EF4-FFF2-40B4-BE49-F238E27FC236}">
                <a16:creationId xmlns:a16="http://schemas.microsoft.com/office/drawing/2014/main" id="{BDB51E08-59CF-70C9-A127-7D830131C91E}"/>
              </a:ext>
            </a:extLst>
          </p:cNvPr>
          <p:cNvSpPr/>
          <p:nvPr/>
        </p:nvSpPr>
        <p:spPr>
          <a:xfrm>
            <a:off x="3343339" y="2306051"/>
            <a:ext cx="1273184" cy="995304"/>
          </a:xfrm>
          <a:prstGeom prst="diamond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sz="10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2041384-BD42-C56E-F5A7-078EC7DCF887}"/>
              </a:ext>
            </a:extLst>
          </p:cNvPr>
          <p:cNvSpPr txBox="1"/>
          <p:nvPr/>
        </p:nvSpPr>
        <p:spPr>
          <a:xfrm>
            <a:off x="3326611" y="2551568"/>
            <a:ext cx="1306639" cy="40011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GB" sz="1000" dirty="0">
                <a:solidFill>
                  <a:schemeClr val="dk1"/>
                </a:solidFill>
              </a:rPr>
              <a:t>3. Lab decides is reanalysis is required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CA70ABCF-224A-80D9-ADDD-7F45FCED2659}"/>
              </a:ext>
            </a:extLst>
          </p:cNvPr>
          <p:cNvSpPr/>
          <p:nvPr/>
        </p:nvSpPr>
        <p:spPr>
          <a:xfrm>
            <a:off x="2474246" y="2419934"/>
            <a:ext cx="766758" cy="61082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Original consent stands</a:t>
            </a:r>
          </a:p>
        </p:txBody>
      </p:sp>
      <p:sp>
        <p:nvSpPr>
          <p:cNvPr id="66" name="Rectangle: Rounded Corners 65">
            <a:extLst>
              <a:ext uri="{FF2B5EF4-FFF2-40B4-BE49-F238E27FC236}">
                <a16:creationId xmlns:a16="http://schemas.microsoft.com/office/drawing/2014/main" id="{F8C3E877-60CD-A3A2-FCE6-601C46B4986A}"/>
              </a:ext>
            </a:extLst>
          </p:cNvPr>
          <p:cNvSpPr/>
          <p:nvPr/>
        </p:nvSpPr>
        <p:spPr>
          <a:xfrm>
            <a:off x="436789" y="4548314"/>
            <a:ext cx="1055022" cy="73972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How to reconsent is scope of analysis is broadened</a:t>
            </a:r>
          </a:p>
        </p:txBody>
      </p:sp>
      <p:cxnSp>
        <p:nvCxnSpPr>
          <p:cNvPr id="68" name="Connector: Elbow 67">
            <a:extLst>
              <a:ext uri="{FF2B5EF4-FFF2-40B4-BE49-F238E27FC236}">
                <a16:creationId xmlns:a16="http://schemas.microsoft.com/office/drawing/2014/main" id="{BAB3F3FA-AC2A-2E27-9845-D5DCF31EBB1E}"/>
              </a:ext>
            </a:extLst>
          </p:cNvPr>
          <p:cNvCxnSpPr>
            <a:cxnSpLocks/>
            <a:stCxn id="66" idx="1"/>
          </p:cNvCxnSpPr>
          <p:nvPr/>
        </p:nvCxnSpPr>
        <p:spPr>
          <a:xfrm rot="10800000" flipV="1">
            <a:off x="383935" y="4918178"/>
            <a:ext cx="52854" cy="585976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: Rounded Corners 72">
            <a:extLst>
              <a:ext uri="{FF2B5EF4-FFF2-40B4-BE49-F238E27FC236}">
                <a16:creationId xmlns:a16="http://schemas.microsoft.com/office/drawing/2014/main" id="{11B1ED7B-BACD-72C8-0522-696E3C4720CD}"/>
              </a:ext>
            </a:extLst>
          </p:cNvPr>
          <p:cNvSpPr/>
          <p:nvPr/>
        </p:nvSpPr>
        <p:spPr>
          <a:xfrm>
            <a:off x="2840469" y="4671833"/>
            <a:ext cx="95721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hange in workflow</a:t>
            </a:r>
          </a:p>
        </p:txBody>
      </p:sp>
      <p:cxnSp>
        <p:nvCxnSpPr>
          <p:cNvPr id="75" name="Connector: Elbow 74">
            <a:extLst>
              <a:ext uri="{FF2B5EF4-FFF2-40B4-BE49-F238E27FC236}">
                <a16:creationId xmlns:a16="http://schemas.microsoft.com/office/drawing/2014/main" id="{B0317852-C7EE-AEA4-F2A6-51729C250BBF}"/>
              </a:ext>
            </a:extLst>
          </p:cNvPr>
          <p:cNvCxnSpPr>
            <a:cxnSpLocks/>
            <a:stCxn id="73" idx="1"/>
          </p:cNvCxnSpPr>
          <p:nvPr/>
        </p:nvCxnSpPr>
        <p:spPr>
          <a:xfrm rot="10800000" flipV="1">
            <a:off x="2787615" y="4970869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: Rounded Corners 99">
            <a:extLst>
              <a:ext uri="{FF2B5EF4-FFF2-40B4-BE49-F238E27FC236}">
                <a16:creationId xmlns:a16="http://schemas.microsoft.com/office/drawing/2014/main" id="{2E628AD1-CC1B-5DAE-43D9-C82621359D3B}"/>
              </a:ext>
            </a:extLst>
          </p:cNvPr>
          <p:cNvSpPr/>
          <p:nvPr/>
        </p:nvSpPr>
        <p:spPr>
          <a:xfrm>
            <a:off x="4152071" y="4685693"/>
            <a:ext cx="787798" cy="56805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Develop a pipeline</a:t>
            </a:r>
          </a:p>
        </p:txBody>
      </p:sp>
      <p:cxnSp>
        <p:nvCxnSpPr>
          <p:cNvPr id="102" name="Connector: Elbow 101">
            <a:extLst>
              <a:ext uri="{FF2B5EF4-FFF2-40B4-BE49-F238E27FC236}">
                <a16:creationId xmlns:a16="http://schemas.microsoft.com/office/drawing/2014/main" id="{A3596005-197A-8079-3251-3F09E62DBD31}"/>
              </a:ext>
            </a:extLst>
          </p:cNvPr>
          <p:cNvCxnSpPr>
            <a:cxnSpLocks/>
            <a:stCxn id="100" idx="1"/>
          </p:cNvCxnSpPr>
          <p:nvPr/>
        </p:nvCxnSpPr>
        <p:spPr>
          <a:xfrm rot="10800000" flipV="1">
            <a:off x="4099219" y="4969718"/>
            <a:ext cx="52853" cy="50013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: Rounded Corners 38">
            <a:extLst>
              <a:ext uri="{FF2B5EF4-FFF2-40B4-BE49-F238E27FC236}">
                <a16:creationId xmlns:a16="http://schemas.microsoft.com/office/drawing/2014/main" id="{32C6CAB8-7887-F07A-5669-27A5B81BDCB3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7270364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51" name="Rectangle: Rounded Corners 50">
            <a:extLst>
              <a:ext uri="{FF2B5EF4-FFF2-40B4-BE49-F238E27FC236}">
                <a16:creationId xmlns:a16="http://schemas.microsoft.com/office/drawing/2014/main" id="{41268781-6795-5F72-87FA-A86C962F1A60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barrier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14105" y="3587383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5A1EE2B-971A-1D9F-F510-05B095B641EA}"/>
              </a:ext>
            </a:extLst>
          </p:cNvPr>
          <p:cNvSpPr/>
          <p:nvPr/>
        </p:nvSpPr>
        <p:spPr>
          <a:xfrm>
            <a:off x="7919254" y="3822193"/>
            <a:ext cx="952986" cy="1447712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Getting the report to the referring clinician or someone who can action it (legal/ethical framework) </a:t>
            </a:r>
          </a:p>
        </p:txBody>
      </p:sp>
      <p:cxnSp>
        <p:nvCxnSpPr>
          <p:cNvPr id="5" name="Connector: Elbow 4">
            <a:extLst>
              <a:ext uri="{FF2B5EF4-FFF2-40B4-BE49-F238E27FC236}">
                <a16:creationId xmlns:a16="http://schemas.microsoft.com/office/drawing/2014/main" id="{5CAA4410-A4A2-8F86-C653-3E673FD46E60}"/>
              </a:ext>
            </a:extLst>
          </p:cNvPr>
          <p:cNvCxnSpPr>
            <a:cxnSpLocks/>
            <a:stCxn id="4" idx="1"/>
          </p:cNvCxnSpPr>
          <p:nvPr/>
        </p:nvCxnSpPr>
        <p:spPr>
          <a:xfrm rot="10800000" flipV="1">
            <a:off x="7866400" y="4546049"/>
            <a:ext cx="52854" cy="93996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23F8A191-4CE7-40DE-0270-8A347B0102CF}"/>
              </a:ext>
            </a:extLst>
          </p:cNvPr>
          <p:cNvSpPr txBox="1"/>
          <p:nvPr/>
        </p:nvSpPr>
        <p:spPr>
          <a:xfrm>
            <a:off x="11117141" y="184615"/>
            <a:ext cx="919108" cy="378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G05</a:t>
            </a:r>
            <a:endParaRPr lang="en-AU" dirty="0"/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BCB17A9D-47E9-7DB7-524A-F31933DF032E}"/>
              </a:ext>
            </a:extLst>
          </p:cNvPr>
          <p:cNvGrpSpPr/>
          <p:nvPr/>
        </p:nvGrpSpPr>
        <p:grpSpPr>
          <a:xfrm>
            <a:off x="173415" y="1586735"/>
            <a:ext cx="10640443" cy="968032"/>
            <a:chOff x="-186166" y="1236763"/>
            <a:chExt cx="10640443" cy="968032"/>
          </a:xfrm>
          <a:solidFill>
            <a:schemeClr val="bg1"/>
          </a:solidFill>
        </p:grpSpPr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3435E52B-C6EA-20D4-BF8C-FE1455C2B667}"/>
                </a:ext>
              </a:extLst>
            </p:cNvPr>
            <p:cNvCxnSpPr>
              <a:cxnSpLocks/>
              <a:endCxn id="58" idx="1"/>
            </p:cNvCxnSpPr>
            <p:nvPr/>
          </p:nvCxnSpPr>
          <p:spPr>
            <a:xfrm flipV="1">
              <a:off x="635297" y="1673304"/>
              <a:ext cx="9818980" cy="10645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Flowchart: Terminator 43">
              <a:extLst>
                <a:ext uri="{FF2B5EF4-FFF2-40B4-BE49-F238E27FC236}">
                  <a16:creationId xmlns:a16="http://schemas.microsoft.com/office/drawing/2014/main" id="{74AC6571-B96F-ABE2-375B-234601BCDBA8}"/>
                </a:ext>
              </a:extLst>
            </p:cNvPr>
            <p:cNvSpPr/>
            <p:nvPr/>
          </p:nvSpPr>
          <p:spPr>
            <a:xfrm>
              <a:off x="-186166" y="1236763"/>
              <a:ext cx="786850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7B856EF9-587C-59AF-E11A-35E7AF614893}"/>
                </a:ext>
              </a:extLst>
            </p:cNvPr>
            <p:cNvSpPr/>
            <p:nvPr/>
          </p:nvSpPr>
          <p:spPr>
            <a:xfrm>
              <a:off x="6383827" y="1479244"/>
              <a:ext cx="1086595" cy="469054"/>
            </a:xfrm>
            <a:prstGeom prst="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6.</a:t>
              </a:r>
            </a:p>
            <a:p>
              <a:pPr algn="ctr"/>
              <a:r>
                <a:rPr lang="en-GB" sz="1000" b="1" dirty="0"/>
                <a:t>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4E66AD31-FBD9-3503-721E-6AAA8EF65A8B}"/>
                </a:ext>
              </a:extLst>
            </p:cNvPr>
            <p:cNvSpPr/>
            <p:nvPr/>
          </p:nvSpPr>
          <p:spPr>
            <a:xfrm>
              <a:off x="9000674" y="1389405"/>
              <a:ext cx="1306021" cy="648731"/>
            </a:xfrm>
            <a:prstGeom prst="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8.Patient informed about results</a:t>
              </a:r>
            </a:p>
          </p:txBody>
        </p:sp>
      </p:grpSp>
      <p:sp>
        <p:nvSpPr>
          <p:cNvPr id="55" name="Rectangle 54">
            <a:extLst>
              <a:ext uri="{FF2B5EF4-FFF2-40B4-BE49-F238E27FC236}">
                <a16:creationId xmlns:a16="http://schemas.microsoft.com/office/drawing/2014/main" id="{809813D9-67B5-DC08-8312-CEDA552904A0}"/>
              </a:ext>
            </a:extLst>
          </p:cNvPr>
          <p:cNvSpPr/>
          <p:nvPr/>
        </p:nvSpPr>
        <p:spPr>
          <a:xfrm>
            <a:off x="1069813" y="1645778"/>
            <a:ext cx="1196473" cy="84484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1. Patient is informed by clinician to be referred back in 2-3 years time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342A5D04-C13E-7F05-4C05-399FC2764337}"/>
              </a:ext>
            </a:extLst>
          </p:cNvPr>
          <p:cNvSpPr/>
          <p:nvPr/>
        </p:nvSpPr>
        <p:spPr>
          <a:xfrm>
            <a:off x="7930467" y="1779556"/>
            <a:ext cx="1306020" cy="58239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7 .Requesting clinician informed about results</a:t>
            </a:r>
          </a:p>
        </p:txBody>
      </p:sp>
      <p:sp>
        <p:nvSpPr>
          <p:cNvPr id="58" name="Rectangle: Rounded Corners 57">
            <a:extLst>
              <a:ext uri="{FF2B5EF4-FFF2-40B4-BE49-F238E27FC236}">
                <a16:creationId xmlns:a16="http://schemas.microsoft.com/office/drawing/2014/main" id="{26F48728-00D0-19D8-6E47-AD10838C50ED}"/>
              </a:ext>
            </a:extLst>
          </p:cNvPr>
          <p:cNvSpPr/>
          <p:nvPr/>
        </p:nvSpPr>
        <p:spPr>
          <a:xfrm>
            <a:off x="10813858" y="1698911"/>
            <a:ext cx="1074859" cy="64873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9. Result sent to primary care physician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40B1AE27-B08B-517B-27C4-5DDA37FF8E75}"/>
              </a:ext>
            </a:extLst>
          </p:cNvPr>
          <p:cNvSpPr/>
          <p:nvPr/>
        </p:nvSpPr>
        <p:spPr>
          <a:xfrm>
            <a:off x="4592083" y="1843130"/>
            <a:ext cx="911565" cy="4182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4.Patient consents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CD0FCBAF-C542-5261-3C2F-6AE5F2582BE5}"/>
              </a:ext>
            </a:extLst>
          </p:cNvPr>
          <p:cNvSpPr/>
          <p:nvPr/>
        </p:nvSpPr>
        <p:spPr>
          <a:xfrm>
            <a:off x="3139411" y="2634185"/>
            <a:ext cx="3074073" cy="9797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GB" sz="1000" dirty="0">
                <a:solidFill>
                  <a:schemeClr val="dk1"/>
                </a:solidFill>
              </a:rPr>
              <a:t>Guideline</a:t>
            </a:r>
          </a:p>
          <a:p>
            <a:r>
              <a:rPr lang="en-GB" sz="1000" dirty="0"/>
              <a:t>1. A</a:t>
            </a:r>
            <a:r>
              <a:rPr lang="en-GB" sz="1000" dirty="0">
                <a:solidFill>
                  <a:schemeClr val="dk1"/>
                </a:solidFill>
              </a:rPr>
              <a:t> significant change in the patients phenotype</a:t>
            </a:r>
          </a:p>
          <a:p>
            <a:r>
              <a:rPr lang="en-GB" sz="1000" dirty="0">
                <a:solidFill>
                  <a:schemeClr val="dk1"/>
                </a:solidFill>
              </a:rPr>
              <a:t>2. </a:t>
            </a:r>
            <a:r>
              <a:rPr lang="en-GB" sz="1000" dirty="0"/>
              <a:t>P</a:t>
            </a:r>
            <a:r>
              <a:rPr lang="en-GB" sz="1000" dirty="0">
                <a:solidFill>
                  <a:schemeClr val="dk1"/>
                </a:solidFill>
              </a:rPr>
              <a:t>revious test was incomplete or incorrect</a:t>
            </a:r>
          </a:p>
          <a:p>
            <a:r>
              <a:rPr lang="en-GB" sz="1000" dirty="0"/>
              <a:t>3. T</a:t>
            </a:r>
            <a:r>
              <a:rPr lang="en-GB" sz="1000" dirty="0">
                <a:solidFill>
                  <a:schemeClr val="dk1"/>
                </a:solidFill>
              </a:rPr>
              <a:t>esting was done over 2 years ago and there is likely to be a yield because new genes have been discovered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22023527-95CD-DF69-2929-38CD617D3E8B}"/>
              </a:ext>
            </a:extLst>
          </p:cNvPr>
          <p:cNvSpPr/>
          <p:nvPr/>
        </p:nvSpPr>
        <p:spPr>
          <a:xfrm>
            <a:off x="2336992" y="1645052"/>
            <a:ext cx="733202" cy="846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2.Patient books review appt.</a:t>
            </a:r>
          </a:p>
        </p:txBody>
      </p:sp>
      <p:grpSp>
        <p:nvGrpSpPr>
          <p:cNvPr id="87" name="Group 86">
            <a:extLst>
              <a:ext uri="{FF2B5EF4-FFF2-40B4-BE49-F238E27FC236}">
                <a16:creationId xmlns:a16="http://schemas.microsoft.com/office/drawing/2014/main" id="{5348658C-0D0F-E40D-F22D-D906F58794F8}"/>
              </a:ext>
            </a:extLst>
          </p:cNvPr>
          <p:cNvGrpSpPr/>
          <p:nvPr/>
        </p:nvGrpSpPr>
        <p:grpSpPr>
          <a:xfrm>
            <a:off x="3121409" y="1547241"/>
            <a:ext cx="1434084" cy="968031"/>
            <a:chOff x="3242075" y="1537036"/>
            <a:chExt cx="1434084" cy="968031"/>
          </a:xfrm>
        </p:grpSpPr>
        <p:sp>
          <p:nvSpPr>
            <p:cNvPr id="56" name="Flowchart: Decision 55">
              <a:extLst>
                <a:ext uri="{FF2B5EF4-FFF2-40B4-BE49-F238E27FC236}">
                  <a16:creationId xmlns:a16="http://schemas.microsoft.com/office/drawing/2014/main" id="{7202911C-343A-5D34-50AA-186B2CBC97EF}"/>
                </a:ext>
              </a:extLst>
            </p:cNvPr>
            <p:cNvSpPr/>
            <p:nvPr/>
          </p:nvSpPr>
          <p:spPr>
            <a:xfrm>
              <a:off x="3244239" y="1537036"/>
              <a:ext cx="1415187" cy="968031"/>
            </a:xfrm>
            <a:prstGeom prst="flowChartDecision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 sz="1000" dirty="0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55E2748-CA4F-D298-39AD-0AFF9B2DD7AD}"/>
                </a:ext>
              </a:extLst>
            </p:cNvPr>
            <p:cNvSpPr txBox="1"/>
            <p:nvPr/>
          </p:nvSpPr>
          <p:spPr>
            <a:xfrm>
              <a:off x="3242075" y="1822997"/>
              <a:ext cx="1434084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GB" sz="1000" dirty="0"/>
                <a:t>3.Clinician decides to reanalyse based on guideline</a:t>
              </a:r>
            </a:p>
          </p:txBody>
        </p:sp>
      </p:grpSp>
      <p:sp>
        <p:nvSpPr>
          <p:cNvPr id="41" name="Rectangle 40">
            <a:extLst>
              <a:ext uri="{FF2B5EF4-FFF2-40B4-BE49-F238E27FC236}">
                <a16:creationId xmlns:a16="http://schemas.microsoft.com/office/drawing/2014/main" id="{4E5EA862-DC80-8F22-5473-DF197ACBFD62}"/>
              </a:ext>
            </a:extLst>
          </p:cNvPr>
          <p:cNvSpPr/>
          <p:nvPr/>
        </p:nvSpPr>
        <p:spPr>
          <a:xfrm>
            <a:off x="5576829" y="1787617"/>
            <a:ext cx="1094897" cy="5743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5. Funded by the requesting department</a:t>
            </a:r>
          </a:p>
        </p:txBody>
      </p:sp>
      <p:sp>
        <p:nvSpPr>
          <p:cNvPr id="89" name="Rectangle: Rounded Corners 88">
            <a:extLst>
              <a:ext uri="{FF2B5EF4-FFF2-40B4-BE49-F238E27FC236}">
                <a16:creationId xmlns:a16="http://schemas.microsoft.com/office/drawing/2014/main" id="{6883238D-0CE0-5EAF-93D7-71DBA8400FCB}"/>
              </a:ext>
            </a:extLst>
          </p:cNvPr>
          <p:cNvSpPr/>
          <p:nvPr/>
        </p:nvSpPr>
        <p:spPr>
          <a:xfrm>
            <a:off x="2821169" y="4640654"/>
            <a:ext cx="899516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pdating phenotype information</a:t>
            </a:r>
          </a:p>
        </p:txBody>
      </p:sp>
      <p:cxnSp>
        <p:nvCxnSpPr>
          <p:cNvPr id="90" name="Connector: Elbow 89">
            <a:extLst>
              <a:ext uri="{FF2B5EF4-FFF2-40B4-BE49-F238E27FC236}">
                <a16:creationId xmlns:a16="http://schemas.microsoft.com/office/drawing/2014/main" id="{48AECDAE-7875-B8E5-8855-887605C7BABC}"/>
              </a:ext>
            </a:extLst>
          </p:cNvPr>
          <p:cNvCxnSpPr>
            <a:cxnSpLocks/>
            <a:stCxn id="89" idx="1"/>
          </p:cNvCxnSpPr>
          <p:nvPr/>
        </p:nvCxnSpPr>
        <p:spPr>
          <a:xfrm rot="10800000" flipV="1">
            <a:off x="2768315" y="4939690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Rectangle: Rounded Corners 105">
            <a:extLst>
              <a:ext uri="{FF2B5EF4-FFF2-40B4-BE49-F238E27FC236}">
                <a16:creationId xmlns:a16="http://schemas.microsoft.com/office/drawing/2014/main" id="{2346886B-129D-3F33-EB41-FE100F4B26F8}"/>
              </a:ext>
            </a:extLst>
          </p:cNvPr>
          <p:cNvSpPr/>
          <p:nvPr/>
        </p:nvSpPr>
        <p:spPr>
          <a:xfrm>
            <a:off x="265392" y="4732121"/>
            <a:ext cx="1007758" cy="528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Funded reanalysis program </a:t>
            </a:r>
          </a:p>
        </p:txBody>
      </p:sp>
      <p:cxnSp>
        <p:nvCxnSpPr>
          <p:cNvPr id="107" name="Connector: Elbow 106">
            <a:extLst>
              <a:ext uri="{FF2B5EF4-FFF2-40B4-BE49-F238E27FC236}">
                <a16:creationId xmlns:a16="http://schemas.microsoft.com/office/drawing/2014/main" id="{EB87F8AF-7676-1D16-2329-9A74CBCD7F76}"/>
              </a:ext>
            </a:extLst>
          </p:cNvPr>
          <p:cNvCxnSpPr>
            <a:stCxn id="106" idx="1"/>
          </p:cNvCxnSpPr>
          <p:nvPr/>
        </p:nvCxnSpPr>
        <p:spPr>
          <a:xfrm rot="10800000" flipV="1">
            <a:off x="223024" y="4996539"/>
            <a:ext cx="42369" cy="825781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Rectangle: Rounded Corners 107">
            <a:extLst>
              <a:ext uri="{FF2B5EF4-FFF2-40B4-BE49-F238E27FC236}">
                <a16:creationId xmlns:a16="http://schemas.microsoft.com/office/drawing/2014/main" id="{DD538740-B63A-68D4-BEC2-A8CB4A660C9E}"/>
              </a:ext>
            </a:extLst>
          </p:cNvPr>
          <p:cNvSpPr/>
          <p:nvPr/>
        </p:nvSpPr>
        <p:spPr>
          <a:xfrm>
            <a:off x="6605246" y="4649526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capacity</a:t>
            </a:r>
          </a:p>
        </p:txBody>
      </p:sp>
      <p:cxnSp>
        <p:nvCxnSpPr>
          <p:cNvPr id="109" name="Connector: Elbow 108">
            <a:extLst>
              <a:ext uri="{FF2B5EF4-FFF2-40B4-BE49-F238E27FC236}">
                <a16:creationId xmlns:a16="http://schemas.microsoft.com/office/drawing/2014/main" id="{7C677436-72AA-481B-FB3C-6D78A2AF0B10}"/>
              </a:ext>
            </a:extLst>
          </p:cNvPr>
          <p:cNvCxnSpPr>
            <a:cxnSpLocks/>
            <a:stCxn id="108" idx="1"/>
          </p:cNvCxnSpPr>
          <p:nvPr/>
        </p:nvCxnSpPr>
        <p:spPr>
          <a:xfrm rot="10800000" flipV="1">
            <a:off x="6552392" y="4948562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Rectangle: Rounded Corners 109">
            <a:extLst>
              <a:ext uri="{FF2B5EF4-FFF2-40B4-BE49-F238E27FC236}">
                <a16:creationId xmlns:a16="http://schemas.microsoft.com/office/drawing/2014/main" id="{68F15707-678E-35D5-C315-3AFFC2989D7A}"/>
              </a:ext>
            </a:extLst>
          </p:cNvPr>
          <p:cNvSpPr/>
          <p:nvPr/>
        </p:nvSpPr>
        <p:spPr>
          <a:xfrm>
            <a:off x="10612986" y="4450079"/>
            <a:ext cx="1074859" cy="786925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What if the patient no longer wishes to receive a result </a:t>
            </a:r>
          </a:p>
        </p:txBody>
      </p:sp>
      <p:cxnSp>
        <p:nvCxnSpPr>
          <p:cNvPr id="111" name="Connector: Elbow 110">
            <a:extLst>
              <a:ext uri="{FF2B5EF4-FFF2-40B4-BE49-F238E27FC236}">
                <a16:creationId xmlns:a16="http://schemas.microsoft.com/office/drawing/2014/main" id="{69399F57-2507-D929-2A94-3BB000E5B03C}"/>
              </a:ext>
            </a:extLst>
          </p:cNvPr>
          <p:cNvCxnSpPr>
            <a:cxnSpLocks/>
            <a:stCxn id="110" idx="1"/>
          </p:cNvCxnSpPr>
          <p:nvPr/>
        </p:nvCxnSpPr>
        <p:spPr>
          <a:xfrm rot="10800000" flipV="1">
            <a:off x="10560140" y="4843541"/>
            <a:ext cx="52847" cy="609561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tangle: Rounded Corners 112">
            <a:extLst>
              <a:ext uri="{FF2B5EF4-FFF2-40B4-BE49-F238E27FC236}">
                <a16:creationId xmlns:a16="http://schemas.microsoft.com/office/drawing/2014/main" id="{1B7764B9-703E-6296-9DCA-7E8C7FA7AC32}"/>
              </a:ext>
            </a:extLst>
          </p:cNvPr>
          <p:cNvSpPr/>
          <p:nvPr/>
        </p:nvSpPr>
        <p:spPr>
          <a:xfrm>
            <a:off x="10560144" y="3674811"/>
            <a:ext cx="840769" cy="60279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able to contact patient</a:t>
            </a:r>
          </a:p>
        </p:txBody>
      </p:sp>
      <p:cxnSp>
        <p:nvCxnSpPr>
          <p:cNvPr id="114" name="Connector: Elbow 113">
            <a:extLst>
              <a:ext uri="{FF2B5EF4-FFF2-40B4-BE49-F238E27FC236}">
                <a16:creationId xmlns:a16="http://schemas.microsoft.com/office/drawing/2014/main" id="{03E16682-8217-4FF0-216F-A033BED94754}"/>
              </a:ext>
            </a:extLst>
          </p:cNvPr>
          <p:cNvCxnSpPr>
            <a:cxnSpLocks/>
            <a:stCxn id="113" idx="1"/>
          </p:cNvCxnSpPr>
          <p:nvPr/>
        </p:nvCxnSpPr>
        <p:spPr>
          <a:xfrm rot="10800000" flipV="1">
            <a:off x="10507290" y="3976207"/>
            <a:ext cx="52854" cy="51750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28C20F75-2A88-AA9A-4164-56C0B135F4E8}"/>
              </a:ext>
            </a:extLst>
          </p:cNvPr>
          <p:cNvSpPr/>
          <p:nvPr/>
        </p:nvSpPr>
        <p:spPr>
          <a:xfrm>
            <a:off x="9206600" y="4655075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No national system</a:t>
            </a:r>
          </a:p>
        </p:txBody>
      </p:sp>
      <p:cxnSp>
        <p:nvCxnSpPr>
          <p:cNvPr id="7" name="Connector: Elbow 6">
            <a:extLst>
              <a:ext uri="{FF2B5EF4-FFF2-40B4-BE49-F238E27FC236}">
                <a16:creationId xmlns:a16="http://schemas.microsoft.com/office/drawing/2014/main" id="{04848098-0A00-40E9-280C-7E9EEF1951D2}"/>
              </a:ext>
            </a:extLst>
          </p:cNvPr>
          <p:cNvCxnSpPr>
            <a:cxnSpLocks/>
            <a:stCxn id="6" idx="1"/>
          </p:cNvCxnSpPr>
          <p:nvPr/>
        </p:nvCxnSpPr>
        <p:spPr>
          <a:xfrm rot="10800000" flipV="1">
            <a:off x="9153746" y="4954111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809256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80918E32-62AE-5D48-2341-8C4AEBDCF0B9}"/>
              </a:ext>
            </a:extLst>
          </p:cNvPr>
          <p:cNvCxnSpPr>
            <a:cxnSpLocks/>
          </p:cNvCxnSpPr>
          <p:nvPr/>
        </p:nvCxnSpPr>
        <p:spPr>
          <a:xfrm>
            <a:off x="1337526" y="1586133"/>
            <a:ext cx="8578564" cy="3756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14105" y="3587383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5A1EE2B-971A-1D9F-F510-05B095B641EA}"/>
              </a:ext>
            </a:extLst>
          </p:cNvPr>
          <p:cNvSpPr/>
          <p:nvPr/>
        </p:nvSpPr>
        <p:spPr>
          <a:xfrm>
            <a:off x="7919254" y="4126463"/>
            <a:ext cx="952986" cy="114344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Getting the report to the referring clinician or someone who can action it</a:t>
            </a:r>
          </a:p>
        </p:txBody>
      </p:sp>
      <p:cxnSp>
        <p:nvCxnSpPr>
          <p:cNvPr id="5" name="Connector: Elbow 4">
            <a:extLst>
              <a:ext uri="{FF2B5EF4-FFF2-40B4-BE49-F238E27FC236}">
                <a16:creationId xmlns:a16="http://schemas.microsoft.com/office/drawing/2014/main" id="{5CAA4410-A4A2-8F86-C653-3E673FD46E60}"/>
              </a:ext>
            </a:extLst>
          </p:cNvPr>
          <p:cNvCxnSpPr>
            <a:cxnSpLocks/>
            <a:stCxn id="4" idx="1"/>
          </p:cNvCxnSpPr>
          <p:nvPr/>
        </p:nvCxnSpPr>
        <p:spPr>
          <a:xfrm rot="10800000" flipV="1">
            <a:off x="7866400" y="4698183"/>
            <a:ext cx="52854" cy="78782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tangle: Rounded Corners 112">
            <a:extLst>
              <a:ext uri="{FF2B5EF4-FFF2-40B4-BE49-F238E27FC236}">
                <a16:creationId xmlns:a16="http://schemas.microsoft.com/office/drawing/2014/main" id="{1B7764B9-703E-6296-9DCA-7E8C7FA7AC32}"/>
              </a:ext>
            </a:extLst>
          </p:cNvPr>
          <p:cNvSpPr/>
          <p:nvPr/>
        </p:nvSpPr>
        <p:spPr>
          <a:xfrm>
            <a:off x="10632437" y="4641651"/>
            <a:ext cx="840769" cy="60279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able to contact patient</a:t>
            </a:r>
          </a:p>
        </p:txBody>
      </p:sp>
      <p:cxnSp>
        <p:nvCxnSpPr>
          <p:cNvPr id="114" name="Connector: Elbow 113">
            <a:extLst>
              <a:ext uri="{FF2B5EF4-FFF2-40B4-BE49-F238E27FC236}">
                <a16:creationId xmlns:a16="http://schemas.microsoft.com/office/drawing/2014/main" id="{03E16682-8217-4FF0-216F-A033BED94754}"/>
              </a:ext>
            </a:extLst>
          </p:cNvPr>
          <p:cNvCxnSpPr>
            <a:cxnSpLocks/>
            <a:stCxn id="113" idx="1"/>
          </p:cNvCxnSpPr>
          <p:nvPr/>
        </p:nvCxnSpPr>
        <p:spPr>
          <a:xfrm rot="10800000" flipV="1">
            <a:off x="10579583" y="4943047"/>
            <a:ext cx="52854" cy="51750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59475E75-A04E-6F61-C55B-B51759F1915A}"/>
              </a:ext>
            </a:extLst>
          </p:cNvPr>
          <p:cNvSpPr txBox="1"/>
          <p:nvPr/>
        </p:nvSpPr>
        <p:spPr>
          <a:xfrm>
            <a:off x="11172521" y="238676"/>
            <a:ext cx="841860" cy="377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C06</a:t>
            </a:r>
            <a:endParaRPr lang="en-AU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947045E-748E-DB9E-F6C5-D5B1CDFDF7F3}"/>
              </a:ext>
            </a:extLst>
          </p:cNvPr>
          <p:cNvCxnSpPr>
            <a:cxnSpLocks/>
          </p:cNvCxnSpPr>
          <p:nvPr/>
        </p:nvCxnSpPr>
        <p:spPr>
          <a:xfrm>
            <a:off x="1337526" y="2681478"/>
            <a:ext cx="29067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9" name="Group 8">
            <a:extLst>
              <a:ext uri="{FF2B5EF4-FFF2-40B4-BE49-F238E27FC236}">
                <a16:creationId xmlns:a16="http://schemas.microsoft.com/office/drawing/2014/main" id="{C9E7F075-8F8E-DE0B-9C7B-FC044D126025}"/>
              </a:ext>
            </a:extLst>
          </p:cNvPr>
          <p:cNvGrpSpPr/>
          <p:nvPr/>
        </p:nvGrpSpPr>
        <p:grpSpPr>
          <a:xfrm>
            <a:off x="585218" y="1158653"/>
            <a:ext cx="10815695" cy="1787996"/>
            <a:chOff x="196767" y="980448"/>
            <a:chExt cx="10815695" cy="1787996"/>
          </a:xfrm>
          <a:solidFill>
            <a:schemeClr val="bg1"/>
          </a:solidFill>
        </p:grpSpPr>
        <p:sp>
          <p:nvSpPr>
            <p:cNvPr id="10" name="Flowchart: Terminator 9">
              <a:extLst>
                <a:ext uri="{FF2B5EF4-FFF2-40B4-BE49-F238E27FC236}">
                  <a16:creationId xmlns:a16="http://schemas.microsoft.com/office/drawing/2014/main" id="{3EA062A4-35D5-268E-E4AC-8F122F0069E8}"/>
                </a:ext>
              </a:extLst>
            </p:cNvPr>
            <p:cNvSpPr/>
            <p:nvPr/>
          </p:nvSpPr>
          <p:spPr>
            <a:xfrm>
              <a:off x="196767" y="1126472"/>
              <a:ext cx="752406" cy="164197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dirty="0"/>
                <a:t>Unsolved patient</a:t>
              </a:r>
            </a:p>
          </p:txBody>
        </p:sp>
        <p:sp>
          <p:nvSpPr>
            <p:cNvPr id="12" name="Flowchart: Terminator 11">
              <a:extLst>
                <a:ext uri="{FF2B5EF4-FFF2-40B4-BE49-F238E27FC236}">
                  <a16:creationId xmlns:a16="http://schemas.microsoft.com/office/drawing/2014/main" id="{7DE263B4-270F-6523-39E1-E6CADF1DE160}"/>
                </a:ext>
              </a:extLst>
            </p:cNvPr>
            <p:cNvSpPr/>
            <p:nvPr/>
          </p:nvSpPr>
          <p:spPr>
            <a:xfrm>
              <a:off x="9527639" y="980448"/>
              <a:ext cx="1484823" cy="96803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dirty="0"/>
                <a:t>7. Patient informed about results either in person, telehealth or a phone call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6C17C40-DC80-01E4-7023-2AD50626EE38}"/>
                </a:ext>
              </a:extLst>
            </p:cNvPr>
            <p:cNvSpPr/>
            <p:nvPr/>
          </p:nvSpPr>
          <p:spPr>
            <a:xfrm>
              <a:off x="7041504" y="1163921"/>
              <a:ext cx="1069239" cy="648920"/>
            </a:xfrm>
            <a:prstGeom prst="rect">
              <a:avLst/>
            </a:prstGeom>
            <a:solidFill>
              <a:schemeClr val="bg1"/>
            </a:solidFill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dirty="0"/>
                <a:t>5. Reanalysis</a:t>
              </a:r>
              <a:endParaRPr lang="en-GB" sz="1000" dirty="0">
                <a:highlight>
                  <a:srgbClr val="FFFF00"/>
                </a:highlight>
              </a:endParaRP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8E4341DA-2D04-695A-4C83-31B9D2E1B839}"/>
              </a:ext>
            </a:extLst>
          </p:cNvPr>
          <p:cNvSpPr/>
          <p:nvPr/>
        </p:nvSpPr>
        <p:spPr>
          <a:xfrm>
            <a:off x="1762432" y="2385183"/>
            <a:ext cx="1364791" cy="65147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Patient or Primary care physician requests reanalysis </a:t>
            </a:r>
          </a:p>
        </p:txBody>
      </p:sp>
      <p:sp>
        <p:nvSpPr>
          <p:cNvPr id="18" name="Flowchart: Decision 17">
            <a:extLst>
              <a:ext uri="{FF2B5EF4-FFF2-40B4-BE49-F238E27FC236}">
                <a16:creationId xmlns:a16="http://schemas.microsoft.com/office/drawing/2014/main" id="{048DA4DC-9620-D8DB-18E6-24B7DAB84742}"/>
              </a:ext>
            </a:extLst>
          </p:cNvPr>
          <p:cNvSpPr/>
          <p:nvPr/>
        </p:nvSpPr>
        <p:spPr>
          <a:xfrm>
            <a:off x="1628203" y="1147200"/>
            <a:ext cx="1536801" cy="875903"/>
          </a:xfrm>
          <a:prstGeom prst="flowChartDecision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Clinician decides to trigger reanalysis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62C718B0-7D4F-84A3-5CC7-9AA53063C1BB}"/>
              </a:ext>
            </a:extLst>
          </p:cNvPr>
          <p:cNvCxnSpPr>
            <a:cxnSpLocks/>
            <a:endCxn id="18" idx="2"/>
          </p:cNvCxnSpPr>
          <p:nvPr/>
        </p:nvCxnSpPr>
        <p:spPr>
          <a:xfrm flipV="1">
            <a:off x="2396085" y="2023103"/>
            <a:ext cx="519" cy="362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A8391341-1B0F-FE4E-9764-253FD010CF50}"/>
              </a:ext>
            </a:extLst>
          </p:cNvPr>
          <p:cNvSpPr/>
          <p:nvPr/>
        </p:nvSpPr>
        <p:spPr>
          <a:xfrm>
            <a:off x="4835896" y="978346"/>
            <a:ext cx="1244543" cy="9680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 Funding available through state government, hospital or department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B5A6C437-DCFA-B9FD-8BBD-F733B12492F1}"/>
              </a:ext>
            </a:extLst>
          </p:cNvPr>
          <p:cNvSpPr/>
          <p:nvPr/>
        </p:nvSpPr>
        <p:spPr>
          <a:xfrm>
            <a:off x="3326974" y="1215965"/>
            <a:ext cx="1244543" cy="73837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Discuss case with lab to see if panel has been updated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0DFB252-5684-E675-B057-104747F57169}"/>
              </a:ext>
            </a:extLst>
          </p:cNvPr>
          <p:cNvSpPr/>
          <p:nvPr/>
        </p:nvSpPr>
        <p:spPr>
          <a:xfrm>
            <a:off x="8755199" y="1301431"/>
            <a:ext cx="904886" cy="64494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6. Clinician sent+/- report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9F726A9-AE6F-FF21-8D12-583727A650EB}"/>
              </a:ext>
            </a:extLst>
          </p:cNvPr>
          <p:cNvSpPr/>
          <p:nvPr/>
        </p:nvSpPr>
        <p:spPr>
          <a:xfrm>
            <a:off x="6286568" y="1301431"/>
            <a:ext cx="894270" cy="56971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 Re-consented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4E9B7464-8732-F0A6-9990-4F7D150DDA5E}"/>
              </a:ext>
            </a:extLst>
          </p:cNvPr>
          <p:cNvSpPr/>
          <p:nvPr/>
        </p:nvSpPr>
        <p:spPr>
          <a:xfrm>
            <a:off x="329768" y="6266829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19096667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32445" y="4002772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5A1EE2B-971A-1D9F-F510-05B095B641EA}"/>
              </a:ext>
            </a:extLst>
          </p:cNvPr>
          <p:cNvSpPr/>
          <p:nvPr/>
        </p:nvSpPr>
        <p:spPr>
          <a:xfrm>
            <a:off x="7919254" y="4126463"/>
            <a:ext cx="952986" cy="114344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Getting the report to the referring clinician or someone who can action it</a:t>
            </a:r>
          </a:p>
        </p:txBody>
      </p:sp>
      <p:cxnSp>
        <p:nvCxnSpPr>
          <p:cNvPr id="5" name="Connector: Elbow 4">
            <a:extLst>
              <a:ext uri="{FF2B5EF4-FFF2-40B4-BE49-F238E27FC236}">
                <a16:creationId xmlns:a16="http://schemas.microsoft.com/office/drawing/2014/main" id="{5CAA4410-A4A2-8F86-C653-3E673FD46E60}"/>
              </a:ext>
            </a:extLst>
          </p:cNvPr>
          <p:cNvCxnSpPr>
            <a:cxnSpLocks/>
            <a:stCxn id="4" idx="1"/>
          </p:cNvCxnSpPr>
          <p:nvPr/>
        </p:nvCxnSpPr>
        <p:spPr>
          <a:xfrm rot="10800000" flipV="1">
            <a:off x="7866400" y="4698183"/>
            <a:ext cx="52854" cy="78782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tangle: Rounded Corners 112">
            <a:extLst>
              <a:ext uri="{FF2B5EF4-FFF2-40B4-BE49-F238E27FC236}">
                <a16:creationId xmlns:a16="http://schemas.microsoft.com/office/drawing/2014/main" id="{1B7764B9-703E-6296-9DCA-7E8C7FA7AC32}"/>
              </a:ext>
            </a:extLst>
          </p:cNvPr>
          <p:cNvSpPr/>
          <p:nvPr/>
        </p:nvSpPr>
        <p:spPr>
          <a:xfrm>
            <a:off x="10632437" y="4641651"/>
            <a:ext cx="840769" cy="60279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able to contact patient</a:t>
            </a:r>
          </a:p>
        </p:txBody>
      </p:sp>
      <p:cxnSp>
        <p:nvCxnSpPr>
          <p:cNvPr id="114" name="Connector: Elbow 113">
            <a:extLst>
              <a:ext uri="{FF2B5EF4-FFF2-40B4-BE49-F238E27FC236}">
                <a16:creationId xmlns:a16="http://schemas.microsoft.com/office/drawing/2014/main" id="{03E16682-8217-4FF0-216F-A033BED94754}"/>
              </a:ext>
            </a:extLst>
          </p:cNvPr>
          <p:cNvCxnSpPr>
            <a:cxnSpLocks/>
            <a:stCxn id="113" idx="1"/>
          </p:cNvCxnSpPr>
          <p:nvPr/>
        </p:nvCxnSpPr>
        <p:spPr>
          <a:xfrm rot="10800000" flipV="1">
            <a:off x="10579583" y="4943047"/>
            <a:ext cx="52854" cy="51750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92CD392-ACD0-6CBF-AB46-6851FC72E631}"/>
              </a:ext>
            </a:extLst>
          </p:cNvPr>
          <p:cNvSpPr txBox="1"/>
          <p:nvPr/>
        </p:nvSpPr>
        <p:spPr>
          <a:xfrm>
            <a:off x="11030703" y="201816"/>
            <a:ext cx="1061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B07</a:t>
            </a:r>
            <a:endParaRPr lang="en-AU" dirty="0"/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26AD8178-FF4B-F741-9BC8-246F55DFAD4D}"/>
              </a:ext>
            </a:extLst>
          </p:cNvPr>
          <p:cNvCxnSpPr>
            <a:cxnSpLocks/>
          </p:cNvCxnSpPr>
          <p:nvPr/>
        </p:nvCxnSpPr>
        <p:spPr>
          <a:xfrm flipV="1">
            <a:off x="1570977" y="2667561"/>
            <a:ext cx="8310639" cy="509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FE9C9CF8-1C01-F41F-8DF5-8361B05128A8}"/>
              </a:ext>
            </a:extLst>
          </p:cNvPr>
          <p:cNvCxnSpPr>
            <a:cxnSpLocks/>
          </p:cNvCxnSpPr>
          <p:nvPr/>
        </p:nvCxnSpPr>
        <p:spPr>
          <a:xfrm flipV="1">
            <a:off x="1547567" y="1668568"/>
            <a:ext cx="8260897" cy="1879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0BFBF47A-5EE8-55CA-0F66-4C9D08E8578F}"/>
              </a:ext>
            </a:extLst>
          </p:cNvPr>
          <p:cNvCxnSpPr>
            <a:cxnSpLocks/>
          </p:cNvCxnSpPr>
          <p:nvPr/>
        </p:nvCxnSpPr>
        <p:spPr>
          <a:xfrm>
            <a:off x="1559271" y="3477708"/>
            <a:ext cx="846255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Flowchart: Terminator 63">
            <a:extLst>
              <a:ext uri="{FF2B5EF4-FFF2-40B4-BE49-F238E27FC236}">
                <a16:creationId xmlns:a16="http://schemas.microsoft.com/office/drawing/2014/main" id="{155A4E17-C5BE-8670-C833-F3AA230978AB}"/>
              </a:ext>
            </a:extLst>
          </p:cNvPr>
          <p:cNvSpPr/>
          <p:nvPr/>
        </p:nvSpPr>
        <p:spPr>
          <a:xfrm>
            <a:off x="380520" y="2243175"/>
            <a:ext cx="1190457" cy="1397776"/>
          </a:xfrm>
          <a:prstGeom prst="flowChartTerminator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Unsolved patient (paediatric)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ACB4AD6B-5F33-F1A5-D774-27FC088947A8}"/>
              </a:ext>
            </a:extLst>
          </p:cNvPr>
          <p:cNvSpPr/>
          <p:nvPr/>
        </p:nvSpPr>
        <p:spPr>
          <a:xfrm>
            <a:off x="1723051" y="2484686"/>
            <a:ext cx="1378361" cy="52294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Clinician request following 2-3 year review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5E33E9FA-D86B-B008-3F46-4FDA113E74AD}"/>
              </a:ext>
            </a:extLst>
          </p:cNvPr>
          <p:cNvSpPr/>
          <p:nvPr/>
        </p:nvSpPr>
        <p:spPr>
          <a:xfrm>
            <a:off x="4499204" y="2524431"/>
            <a:ext cx="873037" cy="39746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/>
              <a:t>3. re-consented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5CAD28A0-9C3A-E3D5-C6CC-6C9907143ECF}"/>
              </a:ext>
            </a:extLst>
          </p:cNvPr>
          <p:cNvSpPr/>
          <p:nvPr/>
        </p:nvSpPr>
        <p:spPr>
          <a:xfrm>
            <a:off x="1656792" y="3300802"/>
            <a:ext cx="1718162" cy="46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Immediate follow-up from primary report (Acute Care)</a:t>
            </a:r>
          </a:p>
        </p:txBody>
      </p:sp>
      <p:sp>
        <p:nvSpPr>
          <p:cNvPr id="68" name="Flowchart: Terminator 67">
            <a:extLst>
              <a:ext uri="{FF2B5EF4-FFF2-40B4-BE49-F238E27FC236}">
                <a16:creationId xmlns:a16="http://schemas.microsoft.com/office/drawing/2014/main" id="{851B9845-1F56-8817-95B7-1F19AF73F373}"/>
              </a:ext>
            </a:extLst>
          </p:cNvPr>
          <p:cNvSpPr/>
          <p:nvPr/>
        </p:nvSpPr>
        <p:spPr>
          <a:xfrm>
            <a:off x="357110" y="1057937"/>
            <a:ext cx="1190457" cy="968032"/>
          </a:xfrm>
          <a:prstGeom prst="flowChartTerminator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Unsolved patient (adult)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27FDEEA4-2BBB-27AA-F589-E6BD80FED4A5}"/>
              </a:ext>
            </a:extLst>
          </p:cNvPr>
          <p:cNvSpPr/>
          <p:nvPr/>
        </p:nvSpPr>
        <p:spPr>
          <a:xfrm>
            <a:off x="1913860" y="1482629"/>
            <a:ext cx="1648328" cy="37626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Clinician request for more genes added to panel</a:t>
            </a:r>
          </a:p>
        </p:txBody>
      </p:sp>
      <p:sp>
        <p:nvSpPr>
          <p:cNvPr id="71" name="Flowchart: Terminator 70">
            <a:extLst>
              <a:ext uri="{FF2B5EF4-FFF2-40B4-BE49-F238E27FC236}">
                <a16:creationId xmlns:a16="http://schemas.microsoft.com/office/drawing/2014/main" id="{C2F21E76-CB25-9F38-D2BA-36F712587B9B}"/>
              </a:ext>
            </a:extLst>
          </p:cNvPr>
          <p:cNvSpPr/>
          <p:nvPr/>
        </p:nvSpPr>
        <p:spPr>
          <a:xfrm>
            <a:off x="9949453" y="2134254"/>
            <a:ext cx="1990105" cy="793737"/>
          </a:xfrm>
          <a:prstGeom prst="flowChartTerminator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s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DEDC21CD-BD5E-5840-97E2-62DF70D1CCE8}"/>
              </a:ext>
            </a:extLst>
          </p:cNvPr>
          <p:cNvSpPr/>
          <p:nvPr/>
        </p:nvSpPr>
        <p:spPr>
          <a:xfrm>
            <a:off x="3175410" y="2512262"/>
            <a:ext cx="1147009" cy="4588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Department funding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0EBDF056-3531-DE73-560A-6194D8E82EF6}"/>
              </a:ext>
            </a:extLst>
          </p:cNvPr>
          <p:cNvSpPr/>
          <p:nvPr/>
        </p:nvSpPr>
        <p:spPr>
          <a:xfrm>
            <a:off x="3453645" y="3318692"/>
            <a:ext cx="762165" cy="42213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2. Lab funds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D5161250-5034-20CD-AD0D-6F7A7E1475D9}"/>
              </a:ext>
            </a:extLst>
          </p:cNvPr>
          <p:cNvSpPr/>
          <p:nvPr/>
        </p:nvSpPr>
        <p:spPr>
          <a:xfrm>
            <a:off x="8403531" y="2392214"/>
            <a:ext cx="909706" cy="3835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6. Medical records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92515C67-43EF-9002-B255-BD6EB70BCFE4}"/>
              </a:ext>
            </a:extLst>
          </p:cNvPr>
          <p:cNvSpPr/>
          <p:nvPr/>
        </p:nvSpPr>
        <p:spPr>
          <a:xfrm>
            <a:off x="7479972" y="3241234"/>
            <a:ext cx="1906705" cy="47294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5. New report or informal report (email)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3422D17E-1F31-8712-A8A1-21D9622D1D63}"/>
              </a:ext>
            </a:extLst>
          </p:cNvPr>
          <p:cNvSpPr/>
          <p:nvPr/>
        </p:nvSpPr>
        <p:spPr>
          <a:xfrm>
            <a:off x="7394243" y="2382137"/>
            <a:ext cx="909706" cy="3835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5. New report 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CF21E312-F229-1C2D-8A2E-99464D027225}"/>
              </a:ext>
            </a:extLst>
          </p:cNvPr>
          <p:cNvSpPr/>
          <p:nvPr/>
        </p:nvSpPr>
        <p:spPr>
          <a:xfrm>
            <a:off x="5883566" y="1503336"/>
            <a:ext cx="1034597" cy="2159943"/>
          </a:xfrm>
          <a:prstGeom prst="rect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Reanalysis</a:t>
            </a:r>
            <a:endParaRPr lang="en-GB" sz="1000" b="1" dirty="0">
              <a:highlight>
                <a:srgbClr val="FFFF00"/>
              </a:highlight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419C7013-37B7-6C43-4A68-9AF20B8B2E9E}"/>
              </a:ext>
            </a:extLst>
          </p:cNvPr>
          <p:cNvSpPr/>
          <p:nvPr/>
        </p:nvSpPr>
        <p:spPr>
          <a:xfrm>
            <a:off x="8358108" y="1550114"/>
            <a:ext cx="909706" cy="3835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6. Medical records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055960F-D05D-D0D7-A718-2BFF00180FFA}"/>
              </a:ext>
            </a:extLst>
          </p:cNvPr>
          <p:cNvSpPr/>
          <p:nvPr/>
        </p:nvSpPr>
        <p:spPr>
          <a:xfrm>
            <a:off x="7348820" y="1540037"/>
            <a:ext cx="909706" cy="3835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5. New report 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3E6DBCDB-F495-E29B-BB69-5A27BA6F7354}"/>
              </a:ext>
            </a:extLst>
          </p:cNvPr>
          <p:cNvSpPr/>
          <p:nvPr/>
        </p:nvSpPr>
        <p:spPr>
          <a:xfrm>
            <a:off x="4350570" y="3286858"/>
            <a:ext cx="1048645" cy="51478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3. Original consent applies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4628031A-342C-7F0C-A138-A69356CCA254}"/>
              </a:ext>
            </a:extLst>
          </p:cNvPr>
          <p:cNvSpPr/>
          <p:nvPr/>
        </p:nvSpPr>
        <p:spPr>
          <a:xfrm>
            <a:off x="4236535" y="1450393"/>
            <a:ext cx="1241685" cy="51478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2. Original consent applies</a:t>
            </a:r>
          </a:p>
        </p:txBody>
      </p:sp>
      <p:sp>
        <p:nvSpPr>
          <p:cNvPr id="92" name="Rectangle: Rounded Corners 91">
            <a:extLst>
              <a:ext uri="{FF2B5EF4-FFF2-40B4-BE49-F238E27FC236}">
                <a16:creationId xmlns:a16="http://schemas.microsoft.com/office/drawing/2014/main" id="{C9877E40-BCF2-709A-58D2-70F5BFA616E5}"/>
              </a:ext>
            </a:extLst>
          </p:cNvPr>
          <p:cNvSpPr/>
          <p:nvPr/>
        </p:nvSpPr>
        <p:spPr>
          <a:xfrm>
            <a:off x="2824460" y="4652298"/>
            <a:ext cx="899516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pdating phenotype information</a:t>
            </a:r>
          </a:p>
        </p:txBody>
      </p:sp>
      <p:cxnSp>
        <p:nvCxnSpPr>
          <p:cNvPr id="93" name="Connector: Elbow 92">
            <a:extLst>
              <a:ext uri="{FF2B5EF4-FFF2-40B4-BE49-F238E27FC236}">
                <a16:creationId xmlns:a16="http://schemas.microsoft.com/office/drawing/2014/main" id="{A974857D-AEA0-3004-5664-C5F766AE3189}"/>
              </a:ext>
            </a:extLst>
          </p:cNvPr>
          <p:cNvCxnSpPr>
            <a:cxnSpLocks/>
            <a:stCxn id="92" idx="1"/>
          </p:cNvCxnSpPr>
          <p:nvPr/>
        </p:nvCxnSpPr>
        <p:spPr>
          <a:xfrm rot="10800000" flipV="1">
            <a:off x="2771606" y="4951334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Rectangle: Rounded Corners 93">
            <a:extLst>
              <a:ext uri="{FF2B5EF4-FFF2-40B4-BE49-F238E27FC236}">
                <a16:creationId xmlns:a16="http://schemas.microsoft.com/office/drawing/2014/main" id="{80B9CCDB-847E-41A4-6160-51A9AE9B0F37}"/>
              </a:ext>
            </a:extLst>
          </p:cNvPr>
          <p:cNvSpPr/>
          <p:nvPr/>
        </p:nvSpPr>
        <p:spPr>
          <a:xfrm>
            <a:off x="4215810" y="4452879"/>
            <a:ext cx="1027944" cy="79749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ipeline generates too much noise or is not clinically acceptable  </a:t>
            </a:r>
          </a:p>
        </p:txBody>
      </p:sp>
      <p:cxnSp>
        <p:nvCxnSpPr>
          <p:cNvPr id="95" name="Connector: Elbow 94">
            <a:extLst>
              <a:ext uri="{FF2B5EF4-FFF2-40B4-BE49-F238E27FC236}">
                <a16:creationId xmlns:a16="http://schemas.microsoft.com/office/drawing/2014/main" id="{3702F5E9-AC4C-A1DA-1973-E01ABA581C8D}"/>
              </a:ext>
            </a:extLst>
          </p:cNvPr>
          <p:cNvCxnSpPr>
            <a:cxnSpLocks/>
            <a:stCxn id="94" idx="1"/>
          </p:cNvCxnSpPr>
          <p:nvPr/>
        </p:nvCxnSpPr>
        <p:spPr>
          <a:xfrm rot="10800000" flipV="1">
            <a:off x="4162956" y="4851624"/>
            <a:ext cx="52854" cy="61485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: Rounded Corners 97">
            <a:extLst>
              <a:ext uri="{FF2B5EF4-FFF2-40B4-BE49-F238E27FC236}">
                <a16:creationId xmlns:a16="http://schemas.microsoft.com/office/drawing/2014/main" id="{E8F7557F-7DA7-CE84-8A27-679086B386A9}"/>
              </a:ext>
            </a:extLst>
          </p:cNvPr>
          <p:cNvSpPr/>
          <p:nvPr/>
        </p:nvSpPr>
        <p:spPr>
          <a:xfrm>
            <a:off x="10535208" y="3766298"/>
            <a:ext cx="1074859" cy="786925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What if the patient no longer wishes to receive a result </a:t>
            </a:r>
          </a:p>
        </p:txBody>
      </p:sp>
      <p:cxnSp>
        <p:nvCxnSpPr>
          <p:cNvPr id="99" name="Connector: Elbow 98">
            <a:extLst>
              <a:ext uri="{FF2B5EF4-FFF2-40B4-BE49-F238E27FC236}">
                <a16:creationId xmlns:a16="http://schemas.microsoft.com/office/drawing/2014/main" id="{D783F401-9F91-D720-1771-134083C0EC97}"/>
              </a:ext>
            </a:extLst>
          </p:cNvPr>
          <p:cNvCxnSpPr>
            <a:cxnSpLocks/>
            <a:stCxn id="98" idx="1"/>
          </p:cNvCxnSpPr>
          <p:nvPr/>
        </p:nvCxnSpPr>
        <p:spPr>
          <a:xfrm rot="10800000" flipV="1">
            <a:off x="10482362" y="4159760"/>
            <a:ext cx="52847" cy="609561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: Rounded Corners 99">
            <a:extLst>
              <a:ext uri="{FF2B5EF4-FFF2-40B4-BE49-F238E27FC236}">
                <a16:creationId xmlns:a16="http://schemas.microsoft.com/office/drawing/2014/main" id="{60732CF8-2240-DCDF-AEA8-F6DCAFD58578}"/>
              </a:ext>
            </a:extLst>
          </p:cNvPr>
          <p:cNvSpPr/>
          <p:nvPr/>
        </p:nvSpPr>
        <p:spPr>
          <a:xfrm>
            <a:off x="296924" y="4820302"/>
            <a:ext cx="1007758" cy="528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Funded reanalysis program </a:t>
            </a:r>
          </a:p>
        </p:txBody>
      </p:sp>
      <p:cxnSp>
        <p:nvCxnSpPr>
          <p:cNvPr id="101" name="Connector: Elbow 100">
            <a:extLst>
              <a:ext uri="{FF2B5EF4-FFF2-40B4-BE49-F238E27FC236}">
                <a16:creationId xmlns:a16="http://schemas.microsoft.com/office/drawing/2014/main" id="{9549C1E6-C251-5E6A-80E8-512AE81F9BBD}"/>
              </a:ext>
            </a:extLst>
          </p:cNvPr>
          <p:cNvCxnSpPr>
            <a:cxnSpLocks/>
            <a:stCxn id="100" idx="1"/>
          </p:cNvCxnSpPr>
          <p:nvPr/>
        </p:nvCxnSpPr>
        <p:spPr>
          <a:xfrm rot="10800000" flipV="1">
            <a:off x="251754" y="5084720"/>
            <a:ext cx="45171" cy="52359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: Rounded Corners 106">
            <a:extLst>
              <a:ext uri="{FF2B5EF4-FFF2-40B4-BE49-F238E27FC236}">
                <a16:creationId xmlns:a16="http://schemas.microsoft.com/office/drawing/2014/main" id="{619CA440-88E9-A47A-A2E6-A9E0C4333187}"/>
              </a:ext>
            </a:extLst>
          </p:cNvPr>
          <p:cNvSpPr/>
          <p:nvPr/>
        </p:nvSpPr>
        <p:spPr>
          <a:xfrm>
            <a:off x="5340982" y="4654424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Laboratory capacity</a:t>
            </a:r>
          </a:p>
        </p:txBody>
      </p:sp>
      <p:cxnSp>
        <p:nvCxnSpPr>
          <p:cNvPr id="108" name="Connector: Elbow 107">
            <a:extLst>
              <a:ext uri="{FF2B5EF4-FFF2-40B4-BE49-F238E27FC236}">
                <a16:creationId xmlns:a16="http://schemas.microsoft.com/office/drawing/2014/main" id="{F73445D9-E46E-C458-095D-0DB3341AA0A1}"/>
              </a:ext>
            </a:extLst>
          </p:cNvPr>
          <p:cNvCxnSpPr>
            <a:cxnSpLocks/>
            <a:stCxn id="107" idx="1"/>
          </p:cNvCxnSpPr>
          <p:nvPr/>
        </p:nvCxnSpPr>
        <p:spPr>
          <a:xfrm rot="10800000" flipV="1">
            <a:off x="5288128" y="4953460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Rectangle: Rounded Corners 114">
            <a:extLst>
              <a:ext uri="{FF2B5EF4-FFF2-40B4-BE49-F238E27FC236}">
                <a16:creationId xmlns:a16="http://schemas.microsoft.com/office/drawing/2014/main" id="{68CA9A9E-3E3D-3516-8DEC-400A3656384C}"/>
              </a:ext>
            </a:extLst>
          </p:cNvPr>
          <p:cNvSpPr/>
          <p:nvPr/>
        </p:nvSpPr>
        <p:spPr>
          <a:xfrm>
            <a:off x="4212519" y="3958351"/>
            <a:ext cx="983683" cy="38180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trust</a:t>
            </a:r>
          </a:p>
        </p:txBody>
      </p:sp>
      <p:cxnSp>
        <p:nvCxnSpPr>
          <p:cNvPr id="116" name="Connector: Elbow 115">
            <a:extLst>
              <a:ext uri="{FF2B5EF4-FFF2-40B4-BE49-F238E27FC236}">
                <a16:creationId xmlns:a16="http://schemas.microsoft.com/office/drawing/2014/main" id="{4989143C-02D9-6F6D-474C-A20D2FA38A6F}"/>
              </a:ext>
            </a:extLst>
          </p:cNvPr>
          <p:cNvCxnSpPr>
            <a:cxnSpLocks/>
            <a:stCxn id="115" idx="1"/>
          </p:cNvCxnSpPr>
          <p:nvPr/>
        </p:nvCxnSpPr>
        <p:spPr>
          <a:xfrm rot="10800000" flipV="1">
            <a:off x="4159665" y="4149251"/>
            <a:ext cx="52854" cy="40700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492F7F79-C9C6-73A8-5EDC-D5904BA77F9B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25031286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32445" y="4002772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71E1855E-6534-F2EF-60A0-A7FAE2BC9610}"/>
              </a:ext>
            </a:extLst>
          </p:cNvPr>
          <p:cNvGrpSpPr/>
          <p:nvPr/>
        </p:nvGrpSpPr>
        <p:grpSpPr>
          <a:xfrm>
            <a:off x="50469" y="1357092"/>
            <a:ext cx="11355995" cy="1657469"/>
            <a:chOff x="-197857" y="1269540"/>
            <a:chExt cx="11355995" cy="1657469"/>
          </a:xfrm>
          <a:solidFill>
            <a:schemeClr val="bg1"/>
          </a:solidFill>
        </p:grpSpPr>
        <p:sp>
          <p:nvSpPr>
            <p:cNvPr id="9" name="Flowchart: Terminator 8">
              <a:extLst>
                <a:ext uri="{FF2B5EF4-FFF2-40B4-BE49-F238E27FC236}">
                  <a16:creationId xmlns:a16="http://schemas.microsoft.com/office/drawing/2014/main" id="{6B44DBF7-8AC4-AD03-40DB-BF5E9F8DF506}"/>
                </a:ext>
              </a:extLst>
            </p:cNvPr>
            <p:cNvSpPr/>
            <p:nvPr/>
          </p:nvSpPr>
          <p:spPr>
            <a:xfrm>
              <a:off x="-197857" y="1690147"/>
              <a:ext cx="1274652" cy="717492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>
                  <a:solidFill>
                    <a:sysClr val="windowText" lastClr="000000"/>
                  </a:solidFill>
                </a:rPr>
                <a:t>Unsolved patient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FF241CD-8BB4-1D3F-3233-13FEF830D51D}"/>
                </a:ext>
              </a:extLst>
            </p:cNvPr>
            <p:cNvSpPr/>
            <p:nvPr/>
          </p:nvSpPr>
          <p:spPr>
            <a:xfrm>
              <a:off x="6401270" y="1269540"/>
              <a:ext cx="936987" cy="1657469"/>
            </a:xfrm>
            <a:prstGeom prst="rect">
              <a:avLst/>
            </a:prstGeom>
            <a:solidFill>
              <a:schemeClr val="bg1"/>
            </a:solidFill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>
                  <a:solidFill>
                    <a:sysClr val="windowText" lastClr="000000"/>
                  </a:solidFill>
                </a:rPr>
                <a:t>4.Reanalysis</a:t>
              </a:r>
              <a:endParaRPr lang="en-GB" sz="1000" b="1" dirty="0">
                <a:solidFill>
                  <a:sysClr val="windowText" lastClr="000000"/>
                </a:solidFill>
                <a:highlight>
                  <a:srgbClr val="FFFF00"/>
                </a:highlight>
              </a:endParaRPr>
            </a:p>
          </p:txBody>
        </p:sp>
        <p:sp>
          <p:nvSpPr>
            <p:cNvPr id="11" name="Flowchart: Terminator 10">
              <a:extLst>
                <a:ext uri="{FF2B5EF4-FFF2-40B4-BE49-F238E27FC236}">
                  <a16:creationId xmlns:a16="http://schemas.microsoft.com/office/drawing/2014/main" id="{4FA2FEB2-B895-0DDC-2980-6C5EB846AD51}"/>
                </a:ext>
              </a:extLst>
            </p:cNvPr>
            <p:cNvSpPr/>
            <p:nvPr/>
          </p:nvSpPr>
          <p:spPr>
            <a:xfrm>
              <a:off x="9805882" y="1682046"/>
              <a:ext cx="1352256" cy="786926"/>
            </a:xfrm>
            <a:prstGeom prst="flowChartTerminator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>
                  <a:solidFill>
                    <a:sysClr val="windowText" lastClr="000000"/>
                  </a:solidFill>
                </a:rPr>
                <a:t>7.Patient informed about results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7FEF74B1-F604-8D7B-102B-07633A341870}"/>
                </a:ext>
              </a:extLst>
            </p:cNvPr>
            <p:cNvCxnSpPr>
              <a:cxnSpLocks/>
            </p:cNvCxnSpPr>
            <p:nvPr/>
          </p:nvCxnSpPr>
          <p:spPr>
            <a:xfrm>
              <a:off x="1364886" y="1550372"/>
              <a:ext cx="5036384" cy="0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DF3DE879-EA22-C357-E855-64E2CF76CBAC}"/>
                </a:ext>
              </a:extLst>
            </p:cNvPr>
            <p:cNvCxnSpPr>
              <a:cxnSpLocks/>
              <a:stCxn id="10" idx="3"/>
              <a:endCxn id="11" idx="1"/>
            </p:cNvCxnSpPr>
            <p:nvPr/>
          </p:nvCxnSpPr>
          <p:spPr>
            <a:xfrm flipV="1">
              <a:off x="7338257" y="2075509"/>
              <a:ext cx="2467625" cy="22766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3D71FABB-7BBA-CA7A-DDF4-A4174DE3FD4C}"/>
              </a:ext>
            </a:extLst>
          </p:cNvPr>
          <p:cNvSpPr/>
          <p:nvPr/>
        </p:nvSpPr>
        <p:spPr>
          <a:xfrm>
            <a:off x="7723777" y="1778316"/>
            <a:ext cx="979925" cy="7141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ysClr val="windowText" lastClr="000000"/>
                </a:solidFill>
              </a:rPr>
              <a:t>5.Clinician informed about result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BB17A46-643C-85E7-4C60-87F95BEE5424}"/>
              </a:ext>
            </a:extLst>
          </p:cNvPr>
          <p:cNvSpPr/>
          <p:nvPr/>
        </p:nvSpPr>
        <p:spPr>
          <a:xfrm>
            <a:off x="1379534" y="1262538"/>
            <a:ext cx="1183278" cy="71749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ysClr val="windowText" lastClr="000000"/>
                </a:solidFill>
              </a:rPr>
              <a:t>1. Clinical review at patient request (2-3 years’ time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A832A2A-8BCB-A855-22A9-36B40065837E}"/>
              </a:ext>
            </a:extLst>
          </p:cNvPr>
          <p:cNvCxnSpPr>
            <a:cxnSpLocks/>
          </p:cNvCxnSpPr>
          <p:nvPr/>
        </p:nvCxnSpPr>
        <p:spPr>
          <a:xfrm>
            <a:off x="1562146" y="2673418"/>
            <a:ext cx="503638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1BBC9223-DDEC-7047-651C-3BA3AB70227E}"/>
              </a:ext>
            </a:extLst>
          </p:cNvPr>
          <p:cNvSpPr/>
          <p:nvPr/>
        </p:nvSpPr>
        <p:spPr>
          <a:xfrm>
            <a:off x="1379534" y="2221976"/>
            <a:ext cx="1213526" cy="7091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ysClr val="windowText" lastClr="000000"/>
                </a:solidFill>
              </a:rPr>
              <a:t>1.Sub-specialist request</a:t>
            </a:r>
          </a:p>
        </p:txBody>
      </p:sp>
      <p:sp>
        <p:nvSpPr>
          <p:cNvPr id="18" name="Diamond 17">
            <a:extLst>
              <a:ext uri="{FF2B5EF4-FFF2-40B4-BE49-F238E27FC236}">
                <a16:creationId xmlns:a16="http://schemas.microsoft.com/office/drawing/2014/main" id="{FA07A94D-BDF6-1538-3C8D-898F1EAAB551}"/>
              </a:ext>
            </a:extLst>
          </p:cNvPr>
          <p:cNvSpPr/>
          <p:nvPr/>
        </p:nvSpPr>
        <p:spPr>
          <a:xfrm>
            <a:off x="2596775" y="1154164"/>
            <a:ext cx="1624775" cy="981643"/>
          </a:xfrm>
          <a:prstGeom prst="diamond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ysClr val="windowText" lastClr="000000"/>
                </a:solidFill>
              </a:rPr>
              <a:t>2. Consulting team discretion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112DBBA-06A9-FB22-7AF4-BA2E39627BA8}"/>
              </a:ext>
            </a:extLst>
          </p:cNvPr>
          <p:cNvSpPr/>
          <p:nvPr/>
        </p:nvSpPr>
        <p:spPr>
          <a:xfrm>
            <a:off x="8956120" y="1720285"/>
            <a:ext cx="877626" cy="879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ysClr val="windowText" lastClr="000000"/>
                </a:solidFill>
              </a:rPr>
              <a:t>6.Results return clinic at 3month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6E8B654-A081-B4FE-BE7A-768170300D6F}"/>
              </a:ext>
            </a:extLst>
          </p:cNvPr>
          <p:cNvSpPr/>
          <p:nvPr/>
        </p:nvSpPr>
        <p:spPr>
          <a:xfrm>
            <a:off x="4275963" y="1193040"/>
            <a:ext cx="877626" cy="84085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3.Booked in for results  return clinic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1068818-0805-7A7D-6A02-15FBDB618E55}"/>
              </a:ext>
            </a:extLst>
          </p:cNvPr>
          <p:cNvSpPr/>
          <p:nvPr/>
        </p:nvSpPr>
        <p:spPr>
          <a:xfrm>
            <a:off x="4302283" y="2122877"/>
            <a:ext cx="877626" cy="84085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Funded through State govt budget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16D8C755-E4CD-F911-000C-78BEBE3E6323}"/>
              </a:ext>
            </a:extLst>
          </p:cNvPr>
          <p:cNvSpPr/>
          <p:nvPr/>
        </p:nvSpPr>
        <p:spPr>
          <a:xfrm>
            <a:off x="5342733" y="1250508"/>
            <a:ext cx="877626" cy="84085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4.Funded through State government budget</a:t>
            </a:r>
          </a:p>
        </p:txBody>
      </p:sp>
      <p:sp>
        <p:nvSpPr>
          <p:cNvPr id="46" name="Diamond 45">
            <a:extLst>
              <a:ext uri="{FF2B5EF4-FFF2-40B4-BE49-F238E27FC236}">
                <a16:creationId xmlns:a16="http://schemas.microsoft.com/office/drawing/2014/main" id="{D086912B-23C6-5DEE-D00D-64CB17A4F7F2}"/>
              </a:ext>
            </a:extLst>
          </p:cNvPr>
          <p:cNvSpPr/>
          <p:nvPr/>
        </p:nvSpPr>
        <p:spPr>
          <a:xfrm>
            <a:off x="2608687" y="2182597"/>
            <a:ext cx="1624775" cy="981643"/>
          </a:xfrm>
          <a:prstGeom prst="diamond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ysClr val="windowText" lastClr="000000"/>
                </a:solidFill>
              </a:rPr>
              <a:t>2. Consulting team discretion</a:t>
            </a:r>
          </a:p>
        </p:txBody>
      </p: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B944D1D9-79B1-D1A7-7CA1-440A22ADCB1D}"/>
              </a:ext>
            </a:extLst>
          </p:cNvPr>
          <p:cNvSpPr/>
          <p:nvPr/>
        </p:nvSpPr>
        <p:spPr>
          <a:xfrm>
            <a:off x="7941111" y="4641651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capacity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11608911-5F6A-A725-8AE6-4CF102B31F1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7888257" y="4940687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: Rounded Corners 52">
            <a:extLst>
              <a:ext uri="{FF2B5EF4-FFF2-40B4-BE49-F238E27FC236}">
                <a16:creationId xmlns:a16="http://schemas.microsoft.com/office/drawing/2014/main" id="{62ED22FF-9D43-9C00-30D1-340EF0B2A14E}"/>
              </a:ext>
            </a:extLst>
          </p:cNvPr>
          <p:cNvSpPr/>
          <p:nvPr/>
        </p:nvSpPr>
        <p:spPr>
          <a:xfrm>
            <a:off x="296924" y="4820302"/>
            <a:ext cx="1007758" cy="528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Funded reanalysis program </a:t>
            </a:r>
          </a:p>
        </p:txBody>
      </p:sp>
      <p:cxnSp>
        <p:nvCxnSpPr>
          <p:cNvPr id="54" name="Connector: Elbow 53">
            <a:extLst>
              <a:ext uri="{FF2B5EF4-FFF2-40B4-BE49-F238E27FC236}">
                <a16:creationId xmlns:a16="http://schemas.microsoft.com/office/drawing/2014/main" id="{D5366B84-0101-24E6-8850-2D9F71F67968}"/>
              </a:ext>
            </a:extLst>
          </p:cNvPr>
          <p:cNvCxnSpPr>
            <a:cxnSpLocks/>
            <a:stCxn id="53" idx="1"/>
          </p:cNvCxnSpPr>
          <p:nvPr/>
        </p:nvCxnSpPr>
        <p:spPr>
          <a:xfrm rot="10800000" flipV="1">
            <a:off x="251754" y="5084720"/>
            <a:ext cx="45171" cy="523597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EFF3FC1F-E521-847B-CECC-48F3714CD00C}"/>
              </a:ext>
            </a:extLst>
          </p:cNvPr>
          <p:cNvSpPr txBox="1"/>
          <p:nvPr/>
        </p:nvSpPr>
        <p:spPr>
          <a:xfrm>
            <a:off x="10649307" y="246020"/>
            <a:ext cx="1542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G08</a:t>
            </a:r>
            <a:endParaRPr lang="en-AU" dirty="0"/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BDBEF279-79F5-BD82-449E-D06F9D353413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10924425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54517C32-D7C7-E3CA-12AD-9586CF54FAB0}"/>
              </a:ext>
            </a:extLst>
          </p:cNvPr>
          <p:cNvSpPr/>
          <p:nvPr/>
        </p:nvSpPr>
        <p:spPr>
          <a:xfrm>
            <a:off x="114105" y="184174"/>
            <a:ext cx="1648327" cy="7174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</a:rPr>
              <a:t>Manual process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79A15F7E-3B69-C639-C465-0415F5E39DF6}"/>
              </a:ext>
            </a:extLst>
          </p:cNvPr>
          <p:cNvSpPr/>
          <p:nvPr/>
        </p:nvSpPr>
        <p:spPr>
          <a:xfrm>
            <a:off x="320164" y="5499309"/>
            <a:ext cx="952986" cy="631504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1. Patient consented at primary test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0DEAB08-430E-2CC4-F35D-505B87664A87}"/>
              </a:ext>
            </a:extLst>
          </p:cNvPr>
          <p:cNvCxnSpPr>
            <a:cxnSpLocks/>
          </p:cNvCxnSpPr>
          <p:nvPr/>
        </p:nvCxnSpPr>
        <p:spPr>
          <a:xfrm>
            <a:off x="1273150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81CE087F-0BF2-286F-0318-81265FD8F0C9}"/>
              </a:ext>
            </a:extLst>
          </p:cNvPr>
          <p:cNvSpPr/>
          <p:nvPr/>
        </p:nvSpPr>
        <p:spPr>
          <a:xfrm>
            <a:off x="1656912" y="5513831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Unsolved patien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4C7692-0D38-C746-3A7F-F18D49A87B53}"/>
              </a:ext>
            </a:extLst>
          </p:cNvPr>
          <p:cNvCxnSpPr>
            <a:cxnSpLocks/>
          </p:cNvCxnSpPr>
          <p:nvPr/>
        </p:nvCxnSpPr>
        <p:spPr>
          <a:xfrm>
            <a:off x="2370871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4167A767-7F05-BDA4-F438-44AD225F7F6B}"/>
              </a:ext>
            </a:extLst>
          </p:cNvPr>
          <p:cNvSpPr/>
          <p:nvPr/>
        </p:nvSpPr>
        <p:spPr>
          <a:xfrm>
            <a:off x="2763466" y="5513831"/>
            <a:ext cx="957219" cy="616981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2. Automated pipeline triggere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058FC16-699C-D15B-C178-3B95813AFA0A}"/>
              </a:ext>
            </a:extLst>
          </p:cNvPr>
          <p:cNvCxnSpPr>
            <a:cxnSpLocks/>
          </p:cNvCxnSpPr>
          <p:nvPr/>
        </p:nvCxnSpPr>
        <p:spPr>
          <a:xfrm>
            <a:off x="3725385" y="5801091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921055-77E4-67F7-6E4D-7C756A6E228F}"/>
              </a:ext>
            </a:extLst>
          </p:cNvPr>
          <p:cNvCxnSpPr>
            <a:cxnSpLocks/>
          </p:cNvCxnSpPr>
          <p:nvPr/>
        </p:nvCxnSpPr>
        <p:spPr>
          <a:xfrm>
            <a:off x="4819640" y="5807194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EC8097-ADDE-C4CE-276B-309318DC5B52}"/>
              </a:ext>
            </a:extLst>
          </p:cNvPr>
          <p:cNvCxnSpPr>
            <a:cxnSpLocks/>
          </p:cNvCxnSpPr>
          <p:nvPr/>
        </p:nvCxnSpPr>
        <p:spPr>
          <a:xfrm>
            <a:off x="61535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95E9D-38EF-117C-7432-BAB95D8CC3FE}"/>
              </a:ext>
            </a:extLst>
          </p:cNvPr>
          <p:cNvCxnSpPr>
            <a:cxnSpLocks/>
          </p:cNvCxnSpPr>
          <p:nvPr/>
        </p:nvCxnSpPr>
        <p:spPr>
          <a:xfrm>
            <a:off x="7479972" y="5822323"/>
            <a:ext cx="345906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F620E5D-9497-DA45-7505-A46769BF455F}"/>
              </a:ext>
            </a:extLst>
          </p:cNvPr>
          <p:cNvCxnSpPr>
            <a:cxnSpLocks/>
          </p:cNvCxnSpPr>
          <p:nvPr/>
        </p:nvCxnSpPr>
        <p:spPr>
          <a:xfrm>
            <a:off x="8797164" y="5832399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7AC2E3A-D840-15C8-299B-F8532514BF62}"/>
              </a:ext>
            </a:extLst>
          </p:cNvPr>
          <p:cNvCxnSpPr>
            <a:cxnSpLocks/>
          </p:cNvCxnSpPr>
          <p:nvPr/>
        </p:nvCxnSpPr>
        <p:spPr>
          <a:xfrm>
            <a:off x="10053090" y="6902770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BEAE5122-2920-1095-5C2E-C15EB14B8DAA}"/>
              </a:ext>
            </a:extLst>
          </p:cNvPr>
          <p:cNvSpPr/>
          <p:nvPr/>
        </p:nvSpPr>
        <p:spPr>
          <a:xfrm>
            <a:off x="5200578" y="5501039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3. Variant curat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91A9808-94FC-CDDD-9173-1CA3A8D27223}"/>
              </a:ext>
            </a:extLst>
          </p:cNvPr>
          <p:cNvSpPr/>
          <p:nvPr/>
        </p:nvSpPr>
        <p:spPr>
          <a:xfrm>
            <a:off x="6526986" y="5491572"/>
            <a:ext cx="952986" cy="64891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4. Clinical interpret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BDD6CA9-B465-FACE-F320-F35204125366}"/>
              </a:ext>
            </a:extLst>
          </p:cNvPr>
          <p:cNvSpPr/>
          <p:nvPr/>
        </p:nvSpPr>
        <p:spPr>
          <a:xfrm>
            <a:off x="7844178" y="5491572"/>
            <a:ext cx="952986" cy="648917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5. Clinician informed about the result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8DDB06F-16C5-570B-D857-878C7CC7DA12}"/>
              </a:ext>
            </a:extLst>
          </p:cNvPr>
          <p:cNvSpPr/>
          <p:nvPr/>
        </p:nvSpPr>
        <p:spPr>
          <a:xfrm>
            <a:off x="9183592" y="5491572"/>
            <a:ext cx="952986" cy="639239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6. Into electronic medical record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6B1FA51-C91F-23E5-8ED5-58DA9D5D0C4B}"/>
              </a:ext>
            </a:extLst>
          </p:cNvPr>
          <p:cNvCxnSpPr>
            <a:cxnSpLocks/>
          </p:cNvCxnSpPr>
          <p:nvPr/>
        </p:nvCxnSpPr>
        <p:spPr>
          <a:xfrm>
            <a:off x="10136578" y="5800062"/>
            <a:ext cx="383642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9BA185E2-A93E-3EC0-6BCF-2E4BF0E00C8B}"/>
              </a:ext>
            </a:extLst>
          </p:cNvPr>
          <p:cNvSpPr/>
          <p:nvPr/>
        </p:nvSpPr>
        <p:spPr>
          <a:xfrm>
            <a:off x="10520220" y="5499308"/>
            <a:ext cx="952986" cy="639239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7. Patient informed about resul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D5DAD14-80DA-819E-1A98-7990DF89C0EB}"/>
              </a:ext>
            </a:extLst>
          </p:cNvPr>
          <p:cNvSpPr/>
          <p:nvPr/>
        </p:nvSpPr>
        <p:spPr>
          <a:xfrm>
            <a:off x="4101623" y="5491569"/>
            <a:ext cx="713959" cy="6169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Variant identified for a case</a:t>
            </a:r>
          </a:p>
        </p:txBody>
      </p:sp>
      <p:sp>
        <p:nvSpPr>
          <p:cNvPr id="85" name="Rectangle: Rounded Corners 84">
            <a:extLst>
              <a:ext uri="{FF2B5EF4-FFF2-40B4-BE49-F238E27FC236}">
                <a16:creationId xmlns:a16="http://schemas.microsoft.com/office/drawing/2014/main" id="{22D24AD1-5879-8528-B7BD-200746AA797B}"/>
              </a:ext>
            </a:extLst>
          </p:cNvPr>
          <p:cNvSpPr/>
          <p:nvPr/>
        </p:nvSpPr>
        <p:spPr>
          <a:xfrm>
            <a:off x="132445" y="4002772"/>
            <a:ext cx="1648327" cy="717492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Automated proces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2AA2CC-F06D-B8CE-9172-D5AB9292BC1D}"/>
              </a:ext>
            </a:extLst>
          </p:cNvPr>
          <p:cNvSpPr txBox="1"/>
          <p:nvPr/>
        </p:nvSpPr>
        <p:spPr>
          <a:xfrm>
            <a:off x="10382670" y="226919"/>
            <a:ext cx="1648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G09 &amp; LAB10</a:t>
            </a:r>
            <a:endParaRPr lang="en-AU" dirty="0"/>
          </a:p>
        </p:txBody>
      </p:sp>
      <p:sp>
        <p:nvSpPr>
          <p:cNvPr id="47" name="Rectangle: Rounded Corners 46">
            <a:extLst>
              <a:ext uri="{FF2B5EF4-FFF2-40B4-BE49-F238E27FC236}">
                <a16:creationId xmlns:a16="http://schemas.microsoft.com/office/drawing/2014/main" id="{B944D1D9-79B1-D1A7-7CA1-440A22ADCB1D}"/>
              </a:ext>
            </a:extLst>
          </p:cNvPr>
          <p:cNvSpPr/>
          <p:nvPr/>
        </p:nvSpPr>
        <p:spPr>
          <a:xfrm>
            <a:off x="7941111" y="4641651"/>
            <a:ext cx="840769" cy="59807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Clinician capacity</a:t>
            </a:r>
          </a:p>
        </p:txBody>
      </p:sp>
      <p:cxnSp>
        <p:nvCxnSpPr>
          <p:cNvPr id="48" name="Connector: Elbow 47">
            <a:extLst>
              <a:ext uri="{FF2B5EF4-FFF2-40B4-BE49-F238E27FC236}">
                <a16:creationId xmlns:a16="http://schemas.microsoft.com/office/drawing/2014/main" id="{11608911-5F6A-A725-8AE6-4CF102B31F19}"/>
              </a:ext>
            </a:extLst>
          </p:cNvPr>
          <p:cNvCxnSpPr>
            <a:cxnSpLocks/>
            <a:stCxn id="47" idx="1"/>
          </p:cNvCxnSpPr>
          <p:nvPr/>
        </p:nvCxnSpPr>
        <p:spPr>
          <a:xfrm rot="10800000" flipV="1">
            <a:off x="7888257" y="4940687"/>
            <a:ext cx="52854" cy="515148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F64A1415-E1A6-EDB1-CE54-7E3D75EC6A7D}"/>
              </a:ext>
            </a:extLst>
          </p:cNvPr>
          <p:cNvCxnSpPr>
            <a:cxnSpLocks/>
          </p:cNvCxnSpPr>
          <p:nvPr/>
        </p:nvCxnSpPr>
        <p:spPr>
          <a:xfrm>
            <a:off x="1762432" y="2491959"/>
            <a:ext cx="405364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A586DB29-7DC9-88C7-202E-6289DDCCD79E}"/>
              </a:ext>
            </a:extLst>
          </p:cNvPr>
          <p:cNvCxnSpPr>
            <a:cxnSpLocks/>
          </p:cNvCxnSpPr>
          <p:nvPr/>
        </p:nvCxnSpPr>
        <p:spPr>
          <a:xfrm>
            <a:off x="1741306" y="2078243"/>
            <a:ext cx="407476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7" name="Group 56">
            <a:extLst>
              <a:ext uri="{FF2B5EF4-FFF2-40B4-BE49-F238E27FC236}">
                <a16:creationId xmlns:a16="http://schemas.microsoft.com/office/drawing/2014/main" id="{F8255FBF-8009-1100-5F70-DDAB79547BDD}"/>
              </a:ext>
            </a:extLst>
          </p:cNvPr>
          <p:cNvGrpSpPr/>
          <p:nvPr/>
        </p:nvGrpSpPr>
        <p:grpSpPr>
          <a:xfrm>
            <a:off x="407599" y="1616605"/>
            <a:ext cx="10704041" cy="1014741"/>
            <a:chOff x="18617" y="1244711"/>
            <a:chExt cx="10704041" cy="1014741"/>
          </a:xfrm>
          <a:solidFill>
            <a:schemeClr val="bg1"/>
          </a:solidFill>
        </p:grpSpPr>
        <p:sp>
          <p:nvSpPr>
            <p:cNvPr id="58" name="Flowchart: Terminator 57">
              <a:extLst>
                <a:ext uri="{FF2B5EF4-FFF2-40B4-BE49-F238E27FC236}">
                  <a16:creationId xmlns:a16="http://schemas.microsoft.com/office/drawing/2014/main" id="{1C1856C6-F3C2-66A8-2705-FB9932ED34D6}"/>
                </a:ext>
              </a:extLst>
            </p:cNvPr>
            <p:cNvSpPr/>
            <p:nvPr/>
          </p:nvSpPr>
          <p:spPr>
            <a:xfrm>
              <a:off x="18617" y="1659078"/>
              <a:ext cx="1275859" cy="553665"/>
            </a:xfrm>
            <a:prstGeom prst="round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Unsolved patient</a:t>
              </a:r>
            </a:p>
          </p:txBody>
        </p:sp>
        <p:sp>
          <p:nvSpPr>
            <p:cNvPr id="59" name="Rectangle: Rounded Corners 58">
              <a:extLst>
                <a:ext uri="{FF2B5EF4-FFF2-40B4-BE49-F238E27FC236}">
                  <a16:creationId xmlns:a16="http://schemas.microsoft.com/office/drawing/2014/main" id="{2080B56F-4AE5-9820-1B5D-41102916F1C5}"/>
                </a:ext>
              </a:extLst>
            </p:cNvPr>
            <p:cNvSpPr/>
            <p:nvPr/>
          </p:nvSpPr>
          <p:spPr>
            <a:xfrm>
              <a:off x="5335650" y="1291420"/>
              <a:ext cx="1190458" cy="968032"/>
            </a:xfrm>
            <a:prstGeom prst="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4. Reanalysis</a:t>
              </a:r>
              <a:endParaRPr lang="en-GB" sz="1000" b="1" dirty="0">
                <a:highlight>
                  <a:srgbClr val="FFFF00"/>
                </a:highlight>
              </a:endParaRPr>
            </a:p>
          </p:txBody>
        </p:sp>
        <p:sp>
          <p:nvSpPr>
            <p:cNvPr id="60" name="Flowchart: Terminator 59">
              <a:extLst>
                <a:ext uri="{FF2B5EF4-FFF2-40B4-BE49-F238E27FC236}">
                  <a16:creationId xmlns:a16="http://schemas.microsoft.com/office/drawing/2014/main" id="{6283BB8A-72A7-1421-7033-D11DB2694024}"/>
                </a:ext>
              </a:extLst>
            </p:cNvPr>
            <p:cNvSpPr/>
            <p:nvPr/>
          </p:nvSpPr>
          <p:spPr>
            <a:xfrm>
              <a:off x="9376824" y="1244711"/>
              <a:ext cx="1345834" cy="968032"/>
            </a:xfrm>
            <a:prstGeom prst="roundRect">
              <a:avLst/>
            </a:prstGeom>
            <a:grpFill/>
            <a:ln w="571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000" b="1" dirty="0"/>
                <a:t>7. Patient informed about results</a:t>
              </a:r>
            </a:p>
          </p:txBody>
        </p:sp>
        <p:cxnSp>
          <p:nvCxnSpPr>
            <p:cNvPr id="72" name="Straight Arrow Connector 71">
              <a:extLst>
                <a:ext uri="{FF2B5EF4-FFF2-40B4-BE49-F238E27FC236}">
                  <a16:creationId xmlns:a16="http://schemas.microsoft.com/office/drawing/2014/main" id="{3FC07C75-3436-7E75-11E8-9C7C30721047}"/>
                </a:ext>
              </a:extLst>
            </p:cNvPr>
            <p:cNvCxnSpPr>
              <a:cxnSpLocks/>
              <a:stCxn id="59" idx="3"/>
            </p:cNvCxnSpPr>
            <p:nvPr/>
          </p:nvCxnSpPr>
          <p:spPr>
            <a:xfrm>
              <a:off x="6526108" y="1775436"/>
              <a:ext cx="2832430" cy="0"/>
            </a:xfrm>
            <a:prstGeom prst="straightConnector1">
              <a:avLst/>
            </a:prstGeom>
            <a:grpFill/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6" name="Rectangle 75">
            <a:extLst>
              <a:ext uri="{FF2B5EF4-FFF2-40B4-BE49-F238E27FC236}">
                <a16:creationId xmlns:a16="http://schemas.microsoft.com/office/drawing/2014/main" id="{4D305144-CA67-F4CE-29CF-F2656C697B5A}"/>
              </a:ext>
            </a:extLst>
          </p:cNvPr>
          <p:cNvSpPr/>
          <p:nvPr/>
        </p:nvSpPr>
        <p:spPr>
          <a:xfrm>
            <a:off x="1862401" y="1798604"/>
            <a:ext cx="1190457" cy="54495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1. Clinician request (time)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14039D2E-58B5-978A-AA8A-351846044406}"/>
              </a:ext>
            </a:extLst>
          </p:cNvPr>
          <p:cNvSpPr/>
          <p:nvPr/>
        </p:nvSpPr>
        <p:spPr>
          <a:xfrm>
            <a:off x="4660658" y="2410719"/>
            <a:ext cx="963863" cy="4237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2.Additional consent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E22A486D-A67B-0F84-5BDF-6A4C99E5FF50}"/>
              </a:ext>
            </a:extLst>
          </p:cNvPr>
          <p:cNvSpPr/>
          <p:nvPr/>
        </p:nvSpPr>
        <p:spPr>
          <a:xfrm>
            <a:off x="7437911" y="2055031"/>
            <a:ext cx="1063637" cy="6054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5. +/- Report send to clinician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5B249940-AB2C-411C-6519-6234C162E585}"/>
              </a:ext>
            </a:extLst>
          </p:cNvPr>
          <p:cNvSpPr/>
          <p:nvPr/>
        </p:nvSpPr>
        <p:spPr>
          <a:xfrm>
            <a:off x="8725482" y="2040842"/>
            <a:ext cx="909706" cy="6054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6. Medical record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5558DE04-B013-2C07-A435-5C98AE0B329D}"/>
              </a:ext>
            </a:extLst>
          </p:cNvPr>
          <p:cNvSpPr/>
          <p:nvPr/>
        </p:nvSpPr>
        <p:spPr>
          <a:xfrm>
            <a:off x="1843161" y="2393492"/>
            <a:ext cx="1413169" cy="6288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1. Lab trigger, significant new knowledge </a:t>
            </a: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8C7A98C4-A862-3872-0E21-0B5CE7506662}"/>
              </a:ext>
            </a:extLst>
          </p:cNvPr>
          <p:cNvSpPr/>
          <p:nvPr/>
        </p:nvSpPr>
        <p:spPr>
          <a:xfrm>
            <a:off x="3140361" y="1783471"/>
            <a:ext cx="1435027" cy="54595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2. Genetics department funded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48F94CB1-6D76-5A7A-2FF1-85839FDB89DA}"/>
              </a:ext>
            </a:extLst>
          </p:cNvPr>
          <p:cNvSpPr/>
          <p:nvPr/>
        </p:nvSpPr>
        <p:spPr>
          <a:xfrm>
            <a:off x="4660659" y="1826220"/>
            <a:ext cx="957260" cy="4237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3.Original consent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C8E48221-E41F-6E45-DC1B-218CFC96CDF7}"/>
              </a:ext>
            </a:extLst>
          </p:cNvPr>
          <p:cNvSpPr/>
          <p:nvPr/>
        </p:nvSpPr>
        <p:spPr>
          <a:xfrm>
            <a:off x="3373431" y="2415754"/>
            <a:ext cx="1091136" cy="4463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/>
              <a:t>2. Lab funded</a:t>
            </a:r>
          </a:p>
        </p:txBody>
      </p:sp>
      <p:sp>
        <p:nvSpPr>
          <p:cNvPr id="110" name="Rectangle: Rounded Corners 109">
            <a:extLst>
              <a:ext uri="{FF2B5EF4-FFF2-40B4-BE49-F238E27FC236}">
                <a16:creationId xmlns:a16="http://schemas.microsoft.com/office/drawing/2014/main" id="{B8A6D824-0133-7A91-B0BE-F7974F84B307}"/>
              </a:ext>
            </a:extLst>
          </p:cNvPr>
          <p:cNvSpPr/>
          <p:nvPr/>
        </p:nvSpPr>
        <p:spPr>
          <a:xfrm>
            <a:off x="4013800" y="4537390"/>
            <a:ext cx="1027944" cy="79749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ipeline generates too much noise or is not clinically acceptable  </a:t>
            </a:r>
          </a:p>
        </p:txBody>
      </p:sp>
      <p:cxnSp>
        <p:nvCxnSpPr>
          <p:cNvPr id="111" name="Connector: Elbow 110">
            <a:extLst>
              <a:ext uri="{FF2B5EF4-FFF2-40B4-BE49-F238E27FC236}">
                <a16:creationId xmlns:a16="http://schemas.microsoft.com/office/drawing/2014/main" id="{57A2A17F-9F64-3D77-3AD3-BE249D04E18A}"/>
              </a:ext>
            </a:extLst>
          </p:cNvPr>
          <p:cNvCxnSpPr>
            <a:cxnSpLocks/>
            <a:stCxn id="110" idx="1"/>
          </p:cNvCxnSpPr>
          <p:nvPr/>
        </p:nvCxnSpPr>
        <p:spPr>
          <a:xfrm rot="10800000" flipV="1">
            <a:off x="3960946" y="4936135"/>
            <a:ext cx="52854" cy="614854"/>
          </a:xfrm>
          <a:prstGeom prst="bentConnector2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736A0C2F-3B93-AC1C-27D2-3E470591A832}"/>
              </a:ext>
            </a:extLst>
          </p:cNvPr>
          <p:cNvSpPr/>
          <p:nvPr/>
        </p:nvSpPr>
        <p:spPr>
          <a:xfrm>
            <a:off x="320164" y="6369164"/>
            <a:ext cx="1007758" cy="41579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/>
              <a:t>Perceived challenge</a:t>
            </a:r>
          </a:p>
        </p:txBody>
      </p:sp>
    </p:spTree>
    <p:extLst>
      <p:ext uri="{BB962C8B-B14F-4D97-AF65-F5344CB8AC3E}">
        <p14:creationId xmlns:p14="http://schemas.microsoft.com/office/powerpoint/2010/main" val="3182455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85</TotalTime>
  <Words>1879</Words>
  <Application>Microsoft Office PowerPoint</Application>
  <PresentationFormat>Widescreen</PresentationFormat>
  <Paragraphs>375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Fehlberg</dc:creator>
  <cp:lastModifiedBy>Zoe Fehlberg</cp:lastModifiedBy>
  <cp:revision>6</cp:revision>
  <dcterms:created xsi:type="dcterms:W3CDTF">2022-09-07T23:48:41Z</dcterms:created>
  <dcterms:modified xsi:type="dcterms:W3CDTF">2023-10-09T23:15:18Z</dcterms:modified>
</cp:coreProperties>
</file>